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1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2.xml" ContentType="application/vnd.openxmlformats-officedocument.themeOverr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3.xml" ContentType="application/vnd.openxmlformats-officedocument.themeOverr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8"/>
  </p:notesMasterIdLst>
  <p:sldIdLst>
    <p:sldId id="256" r:id="rId5"/>
    <p:sldId id="440" r:id="rId6"/>
    <p:sldId id="264" r:id="rId7"/>
    <p:sldId id="442" r:id="rId8"/>
    <p:sldId id="438" r:id="rId9"/>
    <p:sldId id="432" r:id="rId10"/>
    <p:sldId id="433" r:id="rId11"/>
    <p:sldId id="425" r:id="rId12"/>
    <p:sldId id="426" r:id="rId13"/>
    <p:sldId id="278" r:id="rId14"/>
    <p:sldId id="280" r:id="rId15"/>
    <p:sldId id="427" r:id="rId16"/>
    <p:sldId id="441" r:id="rId17"/>
  </p:sldIdLst>
  <p:sldSz cx="13208000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85723"/>
    <a:srgbClr val="7C7C7C"/>
    <a:srgbClr val="B4C7E7"/>
    <a:srgbClr val="E6E3C4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0058" autoAdjust="0"/>
  </p:normalViewPr>
  <p:slideViewPr>
    <p:cSldViewPr snapToGrid="0">
      <p:cViewPr varScale="1">
        <p:scale>
          <a:sx n="47" d="100"/>
          <a:sy n="47" d="100"/>
        </p:scale>
        <p:origin x="126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kuleuven-my.sharepoint.com/personal/charlotte_vandevelde_kuleuven_be/Documents/WorkPackages/WP3/Ambr15/20210202_Ambr_Exp2/Ambr2_HPLC_RevisedVers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kuleuven-my.sharepoint.com/personal/charlotte_vandevelde_kuleuven_be/Documents/WorkPackages/WP3/Ambr15/20210202_Ambr_Exp2/Ambr2_HPLC_RevisedVers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https://kuleuven-my.sharepoint.com/personal/charlotte_vandevelde_kuleuven_be/Documents/16S_pipeline/DI21R16_Ambr2/DI21R16_results_improvedscript_copynumber/RESULTS_DI21R16_graphs_improvedscript_copynumber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https://kuleuven-my.sharepoint.com/personal/charlotte_vandevelde_kuleuven_be/Documents/16S_pipeline/DI21R16_Ambr2/DI21R16_results_improvedscript_copynumber/RESULTS_DI21R16_graphs_improvedscript_copynumber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https://kuleuven-my.sharepoint.com/personal/charlotte_vandevelde_kuleuven_be/Documents/WorkPackages/WP3/Ambr15/20210202_Ambr_Exp2/Ambr2_HPLC_RevisedVersion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0127034\Box%20Sync\16S_pipeline\DI21R16_Ambr2\DI21R16_results_improvedscript_copynumber\RESULTS_DI21R16_graphs_improvedscript_copynumber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kuleuven-my.sharepoint.com/personal/charlotte_vandevelde_kuleuven_be/Documents/WorkPackages/WP3/Ambr15/20210202_Ambr_Exp2/Cellscanner_AllT12_NoPC_Unknown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kuleuven-my.sharepoint.com/personal/charlotte_vandevelde_kuleuven_be/Documents/Paper%202%20community/Revision/TotalCellcountEx1Ex2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3"/>
          <c:order val="0"/>
          <c:tx>
            <c:strRef>
              <c:f>over_time_CO_AVERAGE!$F$1</c:f>
              <c:strCache>
                <c:ptCount val="1"/>
                <c:pt idx="0">
                  <c:v>SUCCINI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4"/>
                </a:solidFill>
                <a:ln w="63500">
                  <a:solidFill>
                    <a:schemeClr val="accent4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7-5882-4817-83D0-C9DA8D427D6D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accent4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5882-4817-83D0-C9DA8D427D6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F$11:$F$17</c:f>
                <c:numCache>
                  <c:formatCode>General</c:formatCode>
                  <c:ptCount val="7"/>
                  <c:pt idx="1">
                    <c:v>33.023063363184356</c:v>
                  </c:pt>
                  <c:pt idx="2">
                    <c:v>8.8152153814993124</c:v>
                  </c:pt>
                  <c:pt idx="3">
                    <c:v>10.558809907686872</c:v>
                  </c:pt>
                  <c:pt idx="4">
                    <c:v>6.9888977433259534</c:v>
                  </c:pt>
                  <c:pt idx="5">
                    <c:v>8.0904705604117328</c:v>
                  </c:pt>
                  <c:pt idx="6">
                    <c:v>10.704545374123398</c:v>
                  </c:pt>
                </c:numCache>
              </c:numRef>
            </c:plus>
            <c:minus>
              <c:numRef>
                <c:f>over_time_CO_AVERAGE!$F$11:$F$17</c:f>
                <c:numCache>
                  <c:formatCode>General</c:formatCode>
                  <c:ptCount val="7"/>
                  <c:pt idx="1">
                    <c:v>33.023063363184356</c:v>
                  </c:pt>
                  <c:pt idx="2">
                    <c:v>8.8152153814993124</c:v>
                  </c:pt>
                  <c:pt idx="3">
                    <c:v>10.558809907686872</c:v>
                  </c:pt>
                  <c:pt idx="4">
                    <c:v>6.9888977433259534</c:v>
                  </c:pt>
                  <c:pt idx="5">
                    <c:v>8.0904705604117328</c:v>
                  </c:pt>
                  <c:pt idx="6">
                    <c:v>10.7045453741233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over_time_CO_AVERAGE!$B$2:$B$8</c:f>
              <c:numCache>
                <c:formatCode>General</c:formatCode>
                <c:ptCount val="7"/>
                <c:pt idx="0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over_time_CO_AVERAGE!$F$2:$F$8</c:f>
              <c:numCache>
                <c:formatCode>0.00</c:formatCode>
                <c:ptCount val="7"/>
                <c:pt idx="0" formatCode="General">
                  <c:v>99.77</c:v>
                </c:pt>
                <c:pt idx="1">
                  <c:v>395.69166666666661</c:v>
                </c:pt>
                <c:pt idx="2">
                  <c:v>366.34666666666664</c:v>
                </c:pt>
                <c:pt idx="3">
                  <c:v>293.26</c:v>
                </c:pt>
                <c:pt idx="4">
                  <c:v>244.57500000000005</c:v>
                </c:pt>
                <c:pt idx="5">
                  <c:v>216.09833333333333</c:v>
                </c:pt>
                <c:pt idx="6">
                  <c:v>206.705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882-4817-83D0-C9DA8D427D6D}"/>
            </c:ext>
          </c:extLst>
        </c:ser>
        <c:ser>
          <c:idx val="4"/>
          <c:order val="1"/>
          <c:tx>
            <c:strRef>
              <c:f>over_time_CO_AVERAGE!$G$1</c:f>
              <c:strCache>
                <c:ptCount val="1"/>
                <c:pt idx="0">
                  <c:v>LACTIC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5"/>
                </a:solidFill>
                <a:ln w="63500">
                  <a:solidFill>
                    <a:schemeClr val="accent5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6-5882-4817-83D0-C9DA8D427D6D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5"/>
                </a:solidFill>
                <a:ln w="9525">
                  <a:solidFill>
                    <a:schemeClr val="accent5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4-5882-4817-83D0-C9DA8D427D6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G$11:$G$17</c:f>
                <c:numCache>
                  <c:formatCode>General</c:formatCode>
                  <c:ptCount val="7"/>
                  <c:pt idx="1">
                    <c:v>14.930501684657328</c:v>
                  </c:pt>
                  <c:pt idx="2">
                    <c:v>12.999931623751799</c:v>
                  </c:pt>
                  <c:pt idx="3">
                    <c:v>6.0452754739180934</c:v>
                  </c:pt>
                  <c:pt idx="4">
                    <c:v>5.9227829888772137</c:v>
                  </c:pt>
                  <c:pt idx="5">
                    <c:v>6.0366282439417729</c:v>
                  </c:pt>
                  <c:pt idx="6">
                    <c:v>5.5004727069589228</c:v>
                  </c:pt>
                </c:numCache>
              </c:numRef>
            </c:plus>
            <c:minus>
              <c:numRef>
                <c:f>over_time_CO_AVERAGE!$G$11:$G$17</c:f>
                <c:numCache>
                  <c:formatCode>General</c:formatCode>
                  <c:ptCount val="7"/>
                  <c:pt idx="1">
                    <c:v>14.930501684657328</c:v>
                  </c:pt>
                  <c:pt idx="2">
                    <c:v>12.999931623751799</c:v>
                  </c:pt>
                  <c:pt idx="3">
                    <c:v>6.0452754739180934</c:v>
                  </c:pt>
                  <c:pt idx="4">
                    <c:v>5.9227829888772137</c:v>
                  </c:pt>
                  <c:pt idx="5">
                    <c:v>6.0366282439417729</c:v>
                  </c:pt>
                  <c:pt idx="6">
                    <c:v>5.50047270695892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over_time_CO_AVERAGE!$B$2:$B$8</c:f>
              <c:numCache>
                <c:formatCode>General</c:formatCode>
                <c:ptCount val="7"/>
                <c:pt idx="0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over_time_CO_AVERAGE!$G$2:$G$8</c:f>
              <c:numCache>
                <c:formatCode>0.00</c:formatCode>
                <c:ptCount val="7"/>
                <c:pt idx="0" formatCode="General">
                  <c:v>141</c:v>
                </c:pt>
                <c:pt idx="1">
                  <c:v>523.70166666666671</c:v>
                </c:pt>
                <c:pt idx="2">
                  <c:v>230.92666666666665</c:v>
                </c:pt>
                <c:pt idx="3">
                  <c:v>183.08333333333337</c:v>
                </c:pt>
                <c:pt idx="4">
                  <c:v>152.04499999999999</c:v>
                </c:pt>
                <c:pt idx="5">
                  <c:v>134.18833333333333</c:v>
                </c:pt>
                <c:pt idx="6">
                  <c:v>122.83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882-4817-83D0-C9DA8D427D6D}"/>
            </c:ext>
          </c:extLst>
        </c:ser>
        <c:ser>
          <c:idx val="0"/>
          <c:order val="2"/>
          <c:tx>
            <c:strRef>
              <c:f>over_time_CO_AVERAGE!$D$1</c:f>
              <c:strCache>
                <c:ptCount val="1"/>
                <c:pt idx="0">
                  <c:v>GLUCOS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2"/>
                </a:solidFill>
                <a:ln w="63500">
                  <a:solidFill>
                    <a:schemeClr val="accent2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3-5882-4817-83D0-C9DA8D427D6D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2"/>
                </a:solidFill>
                <a:ln w="9525">
                  <a:solidFill>
                    <a:schemeClr val="accent2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7-5882-4817-83D0-C9DA8D427D6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D$11:$D$17</c:f>
                <c:numCache>
                  <c:formatCode>General</c:formatCode>
                  <c:ptCount val="7"/>
                  <c:pt idx="1">
                    <c:v>21.38960631552936</c:v>
                  </c:pt>
                  <c:pt idx="2">
                    <c:v>0.54227914091053453</c:v>
                  </c:pt>
                  <c:pt idx="3">
                    <c:v>0.27202941017470889</c:v>
                  </c:pt>
                  <c:pt idx="4">
                    <c:v>0.31791311706187902</c:v>
                  </c:pt>
                  <c:pt idx="5">
                    <c:v>0.6670019989975029</c:v>
                  </c:pt>
                  <c:pt idx="6">
                    <c:v>0.56262243112055077</c:v>
                  </c:pt>
                </c:numCache>
              </c:numRef>
            </c:plus>
            <c:minus>
              <c:numRef>
                <c:f>over_time_CO_AVERAGE!$D$11:$D$17</c:f>
                <c:numCache>
                  <c:formatCode>General</c:formatCode>
                  <c:ptCount val="7"/>
                  <c:pt idx="1">
                    <c:v>21.38960631552936</c:v>
                  </c:pt>
                  <c:pt idx="2">
                    <c:v>0.54227914091053453</c:v>
                  </c:pt>
                  <c:pt idx="3">
                    <c:v>0.27202941017470889</c:v>
                  </c:pt>
                  <c:pt idx="4">
                    <c:v>0.31791311706187902</c:v>
                  </c:pt>
                  <c:pt idx="5">
                    <c:v>0.6670019989975029</c:v>
                  </c:pt>
                  <c:pt idx="6">
                    <c:v>0.562622431120550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over_time_CO_AVERAGE!$D$2:$D$8</c:f>
              <c:numCache>
                <c:formatCode>0.00</c:formatCode>
                <c:ptCount val="7"/>
                <c:pt idx="0" formatCode="General">
                  <c:v>1778.48</c:v>
                </c:pt>
                <c:pt idx="1">
                  <c:v>24.915000000000003</c:v>
                </c:pt>
                <c:pt idx="2">
                  <c:v>3.73</c:v>
                </c:pt>
                <c:pt idx="3">
                  <c:v>3.6200000000000006</c:v>
                </c:pt>
                <c:pt idx="4">
                  <c:v>3.8925000000000001</c:v>
                </c:pt>
                <c:pt idx="5">
                  <c:v>4.2650000000000006</c:v>
                </c:pt>
                <c:pt idx="6">
                  <c:v>4.37400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5882-4817-83D0-C9DA8D427D6D}"/>
            </c:ext>
          </c:extLst>
        </c:ser>
        <c:ser>
          <c:idx val="1"/>
          <c:order val="3"/>
          <c:tx>
            <c:strRef>
              <c:f>over_time_CO_AVERAGE!$E$1</c:f>
              <c:strCache>
                <c:ptCount val="1"/>
                <c:pt idx="0">
                  <c:v>PYRUVIC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3"/>
                </a:solidFill>
                <a:ln w="63500">
                  <a:solidFill>
                    <a:schemeClr val="accent3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4-5882-4817-83D0-C9DA8D427D6D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3"/>
                </a:solidFill>
                <a:ln w="9525">
                  <a:solidFill>
                    <a:schemeClr val="accent3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A-5882-4817-83D0-C9DA8D427D6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E$11:$E$17</c:f>
                <c:numCache>
                  <c:formatCode>General</c:formatCode>
                  <c:ptCount val="7"/>
                  <c:pt idx="1">
                    <c:v>41.103783956657274</c:v>
                  </c:pt>
                  <c:pt idx="2">
                    <c:v>0.10307764064044074</c:v>
                  </c:pt>
                  <c:pt idx="3">
                    <c:v>0.44496254524023282</c:v>
                  </c:pt>
                  <c:pt idx="4">
                    <c:v>0.4873397172404485</c:v>
                  </c:pt>
                  <c:pt idx="5">
                    <c:v>0.38796119508127197</c:v>
                  </c:pt>
                  <c:pt idx="6">
                    <c:v>0.52147227475037738</c:v>
                  </c:pt>
                </c:numCache>
              </c:numRef>
            </c:plus>
            <c:minus>
              <c:numRef>
                <c:f>over_time_CO_AVERAGE!$E$11:$E$17</c:f>
                <c:numCache>
                  <c:formatCode>General</c:formatCode>
                  <c:ptCount val="7"/>
                  <c:pt idx="1">
                    <c:v>41.103783956657274</c:v>
                  </c:pt>
                  <c:pt idx="2">
                    <c:v>0.10307764064044074</c:v>
                  </c:pt>
                  <c:pt idx="3">
                    <c:v>0.44496254524023282</c:v>
                  </c:pt>
                  <c:pt idx="4">
                    <c:v>0.4873397172404485</c:v>
                  </c:pt>
                  <c:pt idx="5">
                    <c:v>0.38796119508127197</c:v>
                  </c:pt>
                  <c:pt idx="6">
                    <c:v>0.521472274750377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over_time_CO_AVERAGE!$E$2:$E$8</c:f>
              <c:numCache>
                <c:formatCode>0.00</c:formatCode>
                <c:ptCount val="7"/>
                <c:pt idx="0" formatCode="General">
                  <c:v>902.69</c:v>
                </c:pt>
                <c:pt idx="1">
                  <c:v>567.75333333333333</c:v>
                </c:pt>
                <c:pt idx="2">
                  <c:v>17.634999999999998</c:v>
                </c:pt>
                <c:pt idx="3">
                  <c:v>16.724999999999998</c:v>
                </c:pt>
                <c:pt idx="4">
                  <c:v>16.09</c:v>
                </c:pt>
                <c:pt idx="5">
                  <c:v>16.351666666666667</c:v>
                </c:pt>
                <c:pt idx="6">
                  <c:v>16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5882-4817-83D0-C9DA8D427D6D}"/>
            </c:ext>
          </c:extLst>
        </c:ser>
        <c:ser>
          <c:idx val="2"/>
          <c:order val="4"/>
          <c:tx>
            <c:strRef>
              <c:f>over_time_CO_AVERAGE!$C$1</c:f>
              <c:strCache>
                <c:ptCount val="1"/>
                <c:pt idx="0">
                  <c:v>TREHALOSE</c:v>
                </c:pt>
              </c:strCache>
            </c:strRef>
          </c:tx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</a:schemeClr>
              </a:solidFill>
              <a:ln w="9525">
                <a:solidFill>
                  <a:schemeClr val="accent5">
                    <a:lumMod val="50000"/>
                  </a:schemeClr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5">
                    <a:lumMod val="50000"/>
                  </a:schemeClr>
                </a:solidFill>
                <a:ln w="63500">
                  <a:solidFill>
                    <a:schemeClr val="accent5">
                      <a:lumMod val="50000"/>
                    </a:schemeClr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5-5882-4817-83D0-C9DA8D427D6D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5">
                    <a:lumMod val="50000"/>
                  </a:schemeClr>
                </a:solidFill>
                <a:ln w="9525">
                  <a:solidFill>
                    <a:schemeClr val="accent5">
                      <a:lumMod val="50000"/>
                    </a:schemeClr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D-5882-4817-83D0-C9DA8D427D6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C$11:$C$17</c:f>
                <c:numCache>
                  <c:formatCode>General</c:formatCode>
                  <c:ptCount val="7"/>
                  <c:pt idx="1">
                    <c:v>23.611968481165555</c:v>
                  </c:pt>
                  <c:pt idx="2">
                    <c:v>0.50151991208946245</c:v>
                  </c:pt>
                  <c:pt idx="3">
                    <c:v>0.44794902983858959</c:v>
                  </c:pt>
                  <c:pt idx="4">
                    <c:v>0.17587874611030557</c:v>
                  </c:pt>
                  <c:pt idx="5">
                    <c:v>0.22602851344219527</c:v>
                  </c:pt>
                  <c:pt idx="6">
                    <c:v>0.74015013492008686</c:v>
                  </c:pt>
                </c:numCache>
              </c:numRef>
            </c:plus>
            <c:minus>
              <c:numRef>
                <c:f>over_time_CO_AVERAGE!$C$11:$C$17</c:f>
                <c:numCache>
                  <c:formatCode>General</c:formatCode>
                  <c:ptCount val="7"/>
                  <c:pt idx="1">
                    <c:v>23.611968481165555</c:v>
                  </c:pt>
                  <c:pt idx="2">
                    <c:v>0.50151991208946245</c:v>
                  </c:pt>
                  <c:pt idx="3">
                    <c:v>0.44794902983858959</c:v>
                  </c:pt>
                  <c:pt idx="4">
                    <c:v>0.17587874611030557</c:v>
                  </c:pt>
                  <c:pt idx="5">
                    <c:v>0.22602851344219527</c:v>
                  </c:pt>
                  <c:pt idx="6">
                    <c:v>0.740150134920086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over_time_CO_AVERAGE!$C$2:$C$8</c:f>
              <c:numCache>
                <c:formatCode>0.00</c:formatCode>
                <c:ptCount val="7"/>
                <c:pt idx="0" formatCode="General">
                  <c:v>224.4</c:v>
                </c:pt>
                <c:pt idx="1">
                  <c:v>96.616666666666674</c:v>
                </c:pt>
                <c:pt idx="2">
                  <c:v>29.473333333333333</c:v>
                </c:pt>
                <c:pt idx="3">
                  <c:v>29.325000000000003</c:v>
                </c:pt>
                <c:pt idx="4">
                  <c:v>27.429999999999996</c:v>
                </c:pt>
                <c:pt idx="5">
                  <c:v>27.146666666666672</c:v>
                </c:pt>
                <c:pt idx="6">
                  <c:v>26.4666666666666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5882-4817-83D0-C9DA8D427D6D}"/>
            </c:ext>
          </c:extLst>
        </c:ser>
        <c:ser>
          <c:idx val="5"/>
          <c:order val="5"/>
          <c:tx>
            <c:strRef>
              <c:f>over_time_CO_AVERAGE!$H$1</c:f>
              <c:strCache>
                <c:ptCount val="1"/>
                <c:pt idx="0">
                  <c:v>FORMIC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6"/>
                </a:solidFill>
                <a:ln w="63500">
                  <a:solidFill>
                    <a:schemeClr val="accent6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8-5882-4817-83D0-C9DA8D427D6D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6"/>
                </a:solidFill>
                <a:ln w="9525">
                  <a:solidFill>
                    <a:schemeClr val="accent6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0-5882-4817-83D0-C9DA8D427D6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H$11:$H$17</c:f>
                <c:numCache>
                  <c:formatCode>General</c:formatCode>
                  <c:ptCount val="7"/>
                  <c:pt idx="1">
                    <c:v>8.7141750741089705</c:v>
                  </c:pt>
                  <c:pt idx="2">
                    <c:v>0.77418236439054333</c:v>
                  </c:pt>
                  <c:pt idx="3">
                    <c:v>2.2608380943554729</c:v>
                  </c:pt>
                  <c:pt idx="4">
                    <c:v>2.130796017141638</c:v>
                  </c:pt>
                  <c:pt idx="5">
                    <c:v>4.8153657412726432</c:v>
                  </c:pt>
                  <c:pt idx="6">
                    <c:v>4.4523043347112834</c:v>
                  </c:pt>
                </c:numCache>
              </c:numRef>
            </c:plus>
            <c:minus>
              <c:numRef>
                <c:f>over_time_CO_AVERAGE!$H$11:$H$17</c:f>
                <c:numCache>
                  <c:formatCode>General</c:formatCode>
                  <c:ptCount val="7"/>
                  <c:pt idx="1">
                    <c:v>8.7141750741089705</c:v>
                  </c:pt>
                  <c:pt idx="2">
                    <c:v>0.77418236439054333</c:v>
                  </c:pt>
                  <c:pt idx="3">
                    <c:v>2.2608380943554729</c:v>
                  </c:pt>
                  <c:pt idx="4">
                    <c:v>2.130796017141638</c:v>
                  </c:pt>
                  <c:pt idx="5">
                    <c:v>4.8153657412726432</c:v>
                  </c:pt>
                  <c:pt idx="6">
                    <c:v>4.45230433471128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over_time_CO_AVERAGE!$H$2:$H$8</c:f>
              <c:numCache>
                <c:formatCode>0.00</c:formatCode>
                <c:ptCount val="7"/>
                <c:pt idx="0" formatCode="General">
                  <c:v>58.22</c:v>
                </c:pt>
                <c:pt idx="1">
                  <c:v>399.94166666666666</c:v>
                </c:pt>
                <c:pt idx="2">
                  <c:v>62.794999999999995</c:v>
                </c:pt>
                <c:pt idx="3">
                  <c:v>51.893333333333324</c:v>
                </c:pt>
                <c:pt idx="4">
                  <c:v>55.294999999999995</c:v>
                </c:pt>
                <c:pt idx="5">
                  <c:v>54.888333333333328</c:v>
                </c:pt>
                <c:pt idx="6">
                  <c:v>54.398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5882-4817-83D0-C9DA8D427D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48196512"/>
        <c:axId val="1048635920"/>
        <c:extLst/>
      </c:lineChart>
      <c:dateAx>
        <c:axId val="1048196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Hours after inocul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1048635920"/>
        <c:crosses val="autoZero"/>
        <c:auto val="0"/>
        <c:lblOffset val="100"/>
        <c:baseTimeUnit val="days"/>
        <c:majorUnit val="8"/>
        <c:majorTimeUnit val="days"/>
      </c:dateAx>
      <c:valAx>
        <c:axId val="1048635920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1048196512"/>
        <c:crosses val="autoZero"/>
        <c:crossBetween val="between"/>
        <c:majorUnit val="50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B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1"/>
          <c:order val="0"/>
          <c:tx>
            <c:strRef>
              <c:f>over_time_CO_AVERAGE!$J$1</c:f>
              <c:strCache>
                <c:ptCount val="1"/>
                <c:pt idx="0">
                  <c:v>PROPIONIC</c:v>
                </c:pt>
              </c:strCache>
            </c:strRef>
          </c:tx>
          <c:spPr>
            <a:ln w="28575" cap="rnd">
              <a:solidFill>
                <a:srgbClr val="A5002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A50021"/>
              </a:solidFill>
              <a:ln w="9525">
                <a:solidFill>
                  <a:srgbClr val="A5002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over_time_CO_AVERAGE!$J$11:$J$17</c:f>
                <c:numCache>
                  <c:formatCode>General</c:formatCode>
                  <c:ptCount val="7"/>
                  <c:pt idx="1">
                    <c:v>32.637789787640692</c:v>
                  </c:pt>
                  <c:pt idx="2">
                    <c:v>4.8157196300818388</c:v>
                  </c:pt>
                  <c:pt idx="3">
                    <c:v>6.1694770622980863</c:v>
                  </c:pt>
                  <c:pt idx="4">
                    <c:v>2.934090811288725</c:v>
                  </c:pt>
                  <c:pt idx="5">
                    <c:v>5.148784376486895</c:v>
                  </c:pt>
                  <c:pt idx="6">
                    <c:v>7.0683388351782366</c:v>
                  </c:pt>
                </c:numCache>
              </c:numRef>
            </c:plus>
            <c:minus>
              <c:numRef>
                <c:f>over_time_CO_AVERAGE!$J$11:$J$17</c:f>
                <c:numCache>
                  <c:formatCode>General</c:formatCode>
                  <c:ptCount val="7"/>
                  <c:pt idx="1">
                    <c:v>32.637789787640692</c:v>
                  </c:pt>
                  <c:pt idx="2">
                    <c:v>4.8157196300818388</c:v>
                  </c:pt>
                  <c:pt idx="3">
                    <c:v>6.1694770622980863</c:v>
                  </c:pt>
                  <c:pt idx="4">
                    <c:v>2.934090811288725</c:v>
                  </c:pt>
                  <c:pt idx="5">
                    <c:v>5.148784376486895</c:v>
                  </c:pt>
                  <c:pt idx="6">
                    <c:v>7.06833883517823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over_time_CO_AVERAGE!$B$2:$B$8</c:f>
              <c:numCache>
                <c:formatCode>General</c:formatCode>
                <c:ptCount val="7"/>
                <c:pt idx="0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over_time_CO_AVERAGE!$J$2:$J$8</c:f>
              <c:numCache>
                <c:formatCode>0.00</c:formatCode>
                <c:ptCount val="7"/>
                <c:pt idx="1">
                  <c:v>70.453333333333333</c:v>
                </c:pt>
                <c:pt idx="2">
                  <c:v>420.67333333333335</c:v>
                </c:pt>
                <c:pt idx="3">
                  <c:v>469.21166666666664</c:v>
                </c:pt>
                <c:pt idx="4">
                  <c:v>477.66666666666669</c:v>
                </c:pt>
                <c:pt idx="5">
                  <c:v>461.12166666666667</c:v>
                </c:pt>
                <c:pt idx="6">
                  <c:v>451.541666666666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229-4FC2-8BE2-B734BFEDA77D}"/>
            </c:ext>
          </c:extLst>
        </c:ser>
        <c:ser>
          <c:idx val="3"/>
          <c:order val="1"/>
          <c:tx>
            <c:strRef>
              <c:f>over_time_CO_AVERAGE!$N$1</c:f>
              <c:strCache>
                <c:ptCount val="1"/>
                <c:pt idx="0">
                  <c:v>ISO-VALERIC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dPt>
            <c:idx val="1"/>
            <c:marker>
              <c:symbol val="circle"/>
              <c:size val="5"/>
              <c:spPr>
                <a:solidFill>
                  <a:schemeClr val="accent6">
                    <a:lumMod val="50000"/>
                  </a:schemeClr>
                </a:solidFill>
                <a:ln w="9525">
                  <a:solidFill>
                    <a:schemeClr val="accent6">
                      <a:lumMod val="50000"/>
                    </a:schemeClr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2229-4FC2-8BE2-B734BFEDA77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N$11:$N$17</c:f>
                <c:numCache>
                  <c:formatCode>General</c:formatCode>
                  <c:ptCount val="7"/>
                  <c:pt idx="1">
                    <c:v>4.4222634350396737</c:v>
                  </c:pt>
                  <c:pt idx="2">
                    <c:v>42.072369264822029</c:v>
                  </c:pt>
                  <c:pt idx="3">
                    <c:v>10.815937314907112</c:v>
                  </c:pt>
                  <c:pt idx="4">
                    <c:v>5.9999879629509012</c:v>
                  </c:pt>
                  <c:pt idx="5">
                    <c:v>7.7390641481311349</c:v>
                  </c:pt>
                  <c:pt idx="6">
                    <c:v>9.4558089142189274</c:v>
                  </c:pt>
                </c:numCache>
              </c:numRef>
            </c:plus>
            <c:minus>
              <c:numRef>
                <c:f>over_time_CO_AVERAGE!$N$11:$N$17</c:f>
                <c:numCache>
                  <c:formatCode>General</c:formatCode>
                  <c:ptCount val="7"/>
                  <c:pt idx="1">
                    <c:v>4.4222634350396737</c:v>
                  </c:pt>
                  <c:pt idx="2">
                    <c:v>42.072369264822029</c:v>
                  </c:pt>
                  <c:pt idx="3">
                    <c:v>10.815937314907112</c:v>
                  </c:pt>
                  <c:pt idx="4">
                    <c:v>5.9999879629509012</c:v>
                  </c:pt>
                  <c:pt idx="5">
                    <c:v>7.7390641481311349</c:v>
                  </c:pt>
                  <c:pt idx="6">
                    <c:v>9.45580891421892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over_time_CO_AVERAGE!$B$2:$B$8</c:f>
              <c:numCache>
                <c:formatCode>General</c:formatCode>
                <c:ptCount val="7"/>
                <c:pt idx="0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over_time_CO_AVERAGE!$N$2:$N$8</c:f>
              <c:numCache>
                <c:formatCode>0.00</c:formatCode>
                <c:ptCount val="7"/>
                <c:pt idx="0" formatCode="General">
                  <c:v>7.87</c:v>
                </c:pt>
                <c:pt idx="1">
                  <c:v>10.028333333333332</c:v>
                </c:pt>
                <c:pt idx="2">
                  <c:v>387.83666666666664</c:v>
                </c:pt>
                <c:pt idx="3">
                  <c:v>663.12</c:v>
                </c:pt>
                <c:pt idx="4">
                  <c:v>662.23666666666668</c:v>
                </c:pt>
                <c:pt idx="5">
                  <c:v>662.05166666666662</c:v>
                </c:pt>
                <c:pt idx="6">
                  <c:v>669.156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229-4FC2-8BE2-B734BFEDA77D}"/>
            </c:ext>
          </c:extLst>
        </c:ser>
        <c:ser>
          <c:idx val="2"/>
          <c:order val="2"/>
          <c:tx>
            <c:strRef>
              <c:f>over_time_CO_AVERAGE!$I$1</c:f>
              <c:strCache>
                <c:ptCount val="1"/>
                <c:pt idx="0">
                  <c:v>ACETIC</c:v>
                </c:pt>
              </c:strCache>
            </c:strRef>
          </c:tx>
          <c:spPr>
            <a:ln w="28575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1">
                    <a:lumMod val="75000"/>
                  </a:schemeClr>
                </a:solidFill>
                <a:ln w="63500">
                  <a:solidFill>
                    <a:schemeClr val="accent1">
                      <a:lumMod val="75000"/>
                    </a:schemeClr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2229-4FC2-8BE2-B734BFEDA77D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1">
                    <a:lumMod val="75000"/>
                  </a:schemeClr>
                </a:solidFill>
                <a:ln w="9525">
                  <a:solidFill>
                    <a:schemeClr val="accent1">
                      <a:lumMod val="75000"/>
                    </a:schemeClr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5-2229-4FC2-8BE2-B734BFEDA77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I$11:$I$17</c:f>
                <c:numCache>
                  <c:formatCode>General</c:formatCode>
                  <c:ptCount val="7"/>
                  <c:pt idx="1">
                    <c:v>33.923821235559878</c:v>
                  </c:pt>
                  <c:pt idx="2">
                    <c:v>18.049797551957941</c:v>
                  </c:pt>
                  <c:pt idx="3">
                    <c:v>33.31800334987409</c:v>
                  </c:pt>
                  <c:pt idx="4">
                    <c:v>28.398712803380509</c:v>
                  </c:pt>
                  <c:pt idx="5">
                    <c:v>45.90173831736179</c:v>
                  </c:pt>
                  <c:pt idx="6">
                    <c:v>45.480741223315867</c:v>
                  </c:pt>
                </c:numCache>
              </c:numRef>
            </c:plus>
            <c:minus>
              <c:numRef>
                <c:f>over_time_CO_AVERAGE!$I$11:$I$17</c:f>
                <c:numCache>
                  <c:formatCode>General</c:formatCode>
                  <c:ptCount val="7"/>
                  <c:pt idx="1">
                    <c:v>33.923821235559878</c:v>
                  </c:pt>
                  <c:pt idx="2">
                    <c:v>18.049797551957941</c:v>
                  </c:pt>
                  <c:pt idx="3">
                    <c:v>33.31800334987409</c:v>
                  </c:pt>
                  <c:pt idx="4">
                    <c:v>28.398712803380509</c:v>
                  </c:pt>
                  <c:pt idx="5">
                    <c:v>45.90173831736179</c:v>
                  </c:pt>
                  <c:pt idx="6">
                    <c:v>45.4807412233158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over_time_CO_AVERAGE!$B$2:$B$8</c:f>
              <c:numCache>
                <c:formatCode>General</c:formatCode>
                <c:ptCount val="7"/>
                <c:pt idx="0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over_time_CO_AVERAGE!$I$2:$I$8</c:f>
              <c:numCache>
                <c:formatCode>0.00</c:formatCode>
                <c:ptCount val="7"/>
                <c:pt idx="0" formatCode="General">
                  <c:v>164.91</c:v>
                </c:pt>
                <c:pt idx="1">
                  <c:v>766.9616666666667</c:v>
                </c:pt>
                <c:pt idx="2">
                  <c:v>1442.9449999999999</c:v>
                </c:pt>
                <c:pt idx="3">
                  <c:v>1718.3216666666667</c:v>
                </c:pt>
                <c:pt idx="4">
                  <c:v>1845.1066666666666</c:v>
                </c:pt>
                <c:pt idx="5">
                  <c:v>1930.1283333333333</c:v>
                </c:pt>
                <c:pt idx="6">
                  <c:v>1964.20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2229-4FC2-8BE2-B734BFEDA77D}"/>
            </c:ext>
          </c:extLst>
        </c:ser>
        <c:ser>
          <c:idx val="4"/>
          <c:order val="3"/>
          <c:tx>
            <c:strRef>
              <c:f>over_time_CO_AVERAGE!$M$1</c:f>
              <c:strCache>
                <c:ptCount val="1"/>
                <c:pt idx="0">
                  <c:v>BUTYRIC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rgbClr val="7030A0"/>
                </a:solidFill>
                <a:ln w="63500">
                  <a:solidFill>
                    <a:srgbClr val="7030A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2229-4FC2-8BE2-B734BFEDA77D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rgbClr val="7030A0"/>
                </a:solidFill>
                <a:ln w="9525">
                  <a:solidFill>
                    <a:srgbClr val="7030A0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8-2229-4FC2-8BE2-B734BFEDA77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over_time_CO_AVERAGE!$M$11:$M$17</c:f>
                <c:numCache>
                  <c:formatCode>General</c:formatCode>
                  <c:ptCount val="7"/>
                  <c:pt idx="1">
                    <c:v>9.7738147903239714</c:v>
                  </c:pt>
                  <c:pt idx="2">
                    <c:v>20.727242942562327</c:v>
                  </c:pt>
                  <c:pt idx="3">
                    <c:v>17.32633392331519</c:v>
                  </c:pt>
                  <c:pt idx="4">
                    <c:v>19.320043995809147</c:v>
                  </c:pt>
                  <c:pt idx="5">
                    <c:v>27.943541293114578</c:v>
                  </c:pt>
                  <c:pt idx="6">
                    <c:v>26.092455273933542</c:v>
                  </c:pt>
                </c:numCache>
              </c:numRef>
            </c:plus>
            <c:minus>
              <c:numRef>
                <c:f>over_time_CO_AVERAGE!$M$11:$M$17</c:f>
                <c:numCache>
                  <c:formatCode>General</c:formatCode>
                  <c:ptCount val="7"/>
                  <c:pt idx="1">
                    <c:v>9.7738147903239714</c:v>
                  </c:pt>
                  <c:pt idx="2">
                    <c:v>20.727242942562327</c:v>
                  </c:pt>
                  <c:pt idx="3">
                    <c:v>17.32633392331519</c:v>
                  </c:pt>
                  <c:pt idx="4">
                    <c:v>19.320043995809147</c:v>
                  </c:pt>
                  <c:pt idx="5">
                    <c:v>27.943541293114578</c:v>
                  </c:pt>
                  <c:pt idx="6">
                    <c:v>26.0924552739335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over_time_CO_AVERAGE!$B$2:$B$8</c:f>
              <c:numCache>
                <c:formatCode>General</c:formatCode>
                <c:ptCount val="7"/>
                <c:pt idx="0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over_time_CO_AVERAGE!$M$2:$M$8</c:f>
              <c:numCache>
                <c:formatCode>0.00</c:formatCode>
                <c:ptCount val="7"/>
                <c:pt idx="0" formatCode="General">
                  <c:v>9.59</c:v>
                </c:pt>
                <c:pt idx="1">
                  <c:v>66.023333333333326</c:v>
                </c:pt>
                <c:pt idx="2">
                  <c:v>365.2</c:v>
                </c:pt>
                <c:pt idx="3">
                  <c:v>505.88833333333332</c:v>
                </c:pt>
                <c:pt idx="4">
                  <c:v>550.65</c:v>
                </c:pt>
                <c:pt idx="5">
                  <c:v>581.23</c:v>
                </c:pt>
                <c:pt idx="6">
                  <c:v>594.44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2229-4FC2-8BE2-B734BFEDA7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48196512"/>
        <c:axId val="1048635920"/>
        <c:extLst/>
      </c:lineChart>
      <c:dateAx>
        <c:axId val="1048196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Hours after inocul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1048635920"/>
        <c:crosses val="autoZero"/>
        <c:auto val="0"/>
        <c:lblOffset val="100"/>
        <c:baseTimeUnit val="days"/>
        <c:majorUnit val="8"/>
        <c:majorTimeUnit val="days"/>
      </c:dateAx>
      <c:valAx>
        <c:axId val="1048635920"/>
        <c:scaling>
          <c:orientation val="minMax"/>
          <c:max val="2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1048196512"/>
        <c:crosses val="autoZero"/>
        <c:crossBetween val="between"/>
        <c:majorUnit val="50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B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verage_STDEV!$C$2</c:f>
              <c:strCache>
                <c:ptCount val="1"/>
                <c:pt idx="0">
                  <c:v>Roseburia intestinalis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1"/>
                </a:solidFill>
                <a:ln w="63500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4-47FD-4698-A82B-AF4338E6EB4B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47FD-4698-A82B-AF4338E6EB4B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verage_STDEV!$C$37:$C$43</c:f>
                <c:numCache>
                  <c:formatCode>General</c:formatCode>
                  <c:ptCount val="7"/>
                  <c:pt idx="1">
                    <c:v>12972623.293475911</c:v>
                  </c:pt>
                  <c:pt idx="2">
                    <c:v>12723028.221812787</c:v>
                  </c:pt>
                  <c:pt idx="3">
                    <c:v>2594870.2520238743</c:v>
                  </c:pt>
                  <c:pt idx="4">
                    <c:v>4616136.8800474275</c:v>
                  </c:pt>
                  <c:pt idx="5">
                    <c:v>6846457.9754405413</c:v>
                  </c:pt>
                  <c:pt idx="6">
                    <c:v>5733139.5522344569</c:v>
                  </c:pt>
                </c:numCache>
              </c:numRef>
            </c:plus>
            <c:minus>
              <c:numRef>
                <c:f>Average_STDEV!$C$37:$C$43</c:f>
                <c:numCache>
                  <c:formatCode>General</c:formatCode>
                  <c:ptCount val="7"/>
                  <c:pt idx="1">
                    <c:v>12972623.293475911</c:v>
                  </c:pt>
                  <c:pt idx="2">
                    <c:v>12723028.221812787</c:v>
                  </c:pt>
                  <c:pt idx="3">
                    <c:v>2594870.2520238743</c:v>
                  </c:pt>
                  <c:pt idx="4">
                    <c:v>4616136.8800474275</c:v>
                  </c:pt>
                  <c:pt idx="5">
                    <c:v>6846457.9754405413</c:v>
                  </c:pt>
                  <c:pt idx="6">
                    <c:v>5733139.55223445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27:$B$33</c:f>
              <c:numCache>
                <c:formatCode>0</c:formatCode>
                <c:ptCount val="7"/>
                <c:pt idx="0" formatCode="General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Average_STDEV!$C$27:$C$33</c:f>
              <c:numCache>
                <c:formatCode>General</c:formatCode>
                <c:ptCount val="7"/>
                <c:pt idx="0" formatCode="0.00E+00">
                  <c:v>6236000</c:v>
                </c:pt>
                <c:pt idx="1">
                  <c:v>114559398.16314553</c:v>
                </c:pt>
                <c:pt idx="2">
                  <c:v>38475186.716794662</c:v>
                </c:pt>
                <c:pt idx="3">
                  <c:v>25433355.571408719</c:v>
                </c:pt>
                <c:pt idx="4">
                  <c:v>24724219.977240413</c:v>
                </c:pt>
                <c:pt idx="5">
                  <c:v>21114165.762939345</c:v>
                </c:pt>
                <c:pt idx="6">
                  <c:v>19572967.9252486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7FD-4698-A82B-AF4338E6EB4B}"/>
            </c:ext>
          </c:extLst>
        </c:ser>
        <c:ser>
          <c:idx val="1"/>
          <c:order val="1"/>
          <c:tx>
            <c:strRef>
              <c:f>Average_STDEV!$D$2</c:f>
              <c:strCache>
                <c:ptCount val="1"/>
                <c:pt idx="0">
                  <c:v>Blautia hydrogenotrophica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2"/>
                </a:solidFill>
                <a:ln w="63500">
                  <a:solidFill>
                    <a:schemeClr val="accent2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3-47FD-4698-A82B-AF4338E6EB4B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2"/>
                </a:solidFill>
                <a:ln w="9525">
                  <a:solidFill>
                    <a:schemeClr val="accent2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4-47FD-4698-A82B-AF4338E6EB4B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verage_STDEV!$D$37:$D$43</c:f>
                <c:numCache>
                  <c:formatCode>General</c:formatCode>
                  <c:ptCount val="7"/>
                  <c:pt idx="1">
                    <c:v>100824614.15706222</c:v>
                  </c:pt>
                  <c:pt idx="2">
                    <c:v>59786650.176176138</c:v>
                  </c:pt>
                  <c:pt idx="3">
                    <c:v>46754811.65331386</c:v>
                  </c:pt>
                  <c:pt idx="4">
                    <c:v>44149501.724271283</c:v>
                  </c:pt>
                  <c:pt idx="5">
                    <c:v>43607530.36059574</c:v>
                  </c:pt>
                  <c:pt idx="6">
                    <c:v>36293162.689119577</c:v>
                  </c:pt>
                </c:numCache>
              </c:numRef>
            </c:plus>
            <c:minus>
              <c:numRef>
                <c:f>Average_STDEV!$D$37:$D$43</c:f>
                <c:numCache>
                  <c:formatCode>General</c:formatCode>
                  <c:ptCount val="7"/>
                  <c:pt idx="1">
                    <c:v>100824614.15706222</c:v>
                  </c:pt>
                  <c:pt idx="2">
                    <c:v>59786650.176176138</c:v>
                  </c:pt>
                  <c:pt idx="3">
                    <c:v>46754811.65331386</c:v>
                  </c:pt>
                  <c:pt idx="4">
                    <c:v>44149501.724271283</c:v>
                  </c:pt>
                  <c:pt idx="5">
                    <c:v>43607530.36059574</c:v>
                  </c:pt>
                  <c:pt idx="6">
                    <c:v>36293162.6891195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27:$B$33</c:f>
              <c:numCache>
                <c:formatCode>0</c:formatCode>
                <c:ptCount val="7"/>
                <c:pt idx="0" formatCode="General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Average_STDEV!$D$27:$D$33</c:f>
              <c:numCache>
                <c:formatCode>General</c:formatCode>
                <c:ptCount val="7"/>
                <c:pt idx="0" formatCode="0.00E+00">
                  <c:v>10300200</c:v>
                </c:pt>
                <c:pt idx="1">
                  <c:v>253874060.96642867</c:v>
                </c:pt>
                <c:pt idx="2">
                  <c:v>270871701.07439715</c:v>
                </c:pt>
                <c:pt idx="3">
                  <c:v>318991696.28718621</c:v>
                </c:pt>
                <c:pt idx="4">
                  <c:v>315234252.87511688</c:v>
                </c:pt>
                <c:pt idx="5">
                  <c:v>247673492.21652636</c:v>
                </c:pt>
                <c:pt idx="6">
                  <c:v>223842284.151172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47FD-4698-A82B-AF4338E6EB4B}"/>
            </c:ext>
          </c:extLst>
        </c:ser>
        <c:ser>
          <c:idx val="2"/>
          <c:order val="2"/>
          <c:tx>
            <c:strRef>
              <c:f>Average_STDEV!$E$2</c:f>
              <c:strCache>
                <c:ptCount val="1"/>
                <c:pt idx="0">
                  <c:v>Bacteroides thetaiotaomicron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3"/>
                </a:solidFill>
                <a:ln w="63500">
                  <a:solidFill>
                    <a:schemeClr val="accent3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1-47FD-4698-A82B-AF4338E6EB4B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3"/>
                </a:solidFill>
                <a:ln w="9525">
                  <a:solidFill>
                    <a:schemeClr val="accent3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7-47FD-4698-A82B-AF4338E6EB4B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verage_STDEV!$E$37:$E$43</c:f>
                <c:numCache>
                  <c:formatCode>General</c:formatCode>
                  <c:ptCount val="7"/>
                  <c:pt idx="1">
                    <c:v>193713319.88645792</c:v>
                  </c:pt>
                  <c:pt idx="2">
                    <c:v>56453033.193853691</c:v>
                  </c:pt>
                  <c:pt idx="3">
                    <c:v>22497024.655922402</c:v>
                  </c:pt>
                  <c:pt idx="4">
                    <c:v>23017917.544377044</c:v>
                  </c:pt>
                  <c:pt idx="5">
                    <c:v>22129662.701404594</c:v>
                  </c:pt>
                  <c:pt idx="6">
                    <c:v>20248330.776690684</c:v>
                  </c:pt>
                </c:numCache>
              </c:numRef>
            </c:plus>
            <c:minus>
              <c:numRef>
                <c:f>Average_STDEV!$E$37:$E$43</c:f>
                <c:numCache>
                  <c:formatCode>General</c:formatCode>
                  <c:ptCount val="7"/>
                  <c:pt idx="1">
                    <c:v>193713319.88645792</c:v>
                  </c:pt>
                  <c:pt idx="2">
                    <c:v>56453033.193853691</c:v>
                  </c:pt>
                  <c:pt idx="3">
                    <c:v>22497024.655922402</c:v>
                  </c:pt>
                  <c:pt idx="4">
                    <c:v>23017917.544377044</c:v>
                  </c:pt>
                  <c:pt idx="5">
                    <c:v>22129662.701404594</c:v>
                  </c:pt>
                  <c:pt idx="6">
                    <c:v>20248330.7766906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27:$B$33</c:f>
              <c:numCache>
                <c:formatCode>0</c:formatCode>
                <c:ptCount val="7"/>
                <c:pt idx="0" formatCode="General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Average_STDEV!$E$27:$E$33</c:f>
              <c:numCache>
                <c:formatCode>General</c:formatCode>
                <c:ptCount val="7"/>
                <c:pt idx="0" formatCode="0.00E+00">
                  <c:v>17227600</c:v>
                </c:pt>
                <c:pt idx="1">
                  <c:v>1120815669.9402304</c:v>
                </c:pt>
                <c:pt idx="2">
                  <c:v>268506867.1648348</c:v>
                </c:pt>
                <c:pt idx="3">
                  <c:v>186278429.82118884</c:v>
                </c:pt>
                <c:pt idx="4">
                  <c:v>165706675.86979267</c:v>
                </c:pt>
                <c:pt idx="5">
                  <c:v>117972793.59329319</c:v>
                </c:pt>
                <c:pt idx="6">
                  <c:v>109968576.593486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47FD-4698-A82B-AF4338E6EB4B}"/>
            </c:ext>
          </c:extLst>
        </c:ser>
        <c:ser>
          <c:idx val="3"/>
          <c:order val="3"/>
          <c:tx>
            <c:strRef>
              <c:f>Average_STDEV!$F$2</c:f>
              <c:strCache>
                <c:ptCount val="1"/>
                <c:pt idx="0">
                  <c:v>Collinsella aerofaciens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4"/>
                </a:solidFill>
                <a:ln w="63500">
                  <a:solidFill>
                    <a:schemeClr val="accent4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2-47FD-4698-A82B-AF4338E6EB4B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accent4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A-47FD-4698-A82B-AF4338E6EB4B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verage_STDEV!$F$37:$F$43</c:f>
                <c:numCache>
                  <c:formatCode>General</c:formatCode>
                  <c:ptCount val="7"/>
                  <c:pt idx="1">
                    <c:v>121269793.89395586</c:v>
                  </c:pt>
                  <c:pt idx="2">
                    <c:v>9933962.7202163506</c:v>
                  </c:pt>
                  <c:pt idx="3">
                    <c:v>5836818.8653499531</c:v>
                  </c:pt>
                  <c:pt idx="4">
                    <c:v>9231251.3961506262</c:v>
                  </c:pt>
                  <c:pt idx="5">
                    <c:v>7369892.1436815253</c:v>
                  </c:pt>
                  <c:pt idx="6">
                    <c:v>8529769.2621883191</c:v>
                  </c:pt>
                </c:numCache>
              </c:numRef>
            </c:plus>
            <c:minus>
              <c:numRef>
                <c:f>Average_STDEV!$F$37:$F$43</c:f>
                <c:numCache>
                  <c:formatCode>General</c:formatCode>
                  <c:ptCount val="7"/>
                  <c:pt idx="1">
                    <c:v>121269793.89395586</c:v>
                  </c:pt>
                  <c:pt idx="2">
                    <c:v>9933962.7202163506</c:v>
                  </c:pt>
                  <c:pt idx="3">
                    <c:v>5836818.8653499531</c:v>
                  </c:pt>
                  <c:pt idx="4">
                    <c:v>9231251.3961506262</c:v>
                  </c:pt>
                  <c:pt idx="5">
                    <c:v>7369892.1436815253</c:v>
                  </c:pt>
                  <c:pt idx="6">
                    <c:v>8529769.26218831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27:$B$33</c:f>
              <c:numCache>
                <c:formatCode>0</c:formatCode>
                <c:ptCount val="7"/>
                <c:pt idx="0" formatCode="General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Average_STDEV!$F$27:$F$33</c:f>
              <c:numCache>
                <c:formatCode>General</c:formatCode>
                <c:ptCount val="7"/>
                <c:pt idx="0" formatCode="0.00E+00">
                  <c:v>12156000</c:v>
                </c:pt>
                <c:pt idx="1">
                  <c:v>199977655.46192193</c:v>
                </c:pt>
                <c:pt idx="2">
                  <c:v>34542248.832830064</c:v>
                </c:pt>
                <c:pt idx="3">
                  <c:v>33882193.905446902</c:v>
                </c:pt>
                <c:pt idx="4">
                  <c:v>41473642.110988118</c:v>
                </c:pt>
                <c:pt idx="5">
                  <c:v>41670048.427240886</c:v>
                </c:pt>
                <c:pt idx="6">
                  <c:v>37625774.7720797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47FD-4698-A82B-AF4338E6EB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639664"/>
        <c:axId val="45454432"/>
        <c:extLst>
          <c:ext xmlns:c15="http://schemas.microsoft.com/office/drawing/2012/chart" uri="{02D57815-91ED-43cb-92C2-25804820EDAC}">
            <c15:filteredLineSeries>
              <c15:ser>
                <c:idx val="5"/>
                <c:order val="4"/>
                <c:tx>
                  <c:strRef>
                    <c:extLst>
                      <c:ext uri="{02D57815-91ED-43cb-92C2-25804820EDAC}">
                        <c15:formulaRef>
                          <c15:sqref>Average_STDEV!$H$2</c15:sqref>
                        </c15:formulaRef>
                      </c:ext>
                    </c:extLst>
                    <c:strCache>
                      <c:ptCount val="1"/>
                      <c:pt idx="0">
                        <c:v>Pseudomonas</c:v>
                      </c:pt>
                    </c:strCache>
                  </c:strRef>
                </c:tx>
                <c:spPr>
                  <a:ln w="28575" cap="rnd">
                    <a:solidFill>
                      <a:schemeClr val="accent6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/>
                    </a:solidFill>
                    <a:ln w="9525">
                      <a:solidFill>
                        <a:schemeClr val="accent6"/>
                      </a:solidFill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Average_STDEV!$H$38:$H$43</c15:sqref>
                          </c15:formulaRef>
                        </c:ext>
                      </c:extLst>
                      <c:numCache>
                        <c:formatCode>General</c:formatCode>
                        <c:ptCount val="6"/>
                        <c:pt idx="0">
                          <c:v>84855.267689246873</c:v>
                        </c:pt>
                        <c:pt idx="1">
                          <c:v>7281.2828187958976</c:v>
                        </c:pt>
                        <c:pt idx="2">
                          <c:v>5800.0878914067152</c:v>
                        </c:pt>
                        <c:pt idx="3">
                          <c:v>5271.4441810105955</c:v>
                        </c:pt>
                        <c:pt idx="4">
                          <c:v>0</c:v>
                        </c:pt>
                        <c:pt idx="5">
                          <c:v>1539.4866890425237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Average_STDEV!$H$38:$H$43</c15:sqref>
                          </c15:formulaRef>
                        </c:ext>
                      </c:extLst>
                      <c:numCache>
                        <c:formatCode>General</c:formatCode>
                        <c:ptCount val="6"/>
                        <c:pt idx="0">
                          <c:v>84855.267689246873</c:v>
                        </c:pt>
                        <c:pt idx="1">
                          <c:v>7281.2828187958976</c:v>
                        </c:pt>
                        <c:pt idx="2">
                          <c:v>5800.0878914067152</c:v>
                        </c:pt>
                        <c:pt idx="3">
                          <c:v>5271.4441810105955</c:v>
                        </c:pt>
                        <c:pt idx="4">
                          <c:v>0</c:v>
                        </c:pt>
                        <c:pt idx="5">
                          <c:v>1539.4866890425237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>
                      <c:ext uri="{02D57815-91ED-43cb-92C2-25804820EDAC}">
                        <c15:formulaRef>
                          <c15:sqref>Average_STDEV!$B$27:$B$33</c15:sqref>
                        </c15:formulaRef>
                      </c:ext>
                    </c:extLst>
                    <c:numCache>
                      <c:formatCode>0</c:formatCode>
                      <c:ptCount val="7"/>
                      <c:pt idx="0" formatCode="General">
                        <c:v>0</c:v>
                      </c:pt>
                      <c:pt idx="1">
                        <c:v>12</c:v>
                      </c:pt>
                      <c:pt idx="2">
                        <c:v>25</c:v>
                      </c:pt>
                      <c:pt idx="3">
                        <c:v>37</c:v>
                      </c:pt>
                      <c:pt idx="4">
                        <c:v>49</c:v>
                      </c:pt>
                      <c:pt idx="5">
                        <c:v>61</c:v>
                      </c:pt>
                      <c:pt idx="6">
                        <c:v>67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Average_STDEV!$H$27:$H$33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1">
                        <c:v>37948.429360419505</c:v>
                      </c:pt>
                      <c:pt idx="2">
                        <c:v>5144.0866612673335</c:v>
                      </c:pt>
                      <c:pt idx="3">
                        <c:v>2593.8781601317664</c:v>
                      </c:pt>
                      <c:pt idx="4">
                        <c:v>3443.6101602270614</c:v>
                      </c:pt>
                      <c:pt idx="5">
                        <c:v>0</c:v>
                      </c:pt>
                      <c:pt idx="6">
                        <c:v>1063.2246788593566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10-47FD-4698-A82B-AF4338E6EB4B}"/>
                  </c:ext>
                </c:extLst>
              </c15:ser>
            </c15:filteredLineSeries>
          </c:ext>
        </c:extLst>
      </c:lineChart>
      <c:dateAx>
        <c:axId val="536396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 dirty="0" err="1"/>
                  <a:t>Hours</a:t>
                </a:r>
                <a:r>
                  <a:rPr lang="nl-BE" dirty="0"/>
                  <a:t> </a:t>
                </a:r>
                <a:r>
                  <a:rPr lang="nl-BE" dirty="0" err="1"/>
                  <a:t>after</a:t>
                </a:r>
                <a:r>
                  <a:rPr lang="nl-BE" dirty="0"/>
                  <a:t> </a:t>
                </a:r>
                <a:r>
                  <a:rPr lang="nl-BE" dirty="0" err="1"/>
                  <a:t>inoculation</a:t>
                </a:r>
                <a:endParaRPr lang="nl-BE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45454432"/>
        <c:crosses val="autoZero"/>
        <c:auto val="0"/>
        <c:lblOffset val="100"/>
        <c:baseTimeUnit val="days"/>
        <c:majorUnit val="4"/>
        <c:majorTimeUnit val="days"/>
      </c:dateAx>
      <c:valAx>
        <c:axId val="45454432"/>
        <c:scaling>
          <c:logBase val="10"/>
          <c:orientation val="minMax"/>
          <c:max val="5000000000"/>
          <c:min val="5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Cells/m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5363966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verage_STDEV!$C$2</c:f>
              <c:strCache>
                <c:ptCount val="1"/>
                <c:pt idx="0">
                  <c:v>Roseburia intestinalis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568F-4E5C-A1BE-AE923EB8536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verage_STDEV!$C$37:$C$43</c:f>
                <c:numCache>
                  <c:formatCode>General</c:formatCode>
                  <c:ptCount val="7"/>
                  <c:pt idx="1">
                    <c:v>12972623.293475911</c:v>
                  </c:pt>
                  <c:pt idx="2">
                    <c:v>12723028.221812787</c:v>
                  </c:pt>
                  <c:pt idx="3">
                    <c:v>2594870.2520238743</c:v>
                  </c:pt>
                  <c:pt idx="4">
                    <c:v>4616136.8800474275</c:v>
                  </c:pt>
                  <c:pt idx="5">
                    <c:v>6846457.9754405413</c:v>
                  </c:pt>
                  <c:pt idx="6">
                    <c:v>5733139.5522344569</c:v>
                  </c:pt>
                </c:numCache>
              </c:numRef>
            </c:plus>
            <c:minus>
              <c:numRef>
                <c:f>Average_STDEV!$C$37:$C$43</c:f>
                <c:numCache>
                  <c:formatCode>General</c:formatCode>
                  <c:ptCount val="7"/>
                  <c:pt idx="1">
                    <c:v>12972623.293475911</c:v>
                  </c:pt>
                  <c:pt idx="2">
                    <c:v>12723028.221812787</c:v>
                  </c:pt>
                  <c:pt idx="3">
                    <c:v>2594870.2520238743</c:v>
                  </c:pt>
                  <c:pt idx="4">
                    <c:v>4616136.8800474275</c:v>
                  </c:pt>
                  <c:pt idx="5">
                    <c:v>6846457.9754405413</c:v>
                  </c:pt>
                  <c:pt idx="6">
                    <c:v>5733139.55223445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27:$B$33</c:f>
              <c:numCache>
                <c:formatCode>0</c:formatCode>
                <c:ptCount val="7"/>
                <c:pt idx="0" formatCode="General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Average_STDEV!$C$27:$C$33</c:f>
              <c:numCache>
                <c:formatCode>General</c:formatCode>
                <c:ptCount val="7"/>
                <c:pt idx="0" formatCode="0.00E+00">
                  <c:v>6236000</c:v>
                </c:pt>
                <c:pt idx="1">
                  <c:v>114559398.16314553</c:v>
                </c:pt>
                <c:pt idx="2">
                  <c:v>38475186.716794662</c:v>
                </c:pt>
                <c:pt idx="3">
                  <c:v>25433355.571408719</c:v>
                </c:pt>
                <c:pt idx="4">
                  <c:v>24724219.977240413</c:v>
                </c:pt>
                <c:pt idx="5">
                  <c:v>21114165.762939345</c:v>
                </c:pt>
                <c:pt idx="6">
                  <c:v>19572967.9252486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68F-4E5C-A1BE-AE923EB85360}"/>
            </c:ext>
          </c:extLst>
        </c:ser>
        <c:ser>
          <c:idx val="1"/>
          <c:order val="1"/>
          <c:tx>
            <c:strRef>
              <c:f>Average_STDEV!$D$2</c:f>
              <c:strCache>
                <c:ptCount val="1"/>
                <c:pt idx="0">
                  <c:v>Blautia hydrogenotrophica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Pt>
            <c:idx val="1"/>
            <c:marker>
              <c:symbol val="circle"/>
              <c:size val="5"/>
              <c:spPr>
                <a:solidFill>
                  <a:schemeClr val="accent2"/>
                </a:solidFill>
                <a:ln w="9525">
                  <a:solidFill>
                    <a:schemeClr val="accent2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4-568F-4E5C-A1BE-AE923EB8536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verage_STDEV!$D$37:$D$43</c:f>
                <c:numCache>
                  <c:formatCode>General</c:formatCode>
                  <c:ptCount val="7"/>
                  <c:pt idx="1">
                    <c:v>100824614.15706222</c:v>
                  </c:pt>
                  <c:pt idx="2">
                    <c:v>59786650.176176138</c:v>
                  </c:pt>
                  <c:pt idx="3">
                    <c:v>46754811.65331386</c:v>
                  </c:pt>
                  <c:pt idx="4">
                    <c:v>44149501.724271283</c:v>
                  </c:pt>
                  <c:pt idx="5">
                    <c:v>43607530.36059574</c:v>
                  </c:pt>
                  <c:pt idx="6">
                    <c:v>36293162.689119577</c:v>
                  </c:pt>
                </c:numCache>
              </c:numRef>
            </c:plus>
            <c:minus>
              <c:numRef>
                <c:f>Average_STDEV!$D$37:$D$43</c:f>
                <c:numCache>
                  <c:formatCode>General</c:formatCode>
                  <c:ptCount val="7"/>
                  <c:pt idx="1">
                    <c:v>100824614.15706222</c:v>
                  </c:pt>
                  <c:pt idx="2">
                    <c:v>59786650.176176138</c:v>
                  </c:pt>
                  <c:pt idx="3">
                    <c:v>46754811.65331386</c:v>
                  </c:pt>
                  <c:pt idx="4">
                    <c:v>44149501.724271283</c:v>
                  </c:pt>
                  <c:pt idx="5">
                    <c:v>43607530.36059574</c:v>
                  </c:pt>
                  <c:pt idx="6">
                    <c:v>36293162.6891195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27:$B$33</c:f>
              <c:numCache>
                <c:formatCode>0</c:formatCode>
                <c:ptCount val="7"/>
                <c:pt idx="0" formatCode="General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Average_STDEV!$D$27:$D$33</c:f>
              <c:numCache>
                <c:formatCode>General</c:formatCode>
                <c:ptCount val="7"/>
                <c:pt idx="0" formatCode="0.00E+00">
                  <c:v>10300200</c:v>
                </c:pt>
                <c:pt idx="1">
                  <c:v>253874060.96642867</c:v>
                </c:pt>
                <c:pt idx="2">
                  <c:v>270871701.07439715</c:v>
                </c:pt>
                <c:pt idx="3">
                  <c:v>318991696.28718621</c:v>
                </c:pt>
                <c:pt idx="4">
                  <c:v>315234252.87511688</c:v>
                </c:pt>
                <c:pt idx="5">
                  <c:v>247673492.21652636</c:v>
                </c:pt>
                <c:pt idx="6">
                  <c:v>223842284.151172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68F-4E5C-A1BE-AE923EB85360}"/>
            </c:ext>
          </c:extLst>
        </c:ser>
        <c:ser>
          <c:idx val="2"/>
          <c:order val="2"/>
          <c:tx>
            <c:strRef>
              <c:f>Average_STDEV!$E$2</c:f>
              <c:strCache>
                <c:ptCount val="1"/>
                <c:pt idx="0">
                  <c:v>Bacteroides thetaiotaomicron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Pt>
            <c:idx val="1"/>
            <c:marker>
              <c:symbol val="circle"/>
              <c:size val="5"/>
              <c:spPr>
                <a:solidFill>
                  <a:schemeClr val="accent3"/>
                </a:solidFill>
                <a:ln w="9525">
                  <a:solidFill>
                    <a:schemeClr val="accent3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7-568F-4E5C-A1BE-AE923EB8536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verage_STDEV!$E$37:$E$43</c:f>
                <c:numCache>
                  <c:formatCode>General</c:formatCode>
                  <c:ptCount val="7"/>
                  <c:pt idx="1">
                    <c:v>193713319.88645792</c:v>
                  </c:pt>
                  <c:pt idx="2">
                    <c:v>56453033.193853691</c:v>
                  </c:pt>
                  <c:pt idx="3">
                    <c:v>22497024.655922402</c:v>
                  </c:pt>
                  <c:pt idx="4">
                    <c:v>23017917.544377044</c:v>
                  </c:pt>
                  <c:pt idx="5">
                    <c:v>22129662.701404594</c:v>
                  </c:pt>
                  <c:pt idx="6">
                    <c:v>20248330.776690684</c:v>
                  </c:pt>
                </c:numCache>
              </c:numRef>
            </c:plus>
            <c:minus>
              <c:numRef>
                <c:f>Average_STDEV!$E$37:$E$43</c:f>
                <c:numCache>
                  <c:formatCode>General</c:formatCode>
                  <c:ptCount val="7"/>
                  <c:pt idx="1">
                    <c:v>193713319.88645792</c:v>
                  </c:pt>
                  <c:pt idx="2">
                    <c:v>56453033.193853691</c:v>
                  </c:pt>
                  <c:pt idx="3">
                    <c:v>22497024.655922402</c:v>
                  </c:pt>
                  <c:pt idx="4">
                    <c:v>23017917.544377044</c:v>
                  </c:pt>
                  <c:pt idx="5">
                    <c:v>22129662.701404594</c:v>
                  </c:pt>
                  <c:pt idx="6">
                    <c:v>20248330.7766906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27:$B$33</c:f>
              <c:numCache>
                <c:formatCode>0</c:formatCode>
                <c:ptCount val="7"/>
                <c:pt idx="0" formatCode="General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Average_STDEV!$E$27:$E$33</c:f>
              <c:numCache>
                <c:formatCode>General</c:formatCode>
                <c:ptCount val="7"/>
                <c:pt idx="0" formatCode="0.00E+00">
                  <c:v>17227600</c:v>
                </c:pt>
                <c:pt idx="1">
                  <c:v>1120815669.9402304</c:v>
                </c:pt>
                <c:pt idx="2">
                  <c:v>268506867.1648348</c:v>
                </c:pt>
                <c:pt idx="3">
                  <c:v>186278429.82118884</c:v>
                </c:pt>
                <c:pt idx="4">
                  <c:v>165706675.86979267</c:v>
                </c:pt>
                <c:pt idx="5">
                  <c:v>117972793.59329319</c:v>
                </c:pt>
                <c:pt idx="6">
                  <c:v>109968576.593486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568F-4E5C-A1BE-AE923EB85360}"/>
            </c:ext>
          </c:extLst>
        </c:ser>
        <c:ser>
          <c:idx val="3"/>
          <c:order val="3"/>
          <c:tx>
            <c:strRef>
              <c:f>Average_STDEV!$F$2</c:f>
              <c:strCache>
                <c:ptCount val="1"/>
                <c:pt idx="0">
                  <c:v>Collinsella aerofaciens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4"/>
                </a:solidFill>
                <a:ln w="63500">
                  <a:solidFill>
                    <a:schemeClr val="accent4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0-568F-4E5C-A1BE-AE923EB85360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accent4"/>
                  </a:solidFill>
                </a:ln>
                <a:effectLst/>
              </c:spPr>
            </c:marker>
            <c:bubble3D val="0"/>
            <c:spPr>
              <a:ln w="28575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A-568F-4E5C-A1BE-AE923EB8536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verage_STDEV!$F$37:$F$43</c:f>
                <c:numCache>
                  <c:formatCode>General</c:formatCode>
                  <c:ptCount val="7"/>
                  <c:pt idx="1">
                    <c:v>121269793.89395586</c:v>
                  </c:pt>
                  <c:pt idx="2">
                    <c:v>9933962.7202163506</c:v>
                  </c:pt>
                  <c:pt idx="3">
                    <c:v>5836818.8653499531</c:v>
                  </c:pt>
                  <c:pt idx="4">
                    <c:v>9231251.3961506262</c:v>
                  </c:pt>
                  <c:pt idx="5">
                    <c:v>7369892.1436815253</c:v>
                  </c:pt>
                  <c:pt idx="6">
                    <c:v>8529769.2621883191</c:v>
                  </c:pt>
                </c:numCache>
              </c:numRef>
            </c:plus>
            <c:minus>
              <c:numRef>
                <c:f>Average_STDEV!$F$37:$F$43</c:f>
                <c:numCache>
                  <c:formatCode>General</c:formatCode>
                  <c:ptCount val="7"/>
                  <c:pt idx="1">
                    <c:v>121269793.89395586</c:v>
                  </c:pt>
                  <c:pt idx="2">
                    <c:v>9933962.7202163506</c:v>
                  </c:pt>
                  <c:pt idx="3">
                    <c:v>5836818.8653499531</c:v>
                  </c:pt>
                  <c:pt idx="4">
                    <c:v>9231251.3961506262</c:v>
                  </c:pt>
                  <c:pt idx="5">
                    <c:v>7369892.1436815253</c:v>
                  </c:pt>
                  <c:pt idx="6">
                    <c:v>8529769.26218831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27:$B$33</c:f>
              <c:numCache>
                <c:formatCode>0</c:formatCode>
                <c:ptCount val="7"/>
                <c:pt idx="0" formatCode="General">
                  <c:v>0</c:v>
                </c:pt>
                <c:pt idx="1">
                  <c:v>12</c:v>
                </c:pt>
                <c:pt idx="2">
                  <c:v>25</c:v>
                </c:pt>
                <c:pt idx="3">
                  <c:v>37</c:v>
                </c:pt>
                <c:pt idx="4">
                  <c:v>49</c:v>
                </c:pt>
                <c:pt idx="5">
                  <c:v>61</c:v>
                </c:pt>
                <c:pt idx="6">
                  <c:v>67</c:v>
                </c:pt>
              </c:numCache>
            </c:numRef>
          </c:cat>
          <c:val>
            <c:numRef>
              <c:f>Average_STDEV!$F$27:$F$33</c:f>
              <c:numCache>
                <c:formatCode>General</c:formatCode>
                <c:ptCount val="7"/>
                <c:pt idx="0" formatCode="0.00E+00">
                  <c:v>12156000</c:v>
                </c:pt>
                <c:pt idx="1">
                  <c:v>199977655.46192193</c:v>
                </c:pt>
                <c:pt idx="2">
                  <c:v>34542248.832830064</c:v>
                </c:pt>
                <c:pt idx="3">
                  <c:v>33882193.905446902</c:v>
                </c:pt>
                <c:pt idx="4">
                  <c:v>41473642.110988118</c:v>
                </c:pt>
                <c:pt idx="5">
                  <c:v>41670048.427240886</c:v>
                </c:pt>
                <c:pt idx="6">
                  <c:v>37625774.7720797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568F-4E5C-A1BE-AE923EB853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639664"/>
        <c:axId val="45454432"/>
        <c:extLst>
          <c:ext xmlns:c15="http://schemas.microsoft.com/office/drawing/2012/chart" uri="{02D57815-91ED-43cb-92C2-25804820EDAC}">
            <c15:filteredLineSeries>
              <c15:ser>
                <c:idx val="5"/>
                <c:order val="4"/>
                <c:tx>
                  <c:strRef>
                    <c:extLst>
                      <c:ext uri="{02D57815-91ED-43cb-92C2-25804820EDAC}">
                        <c15:formulaRef>
                          <c15:sqref>Average_STDEV!$H$2</c15:sqref>
                        </c15:formulaRef>
                      </c:ext>
                    </c:extLst>
                    <c:strCache>
                      <c:ptCount val="1"/>
                      <c:pt idx="0">
                        <c:v>Pseudomonas</c:v>
                      </c:pt>
                    </c:strCache>
                  </c:strRef>
                </c:tx>
                <c:spPr>
                  <a:ln w="28575" cap="rnd">
                    <a:solidFill>
                      <a:schemeClr val="accent6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/>
                    </a:solidFill>
                    <a:ln w="9525">
                      <a:solidFill>
                        <a:schemeClr val="accent6"/>
                      </a:solidFill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Average_STDEV!$H$38:$H$43</c15:sqref>
                          </c15:formulaRef>
                        </c:ext>
                      </c:extLst>
                      <c:numCache>
                        <c:formatCode>General</c:formatCode>
                        <c:ptCount val="6"/>
                        <c:pt idx="0">
                          <c:v>84855.267689246873</c:v>
                        </c:pt>
                        <c:pt idx="1">
                          <c:v>7281.2828187958976</c:v>
                        </c:pt>
                        <c:pt idx="2">
                          <c:v>5800.0878914067152</c:v>
                        </c:pt>
                        <c:pt idx="3">
                          <c:v>5271.4441810105955</c:v>
                        </c:pt>
                        <c:pt idx="4">
                          <c:v>0</c:v>
                        </c:pt>
                        <c:pt idx="5">
                          <c:v>1539.4866890425237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Average_STDEV!$H$38:$H$43</c15:sqref>
                          </c15:formulaRef>
                        </c:ext>
                      </c:extLst>
                      <c:numCache>
                        <c:formatCode>General</c:formatCode>
                        <c:ptCount val="6"/>
                        <c:pt idx="0">
                          <c:v>84855.267689246873</c:v>
                        </c:pt>
                        <c:pt idx="1">
                          <c:v>7281.2828187958976</c:v>
                        </c:pt>
                        <c:pt idx="2">
                          <c:v>5800.0878914067152</c:v>
                        </c:pt>
                        <c:pt idx="3">
                          <c:v>5271.4441810105955</c:v>
                        </c:pt>
                        <c:pt idx="4">
                          <c:v>0</c:v>
                        </c:pt>
                        <c:pt idx="5">
                          <c:v>1539.4866890425237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>
                      <c:ext uri="{02D57815-91ED-43cb-92C2-25804820EDAC}">
                        <c15:formulaRef>
                          <c15:sqref>Average_STDEV!$B$27:$B$33</c15:sqref>
                        </c15:formulaRef>
                      </c:ext>
                    </c:extLst>
                    <c:numCache>
                      <c:formatCode>0</c:formatCode>
                      <c:ptCount val="7"/>
                      <c:pt idx="0" formatCode="General">
                        <c:v>0</c:v>
                      </c:pt>
                      <c:pt idx="1">
                        <c:v>12</c:v>
                      </c:pt>
                      <c:pt idx="2">
                        <c:v>25</c:v>
                      </c:pt>
                      <c:pt idx="3">
                        <c:v>37</c:v>
                      </c:pt>
                      <c:pt idx="4">
                        <c:v>49</c:v>
                      </c:pt>
                      <c:pt idx="5">
                        <c:v>61</c:v>
                      </c:pt>
                      <c:pt idx="6">
                        <c:v>67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Average_STDEV!$H$27:$H$33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1">
                        <c:v>37948.429360419505</c:v>
                      </c:pt>
                      <c:pt idx="2">
                        <c:v>5144.0866612673335</c:v>
                      </c:pt>
                      <c:pt idx="3">
                        <c:v>2593.8781601317664</c:v>
                      </c:pt>
                      <c:pt idx="4">
                        <c:v>3443.6101602270614</c:v>
                      </c:pt>
                      <c:pt idx="5">
                        <c:v>0</c:v>
                      </c:pt>
                      <c:pt idx="6">
                        <c:v>1063.2246788593566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F-568F-4E5C-A1BE-AE923EB85360}"/>
                  </c:ext>
                </c:extLst>
              </c15:ser>
            </c15:filteredLineSeries>
          </c:ext>
        </c:extLst>
      </c:lineChart>
      <c:dateAx>
        <c:axId val="536396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 dirty="0" err="1"/>
                  <a:t>Hours</a:t>
                </a:r>
                <a:r>
                  <a:rPr lang="nl-BE" dirty="0"/>
                  <a:t> </a:t>
                </a:r>
                <a:r>
                  <a:rPr lang="nl-BE" dirty="0" err="1"/>
                  <a:t>after</a:t>
                </a:r>
                <a:r>
                  <a:rPr lang="nl-BE" dirty="0"/>
                  <a:t> </a:t>
                </a:r>
                <a:r>
                  <a:rPr lang="nl-BE" dirty="0" err="1"/>
                  <a:t>inoculation</a:t>
                </a:r>
                <a:endParaRPr lang="nl-BE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45454432"/>
        <c:crosses val="autoZero"/>
        <c:auto val="0"/>
        <c:lblOffset val="100"/>
        <c:baseTimeUnit val="days"/>
        <c:majorUnit val="4"/>
        <c:majorTimeUnit val="days"/>
      </c:dateAx>
      <c:valAx>
        <c:axId val="45454432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Cells/m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53639664"/>
        <c:crosses val="autoZero"/>
        <c:crossBetween val="between"/>
        <c:majorUnit val="500000000"/>
        <c:min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RI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extLst>
                <c:ext xmlns:c15="http://schemas.microsoft.com/office/drawing/2012/chart" uri="{02D57815-91ED-43cb-92C2-25804820EDAC}">
                  <c15:fullRef>
                    <c15:sqref>over_time_MONO!$C$1:$N$1</c15:sqref>
                  </c15:fullRef>
                </c:ext>
              </c:extLst>
              <c:f>(over_time_MONO!$C$1:$K$1,over_time_MONO!$M$1:$N$1)</c:f>
              <c:strCache>
                <c:ptCount val="11"/>
                <c:pt idx="0">
                  <c:v>TREHALOSE</c:v>
                </c:pt>
                <c:pt idx="1">
                  <c:v>GLUCOSE</c:v>
                </c:pt>
                <c:pt idx="2">
                  <c:v>PYRUVIC</c:v>
                </c:pt>
                <c:pt idx="3">
                  <c:v>SUCCINIC</c:v>
                </c:pt>
                <c:pt idx="4">
                  <c:v>LACTIC</c:v>
                </c:pt>
                <c:pt idx="5">
                  <c:v>FORMIC</c:v>
                </c:pt>
                <c:pt idx="6">
                  <c:v>ACETIC</c:v>
                </c:pt>
                <c:pt idx="7">
                  <c:v>PROPIONIC</c:v>
                </c:pt>
                <c:pt idx="8">
                  <c:v>ISO-BUTYRIC</c:v>
                </c:pt>
                <c:pt idx="9">
                  <c:v>BUTYRIC</c:v>
                </c:pt>
                <c:pt idx="10">
                  <c:v>ISO-VALERIC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over_time_MONO!$C$2:$N$2</c15:sqref>
                  </c15:fullRef>
                </c:ext>
              </c:extLst>
              <c:f>(over_time_MONO!$C$2:$K$2,over_time_MONO!$M$2:$N$2)</c:f>
              <c:numCache>
                <c:formatCode>0.00</c:formatCode>
                <c:ptCount val="11"/>
                <c:pt idx="0">
                  <c:v>233.75</c:v>
                </c:pt>
                <c:pt idx="1">
                  <c:v>1575.15</c:v>
                </c:pt>
                <c:pt idx="2">
                  <c:v>845.04</c:v>
                </c:pt>
                <c:pt idx="3">
                  <c:v>96.88</c:v>
                </c:pt>
                <c:pt idx="4">
                  <c:v>202.96</c:v>
                </c:pt>
                <c:pt idx="5">
                  <c:v>58.14</c:v>
                </c:pt>
                <c:pt idx="6">
                  <c:v>243.26</c:v>
                </c:pt>
                <c:pt idx="9">
                  <c:v>128.49</c:v>
                </c:pt>
                <c:pt idx="10">
                  <c:v>9.0399999999999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7F-41E7-829A-C4CB897CB899}"/>
            </c:ext>
          </c:extLst>
        </c:ser>
        <c:ser>
          <c:idx val="1"/>
          <c:order val="1"/>
          <c:tx>
            <c:v>BH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Lit>
              <c:ptCount val="11"/>
              <c:pt idx="0">
                <c:v>TREHALOSE</c:v>
              </c:pt>
              <c:pt idx="1">
                <c:v>GLUCOSE</c:v>
              </c:pt>
              <c:pt idx="2">
                <c:v>PYRUVIC</c:v>
              </c:pt>
              <c:pt idx="3">
                <c:v>SUCCINIC</c:v>
              </c:pt>
              <c:pt idx="4">
                <c:v>LACTIC</c:v>
              </c:pt>
              <c:pt idx="5">
                <c:v>FORMIC</c:v>
              </c:pt>
              <c:pt idx="6">
                <c:v>ACETIC</c:v>
              </c:pt>
              <c:pt idx="7">
                <c:v>PROPIONIC</c:v>
              </c:pt>
              <c:pt idx="8">
                <c:v>ISO-BUTYRIC</c:v>
              </c:pt>
              <c:pt idx="9">
                <c:v>BUTYRIC</c:v>
              </c:pt>
              <c:pt idx="10">
                <c:v>ISO-VALERIC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over_time_MONO!$C$5:$N$5</c15:sqref>
                  </c15:fullRef>
                </c:ext>
              </c:extLst>
              <c:f>(over_time_MONO!$C$5:$K$5,over_time_MONO!$M$5:$N$5)</c:f>
              <c:numCache>
                <c:formatCode>0.00</c:formatCode>
                <c:ptCount val="11"/>
                <c:pt idx="0">
                  <c:v>126.97</c:v>
                </c:pt>
                <c:pt idx="1">
                  <c:v>1816.15</c:v>
                </c:pt>
                <c:pt idx="2">
                  <c:v>691.99</c:v>
                </c:pt>
                <c:pt idx="3">
                  <c:v>95.8</c:v>
                </c:pt>
                <c:pt idx="4">
                  <c:v>280.33</c:v>
                </c:pt>
                <c:pt idx="5">
                  <c:v>41.23</c:v>
                </c:pt>
                <c:pt idx="6">
                  <c:v>297.89</c:v>
                </c:pt>
                <c:pt idx="10">
                  <c:v>10.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77F-41E7-829A-C4CB897CB899}"/>
            </c:ext>
          </c:extLst>
        </c:ser>
        <c:ser>
          <c:idx val="2"/>
          <c:order val="2"/>
          <c:tx>
            <c:v>BT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Lit>
              <c:ptCount val="11"/>
              <c:pt idx="0">
                <c:v>TREHALOSE</c:v>
              </c:pt>
              <c:pt idx="1">
                <c:v>GLUCOSE</c:v>
              </c:pt>
              <c:pt idx="2">
                <c:v>PYRUVIC</c:v>
              </c:pt>
              <c:pt idx="3">
                <c:v>SUCCINIC</c:v>
              </c:pt>
              <c:pt idx="4">
                <c:v>LACTIC</c:v>
              </c:pt>
              <c:pt idx="5">
                <c:v>FORMIC</c:v>
              </c:pt>
              <c:pt idx="6">
                <c:v>ACETIC</c:v>
              </c:pt>
              <c:pt idx="7">
                <c:v>PROPIONIC</c:v>
              </c:pt>
              <c:pt idx="8">
                <c:v>ISO-BUTYRIC</c:v>
              </c:pt>
              <c:pt idx="9">
                <c:v>BUTYRIC</c:v>
              </c:pt>
              <c:pt idx="10">
                <c:v>ISO-VALERIC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over_time_MONO!$C$8:$N$8</c15:sqref>
                  </c15:fullRef>
                </c:ext>
              </c:extLst>
              <c:f>(over_time_MONO!$C$8:$K$8,over_time_MONO!$M$8:$N$8)</c:f>
              <c:numCache>
                <c:formatCode>0.00</c:formatCode>
                <c:ptCount val="11"/>
                <c:pt idx="0">
                  <c:v>162.29</c:v>
                </c:pt>
                <c:pt idx="1">
                  <c:v>38.19</c:v>
                </c:pt>
                <c:pt idx="2">
                  <c:v>604.86</c:v>
                </c:pt>
                <c:pt idx="3">
                  <c:v>1231.54</c:v>
                </c:pt>
                <c:pt idx="4">
                  <c:v>310.89</c:v>
                </c:pt>
                <c:pt idx="5">
                  <c:v>266.63</c:v>
                </c:pt>
                <c:pt idx="6">
                  <c:v>754.82</c:v>
                </c:pt>
                <c:pt idx="10">
                  <c:v>13.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77F-41E7-829A-C4CB897CB899}"/>
            </c:ext>
          </c:extLst>
        </c:ser>
        <c:ser>
          <c:idx val="3"/>
          <c:order val="3"/>
          <c:tx>
            <c:v>CA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Lit>
              <c:ptCount val="11"/>
              <c:pt idx="0">
                <c:v>TREHALOSE</c:v>
              </c:pt>
              <c:pt idx="1">
                <c:v>GLUCOSE</c:v>
              </c:pt>
              <c:pt idx="2">
                <c:v>PYRUVIC</c:v>
              </c:pt>
              <c:pt idx="3">
                <c:v>SUCCINIC</c:v>
              </c:pt>
              <c:pt idx="4">
                <c:v>LACTIC</c:v>
              </c:pt>
              <c:pt idx="5">
                <c:v>FORMIC</c:v>
              </c:pt>
              <c:pt idx="6">
                <c:v>ACETIC</c:v>
              </c:pt>
              <c:pt idx="7">
                <c:v>PROPIONIC</c:v>
              </c:pt>
              <c:pt idx="8">
                <c:v>ISO-BUTYRIC</c:v>
              </c:pt>
              <c:pt idx="9">
                <c:v>BUTYRIC</c:v>
              </c:pt>
              <c:pt idx="10">
                <c:v>ISO-VALERIC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over_time_MONO!$C$11:$N$11</c15:sqref>
                  </c15:fullRef>
                </c:ext>
              </c:extLst>
              <c:f>(over_time_MONO!$C$11:$K$11,over_time_MONO!$M$11:$N$11)</c:f>
              <c:numCache>
                <c:formatCode>0.00</c:formatCode>
                <c:ptCount val="11"/>
                <c:pt idx="0">
                  <c:v>216.59</c:v>
                </c:pt>
                <c:pt idx="1">
                  <c:v>1162.6500000000001</c:v>
                </c:pt>
                <c:pt idx="2">
                  <c:v>787.6</c:v>
                </c:pt>
                <c:pt idx="3">
                  <c:v>99.35</c:v>
                </c:pt>
                <c:pt idx="4">
                  <c:v>422.67</c:v>
                </c:pt>
                <c:pt idx="5">
                  <c:v>273.52</c:v>
                </c:pt>
                <c:pt idx="6">
                  <c:v>343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77F-41E7-829A-C4CB897CB899}"/>
            </c:ext>
          </c:extLst>
        </c:ser>
        <c:ser>
          <c:idx val="4"/>
          <c:order val="4"/>
          <c:tx>
            <c:v>Blank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Lit>
              <c:ptCount val="11"/>
              <c:pt idx="0">
                <c:v>TREHALOSE</c:v>
              </c:pt>
              <c:pt idx="1">
                <c:v>GLUCOSE</c:v>
              </c:pt>
              <c:pt idx="2">
                <c:v>PYRUVIC</c:v>
              </c:pt>
              <c:pt idx="3">
                <c:v>SUCCINIC</c:v>
              </c:pt>
              <c:pt idx="4">
                <c:v>LACTIC</c:v>
              </c:pt>
              <c:pt idx="5">
                <c:v>FORMIC</c:v>
              </c:pt>
              <c:pt idx="6">
                <c:v>ACETIC</c:v>
              </c:pt>
              <c:pt idx="7">
                <c:v>PROPIONIC</c:v>
              </c:pt>
              <c:pt idx="8">
                <c:v>ISO-BUTYRIC</c:v>
              </c:pt>
              <c:pt idx="9">
                <c:v>BUTYRIC</c:v>
              </c:pt>
              <c:pt idx="10">
                <c:v>ISO-VALERIC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over_time_MONO!$C$17:$N$17</c15:sqref>
                  </c15:fullRef>
                </c:ext>
              </c:extLst>
              <c:f>(over_time_MONO!$C$17:$K$17,over_time_MONO!$M$17:$N$17)</c:f>
              <c:numCache>
                <c:formatCode>0.00</c:formatCode>
                <c:ptCount val="11"/>
                <c:pt idx="0">
                  <c:v>224.4</c:v>
                </c:pt>
                <c:pt idx="1">
                  <c:v>1778.48</c:v>
                </c:pt>
                <c:pt idx="2">
                  <c:v>902.69</c:v>
                </c:pt>
                <c:pt idx="3">
                  <c:v>99.77</c:v>
                </c:pt>
                <c:pt idx="4">
                  <c:v>141</c:v>
                </c:pt>
                <c:pt idx="5">
                  <c:v>58.22</c:v>
                </c:pt>
                <c:pt idx="6">
                  <c:v>164.91</c:v>
                </c:pt>
                <c:pt idx="9">
                  <c:v>9.59</c:v>
                </c:pt>
                <c:pt idx="10">
                  <c:v>7.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77F-41E7-829A-C4CB897CB8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985695"/>
        <c:axId val="183272255"/>
      </c:barChart>
      <c:catAx>
        <c:axId val="3149856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183272255"/>
        <c:crosses val="autoZero"/>
        <c:auto val="1"/>
        <c:lblAlgn val="ctr"/>
        <c:lblOffset val="100"/>
        <c:noMultiLvlLbl val="0"/>
      </c:catAx>
      <c:valAx>
        <c:axId val="183272255"/>
        <c:scaling>
          <c:orientation val="minMax"/>
          <c:max val="2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314985695"/>
        <c:crosses val="autoZero"/>
        <c:crossBetween val="between"/>
        <c:majorUnit val="5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nl-BE" dirty="0"/>
              <a:t>16S </a:t>
            </a:r>
            <a:r>
              <a:rPr lang="nl-BE" dirty="0" err="1"/>
              <a:t>rRNA</a:t>
            </a:r>
            <a:r>
              <a:rPr lang="nl-BE" dirty="0"/>
              <a:t> gene </a:t>
            </a:r>
            <a:r>
              <a:rPr lang="nl-BE" dirty="0" err="1"/>
              <a:t>sequencing</a:t>
            </a:r>
            <a:endParaRPr lang="nl-BE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BE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Average_STDEV!$C$2</c:f>
              <c:strCache>
                <c:ptCount val="1"/>
                <c:pt idx="0">
                  <c:v>Roseburia intestinali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TDEV!$C$14:$C$19</c:f>
                <c:numCache>
                  <c:formatCode>General</c:formatCode>
                  <c:ptCount val="6"/>
                  <c:pt idx="0">
                    <c:v>1.0829547652629112E-2</c:v>
                  </c:pt>
                  <c:pt idx="1">
                    <c:v>1.5280244709294616E-2</c:v>
                  </c:pt>
                  <c:pt idx="2">
                    <c:v>6.5175607347238299E-3</c:v>
                  </c:pt>
                  <c:pt idx="3">
                    <c:v>6.4039753832593905E-3</c:v>
                  </c:pt>
                  <c:pt idx="4">
                    <c:v>8.9040327280785134E-3</c:v>
                  </c:pt>
                  <c:pt idx="5">
                    <c:v>9.6211698191960484E-3</c:v>
                  </c:pt>
                </c:numCache>
              </c:numRef>
            </c:plus>
            <c:minus>
              <c:numRef>
                <c:f>Average_STDEV!$C$14:$C$19</c:f>
                <c:numCache>
                  <c:formatCode>General</c:formatCode>
                  <c:ptCount val="6"/>
                  <c:pt idx="0">
                    <c:v>1.0829547652629112E-2</c:v>
                  </c:pt>
                  <c:pt idx="1">
                    <c:v>1.5280244709294616E-2</c:v>
                  </c:pt>
                  <c:pt idx="2">
                    <c:v>6.5175607347238299E-3</c:v>
                  </c:pt>
                  <c:pt idx="3">
                    <c:v>6.4039753832593905E-3</c:v>
                  </c:pt>
                  <c:pt idx="4">
                    <c:v>8.9040327280785134E-3</c:v>
                  </c:pt>
                  <c:pt idx="5">
                    <c:v>9.621169819196048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4:$B$9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2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Average_STDEV!$C$4:$C$9</c:f>
              <c:numCache>
                <c:formatCode>General</c:formatCode>
                <c:ptCount val="6"/>
                <c:pt idx="0">
                  <c:v>6.9580636485426325E-2</c:v>
                </c:pt>
                <c:pt idx="1">
                  <c:v>6.2205499788772267E-2</c:v>
                </c:pt>
                <c:pt idx="2">
                  <c:v>4.563523190677831E-2</c:v>
                </c:pt>
                <c:pt idx="3">
                  <c:v>4.5310863560821736E-2</c:v>
                </c:pt>
                <c:pt idx="4">
                  <c:v>4.8304446142579838E-2</c:v>
                </c:pt>
                <c:pt idx="5">
                  <c:v>4.966869639310205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F0-4E42-971B-C9980DD4D890}"/>
            </c:ext>
          </c:extLst>
        </c:ser>
        <c:ser>
          <c:idx val="1"/>
          <c:order val="1"/>
          <c:tx>
            <c:strRef>
              <c:f>Average_STDEV!$D$2</c:f>
              <c:strCache>
                <c:ptCount val="1"/>
                <c:pt idx="0">
                  <c:v>Blautia hydrogenotrophic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TDEV!$D$14:$D$19</c:f>
                <c:numCache>
                  <c:formatCode>General</c:formatCode>
                  <c:ptCount val="6"/>
                  <c:pt idx="0">
                    <c:v>5.0843305704877238E-2</c:v>
                  </c:pt>
                  <c:pt idx="1">
                    <c:v>5.6533148525596294E-2</c:v>
                  </c:pt>
                  <c:pt idx="2">
                    <c:v>2.5642986456432249E-2</c:v>
                  </c:pt>
                  <c:pt idx="3">
                    <c:v>1.5535273870503827E-2</c:v>
                  </c:pt>
                  <c:pt idx="4">
                    <c:v>9.5193051627350811E-3</c:v>
                  </c:pt>
                  <c:pt idx="5">
                    <c:v>1.8916479303632668E-2</c:v>
                  </c:pt>
                </c:numCache>
              </c:numRef>
            </c:plus>
            <c:minus>
              <c:numRef>
                <c:f>Average_STDEV!$D$14:$D$19</c:f>
                <c:numCache>
                  <c:formatCode>General</c:formatCode>
                  <c:ptCount val="6"/>
                  <c:pt idx="0">
                    <c:v>5.0843305704877238E-2</c:v>
                  </c:pt>
                  <c:pt idx="1">
                    <c:v>5.6533148525596294E-2</c:v>
                  </c:pt>
                  <c:pt idx="2">
                    <c:v>2.5642986456432249E-2</c:v>
                  </c:pt>
                  <c:pt idx="3">
                    <c:v>1.5535273870503827E-2</c:v>
                  </c:pt>
                  <c:pt idx="4">
                    <c:v>9.5193051627350811E-3</c:v>
                  </c:pt>
                  <c:pt idx="5">
                    <c:v>1.891647930363266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4:$B$9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2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Average_STDEV!$D$4:$D$9</c:f>
              <c:numCache>
                <c:formatCode>General</c:formatCode>
                <c:ptCount val="6"/>
                <c:pt idx="0">
                  <c:v>0.14851380508691989</c:v>
                </c:pt>
                <c:pt idx="1">
                  <c:v>0.444006036183273</c:v>
                </c:pt>
                <c:pt idx="2">
                  <c:v>0.56309161800962204</c:v>
                </c:pt>
                <c:pt idx="3">
                  <c:v>0.576385748070118</c:v>
                </c:pt>
                <c:pt idx="4">
                  <c:v>0.57786254691470185</c:v>
                </c:pt>
                <c:pt idx="5">
                  <c:v>0.574145353409411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2F0-4E42-971B-C9980DD4D890}"/>
            </c:ext>
          </c:extLst>
        </c:ser>
        <c:ser>
          <c:idx val="2"/>
          <c:order val="2"/>
          <c:tx>
            <c:strRef>
              <c:f>Average_STDEV!$E$2</c:f>
              <c:strCache>
                <c:ptCount val="1"/>
                <c:pt idx="0">
                  <c:v>Bacteroides thetaiotaomicron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TDEV!$E$14:$E$19</c:f>
                <c:numCache>
                  <c:formatCode>General</c:formatCode>
                  <c:ptCount val="6"/>
                  <c:pt idx="0">
                    <c:v>5.6508096702734587E-2</c:v>
                  </c:pt>
                  <c:pt idx="1">
                    <c:v>3.187146640622416E-2</c:v>
                  </c:pt>
                  <c:pt idx="2">
                    <c:v>1.0835755127310505E-2</c:v>
                  </c:pt>
                  <c:pt idx="3">
                    <c:v>1.227090204127813E-2</c:v>
                  </c:pt>
                  <c:pt idx="4">
                    <c:v>4.8738668328083693E-3</c:v>
                  </c:pt>
                  <c:pt idx="5">
                    <c:v>1.0139402451161532E-2</c:v>
                  </c:pt>
                </c:numCache>
              </c:numRef>
            </c:plus>
            <c:minus>
              <c:numRef>
                <c:f>Average_STDEV!$E$14:$E$19</c:f>
                <c:numCache>
                  <c:formatCode>General</c:formatCode>
                  <c:ptCount val="6"/>
                  <c:pt idx="0">
                    <c:v>5.6508096702734587E-2</c:v>
                  </c:pt>
                  <c:pt idx="1">
                    <c:v>3.187146640622416E-2</c:v>
                  </c:pt>
                  <c:pt idx="2">
                    <c:v>1.0835755127310505E-2</c:v>
                  </c:pt>
                  <c:pt idx="3">
                    <c:v>1.227090204127813E-2</c:v>
                  </c:pt>
                  <c:pt idx="4">
                    <c:v>4.8738668328083693E-3</c:v>
                  </c:pt>
                  <c:pt idx="5">
                    <c:v>1.013940245116153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4:$B$9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2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Average_STDEV!$E$4:$E$9</c:f>
              <c:numCache>
                <c:formatCode>General</c:formatCode>
                <c:ptCount val="6"/>
                <c:pt idx="0">
                  <c:v>0.66818154822541731</c:v>
                </c:pt>
                <c:pt idx="1">
                  <c:v>0.43707443368583004</c:v>
                </c:pt>
                <c:pt idx="2">
                  <c:v>0.33000871425756784</c:v>
                </c:pt>
                <c:pt idx="3">
                  <c:v>0.30324582240167036</c:v>
                </c:pt>
                <c:pt idx="4">
                  <c:v>0.27467565391729282</c:v>
                </c:pt>
                <c:pt idx="5">
                  <c:v>0.280755794023304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2F0-4E42-971B-C9980DD4D890}"/>
            </c:ext>
          </c:extLst>
        </c:ser>
        <c:ser>
          <c:idx val="3"/>
          <c:order val="3"/>
          <c:tx>
            <c:strRef>
              <c:f>Average_STDEV!$F$2</c:f>
              <c:strCache>
                <c:ptCount val="1"/>
                <c:pt idx="0">
                  <c:v>Collinsella aerofacien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TDEV!$F$14:$F$19</c:f>
                <c:numCache>
                  <c:formatCode>General</c:formatCode>
                  <c:ptCount val="6"/>
                  <c:pt idx="0">
                    <c:v>5.0474145126434992E-2</c:v>
                  </c:pt>
                  <c:pt idx="1">
                    <c:v>1.3030796095273111E-2</c:v>
                  </c:pt>
                  <c:pt idx="2">
                    <c:v>1.3905069841300808E-2</c:v>
                  </c:pt>
                  <c:pt idx="3">
                    <c:v>9.4942777633109654E-3</c:v>
                  </c:pt>
                  <c:pt idx="4">
                    <c:v>1.7412821880592833E-2</c:v>
                  </c:pt>
                  <c:pt idx="5">
                    <c:v>9.062090374406799E-3</c:v>
                  </c:pt>
                </c:numCache>
              </c:numRef>
            </c:plus>
            <c:minus>
              <c:numRef>
                <c:f>Average_STDEV!$F$14:$F$19</c:f>
                <c:numCache>
                  <c:formatCode>General</c:formatCode>
                  <c:ptCount val="6"/>
                  <c:pt idx="0">
                    <c:v>5.0474145126434992E-2</c:v>
                  </c:pt>
                  <c:pt idx="1">
                    <c:v>1.3030796095273111E-2</c:v>
                  </c:pt>
                  <c:pt idx="2">
                    <c:v>1.3905069841300808E-2</c:v>
                  </c:pt>
                  <c:pt idx="3">
                    <c:v>9.4942777633109654E-3</c:v>
                  </c:pt>
                  <c:pt idx="4">
                    <c:v>1.7412821880592833E-2</c:v>
                  </c:pt>
                  <c:pt idx="5">
                    <c:v>9.06209037440679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verage_STDEV!$B$4:$B$9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2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Average_STDEV!$F$4:$F$9</c:f>
              <c:numCache>
                <c:formatCode>General</c:formatCode>
                <c:ptCount val="6"/>
                <c:pt idx="0">
                  <c:v>0.1136157071180149</c:v>
                </c:pt>
                <c:pt idx="1">
                  <c:v>5.6675896051947276E-2</c:v>
                </c:pt>
                <c:pt idx="2">
                  <c:v>6.1256768866089391E-2</c:v>
                </c:pt>
                <c:pt idx="3">
                  <c:v>7.5047679548133475E-2</c:v>
                </c:pt>
                <c:pt idx="4">
                  <c:v>9.9157353025425679E-2</c:v>
                </c:pt>
                <c:pt idx="5">
                  <c:v>9.542675686765485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2F0-4E42-971B-C9980DD4D890}"/>
            </c:ext>
          </c:extLst>
        </c:ser>
        <c:ser>
          <c:idx val="4"/>
          <c:order val="4"/>
          <c:tx>
            <c:strRef>
              <c:f>Average_STDEV!$G$2</c:f>
              <c:strCache>
                <c:ptCount val="1"/>
                <c:pt idx="0">
                  <c:v>Prevotella copri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Average_STDEV!$B$4:$B$9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2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Average_STDEV!$G$4:$G$9</c:f>
              <c:numCache>
                <c:formatCode>General</c:formatCode>
                <c:ptCount val="6"/>
                <c:pt idx="0">
                  <c:v>8.7396068175525895E-5</c:v>
                </c:pt>
                <c:pt idx="1">
                  <c:v>2.9732107264703216E-5</c:v>
                </c:pt>
                <c:pt idx="2">
                  <c:v>3.2452626737243166E-6</c:v>
                </c:pt>
                <c:pt idx="3">
                  <c:v>4.0927917751256501E-6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2F0-4E42-971B-C9980DD4D8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3639664"/>
        <c:axId val="45454432"/>
        <c:extLst>
          <c:ext xmlns:c15="http://schemas.microsoft.com/office/drawing/2012/chart" uri="{02D57815-91ED-43cb-92C2-25804820EDAC}">
            <c15:filteredBarSeries>
              <c15:ser>
                <c:idx val="5"/>
                <c:order val="5"/>
                <c:tx>
                  <c:strRef>
                    <c:extLst>
                      <c:ext uri="{02D57815-91ED-43cb-92C2-25804820EDAC}">
                        <c15:formulaRef>
                          <c15:sqref>Average_STDEV!$H$2</c15:sqref>
                        </c15:formulaRef>
                      </c:ext>
                    </c:extLst>
                    <c:strCache>
                      <c:ptCount val="1"/>
                      <c:pt idx="0">
                        <c:v>Pseudomonas</c:v>
                      </c:pt>
                    </c:strCache>
                  </c:strRef>
                </c:tx>
                <c:spPr>
                  <a:solidFill>
                    <a:schemeClr val="accent6"/>
                  </a:solidFill>
                  <a:ln>
                    <a:noFill/>
                  </a:ln>
                  <a:effectLst/>
                </c:spPr>
                <c:invertIfNegative val="0"/>
                <c:cat>
                  <c:numRef>
                    <c:extLst>
                      <c:ext uri="{02D57815-91ED-43cb-92C2-25804820EDAC}">
                        <c15:formulaRef>
                          <c15:sqref>Average_STDEV!$B$4:$B$9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12</c:v>
                      </c:pt>
                      <c:pt idx="1">
                        <c:v>25</c:v>
                      </c:pt>
                      <c:pt idx="2">
                        <c:v>27</c:v>
                      </c:pt>
                      <c:pt idx="3">
                        <c:v>49</c:v>
                      </c:pt>
                      <c:pt idx="4">
                        <c:v>61</c:v>
                      </c:pt>
                      <c:pt idx="5">
                        <c:v>67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Average_STDEV!$H$4:$H$9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.0907016046134834E-5</c:v>
                      </c:pt>
                      <c:pt idx="1">
                        <c:v>8.4021829123633666E-6</c:v>
                      </c:pt>
                      <c:pt idx="2">
                        <c:v>4.4216972684965165E-6</c:v>
                      </c:pt>
                      <c:pt idx="3">
                        <c:v>5.7936274815627661E-6</c:v>
                      </c:pt>
                      <c:pt idx="4">
                        <c:v>0</c:v>
                      </c:pt>
                      <c:pt idx="5">
                        <c:v>3.3993065277100299E-6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5-A2F0-4E42-971B-C9980DD4D890}"/>
                  </c:ext>
                </c:extLst>
              </c15:ser>
            </c15:filteredBarSeries>
          </c:ext>
        </c:extLst>
      </c:barChart>
      <c:catAx>
        <c:axId val="536396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 dirty="0" err="1"/>
                  <a:t>Hours</a:t>
                </a:r>
                <a:r>
                  <a:rPr lang="nl-BE" dirty="0"/>
                  <a:t> </a:t>
                </a:r>
                <a:r>
                  <a:rPr lang="nl-BE" dirty="0" err="1"/>
                  <a:t>after</a:t>
                </a:r>
                <a:r>
                  <a:rPr lang="nl-BE" baseline="0" dirty="0"/>
                  <a:t> </a:t>
                </a:r>
                <a:r>
                  <a:rPr lang="nl-BE" dirty="0" err="1"/>
                  <a:t>inoculation</a:t>
                </a:r>
                <a:endParaRPr lang="nl-BE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45454432"/>
        <c:crosses val="autoZero"/>
        <c:auto val="1"/>
        <c:lblAlgn val="ctr"/>
        <c:lblOffset val="100"/>
        <c:noMultiLvlLbl val="0"/>
      </c:catAx>
      <c:valAx>
        <c:axId val="45454432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5363966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nl-BE" dirty="0" err="1"/>
              <a:t>CellScanner</a:t>
            </a:r>
            <a:endParaRPr lang="nl-BE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BE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RelAbs_Last!$V$7</c:f>
              <c:strCache>
                <c:ptCount val="1"/>
                <c:pt idx="0">
                  <c:v>Roseburia intestinali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lAbs_Last!$V$19:$V$24</c:f>
                <c:numCache>
                  <c:formatCode>General</c:formatCode>
                  <c:ptCount val="6"/>
                  <c:pt idx="0">
                    <c:v>0.3389122847839019</c:v>
                  </c:pt>
                  <c:pt idx="1">
                    <c:v>0.25090745753799099</c:v>
                  </c:pt>
                  <c:pt idx="2">
                    <c:v>0.92123294193307048</c:v>
                  </c:pt>
                  <c:pt idx="3">
                    <c:v>0.66144479440589721</c:v>
                  </c:pt>
                  <c:pt idx="4">
                    <c:v>2.414620109956799</c:v>
                  </c:pt>
                  <c:pt idx="5">
                    <c:v>2.3144936971875909</c:v>
                  </c:pt>
                </c:numCache>
              </c:numRef>
            </c:plus>
            <c:minus>
              <c:numRef>
                <c:f>RelAbs_Last!$V$19:$V$24</c:f>
                <c:numCache>
                  <c:formatCode>General</c:formatCode>
                  <c:ptCount val="6"/>
                  <c:pt idx="0">
                    <c:v>0.3389122847839019</c:v>
                  </c:pt>
                  <c:pt idx="1">
                    <c:v>0.25090745753799099</c:v>
                  </c:pt>
                  <c:pt idx="2">
                    <c:v>0.92123294193307048</c:v>
                  </c:pt>
                  <c:pt idx="3">
                    <c:v>0.66144479440589721</c:v>
                  </c:pt>
                  <c:pt idx="4">
                    <c:v>2.414620109956799</c:v>
                  </c:pt>
                  <c:pt idx="5">
                    <c:v>2.31449369718759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RelAbs_Last!$U$8:$U$13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3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RelAbs_Last!$V$8:$V$13</c:f>
              <c:numCache>
                <c:formatCode>General</c:formatCode>
                <c:ptCount val="6"/>
                <c:pt idx="0">
                  <c:v>3.9759744862587945</c:v>
                </c:pt>
                <c:pt idx="1">
                  <c:v>1.170644665958712</c:v>
                </c:pt>
                <c:pt idx="2">
                  <c:v>4.2950333215095711</c:v>
                </c:pt>
                <c:pt idx="3">
                  <c:v>8.9620600647990472</c:v>
                </c:pt>
                <c:pt idx="4">
                  <c:v>14.251840278828107</c:v>
                </c:pt>
                <c:pt idx="5">
                  <c:v>16.557003190582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AC-4471-A1F0-B5A3E52E8A83}"/>
            </c:ext>
          </c:extLst>
        </c:ser>
        <c:ser>
          <c:idx val="1"/>
          <c:order val="1"/>
          <c:tx>
            <c:strRef>
              <c:f>RelAbs_Last!$W$7</c:f>
              <c:strCache>
                <c:ptCount val="1"/>
                <c:pt idx="0">
                  <c:v>Blautia hydrogenotrophic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lAbs_Last!$W$19:$W$24</c:f>
                <c:numCache>
                  <c:formatCode>General</c:formatCode>
                  <c:ptCount val="6"/>
                  <c:pt idx="0">
                    <c:v>0.17849968103181893</c:v>
                  </c:pt>
                  <c:pt idx="1">
                    <c:v>0.2974999986277414</c:v>
                  </c:pt>
                  <c:pt idx="2">
                    <c:v>1.5340972161422322</c:v>
                  </c:pt>
                  <c:pt idx="3">
                    <c:v>1.1876379591624779</c:v>
                  </c:pt>
                  <c:pt idx="4">
                    <c:v>1.9630332833349646</c:v>
                  </c:pt>
                  <c:pt idx="5">
                    <c:v>3.1174282145259538</c:v>
                  </c:pt>
                </c:numCache>
              </c:numRef>
            </c:plus>
            <c:minus>
              <c:numRef>
                <c:f>RelAbs_Last!$W$19:$W$24</c:f>
                <c:numCache>
                  <c:formatCode>General</c:formatCode>
                  <c:ptCount val="6"/>
                  <c:pt idx="0">
                    <c:v>0.17849968103181893</c:v>
                  </c:pt>
                  <c:pt idx="1">
                    <c:v>0.2974999986277414</c:v>
                  </c:pt>
                  <c:pt idx="2">
                    <c:v>1.5340972161422322</c:v>
                  </c:pt>
                  <c:pt idx="3">
                    <c:v>1.1876379591624779</c:v>
                  </c:pt>
                  <c:pt idx="4">
                    <c:v>1.9630332833349646</c:v>
                  </c:pt>
                  <c:pt idx="5">
                    <c:v>3.11742821452595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RelAbs_Last!$U$8:$U$13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3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RelAbs_Last!$W$8:$W$13</c:f>
              <c:numCache>
                <c:formatCode>General</c:formatCode>
                <c:ptCount val="6"/>
                <c:pt idx="0">
                  <c:v>4.9430034805938829</c:v>
                </c:pt>
                <c:pt idx="1">
                  <c:v>27.201188637250283</c:v>
                </c:pt>
                <c:pt idx="2">
                  <c:v>53.585347311018211</c:v>
                </c:pt>
                <c:pt idx="3">
                  <c:v>59.920273151018307</c:v>
                </c:pt>
                <c:pt idx="4">
                  <c:v>56.249029851362359</c:v>
                </c:pt>
                <c:pt idx="5">
                  <c:v>54.7680782665599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6AC-4471-A1F0-B5A3E52E8A83}"/>
            </c:ext>
          </c:extLst>
        </c:ser>
        <c:ser>
          <c:idx val="2"/>
          <c:order val="2"/>
          <c:tx>
            <c:strRef>
              <c:f>RelAbs_Last!$X$7</c:f>
              <c:strCache>
                <c:ptCount val="1"/>
                <c:pt idx="0">
                  <c:v>Bacteroides thetaiotaomicron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lAbs_Last!$X$19:$X$24</c:f>
                <c:numCache>
                  <c:formatCode>General</c:formatCode>
                  <c:ptCount val="6"/>
                  <c:pt idx="0">
                    <c:v>1.6689245748421531</c:v>
                  </c:pt>
                  <c:pt idx="1">
                    <c:v>0.42244457827817927</c:v>
                  </c:pt>
                  <c:pt idx="2">
                    <c:v>1.4543970753883204</c:v>
                  </c:pt>
                  <c:pt idx="3">
                    <c:v>0.85593398447821933</c:v>
                  </c:pt>
                  <c:pt idx="4">
                    <c:v>1.4991591586039137</c:v>
                  </c:pt>
                  <c:pt idx="5">
                    <c:v>1.3730893282189589</c:v>
                  </c:pt>
                </c:numCache>
              </c:numRef>
            </c:plus>
            <c:minus>
              <c:numRef>
                <c:f>RelAbs_Last!$X$19:$X$24</c:f>
                <c:numCache>
                  <c:formatCode>General</c:formatCode>
                  <c:ptCount val="6"/>
                  <c:pt idx="0">
                    <c:v>1.6689245748421531</c:v>
                  </c:pt>
                  <c:pt idx="1">
                    <c:v>0.42244457827817927</c:v>
                  </c:pt>
                  <c:pt idx="2">
                    <c:v>1.4543970753883204</c:v>
                  </c:pt>
                  <c:pt idx="3">
                    <c:v>0.85593398447821933</c:v>
                  </c:pt>
                  <c:pt idx="4">
                    <c:v>1.4991591586039137</c:v>
                  </c:pt>
                  <c:pt idx="5">
                    <c:v>1.37308932821895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RelAbs_Last!$U$8:$U$13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3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RelAbs_Last!$X$8:$X$13</c:f>
              <c:numCache>
                <c:formatCode>General</c:formatCode>
                <c:ptCount val="6"/>
                <c:pt idx="0">
                  <c:v>75.223604407956685</c:v>
                </c:pt>
                <c:pt idx="1">
                  <c:v>58.086821649859694</c:v>
                </c:pt>
                <c:pt idx="2">
                  <c:v>27.221207533933384</c:v>
                </c:pt>
                <c:pt idx="3">
                  <c:v>15.006338042560152</c:v>
                </c:pt>
                <c:pt idx="4">
                  <c:v>11.70965084713289</c:v>
                </c:pt>
                <c:pt idx="5">
                  <c:v>12.821409552153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6AC-4471-A1F0-B5A3E52E8A83}"/>
            </c:ext>
          </c:extLst>
        </c:ser>
        <c:ser>
          <c:idx val="3"/>
          <c:order val="3"/>
          <c:tx>
            <c:strRef>
              <c:f>RelAbs_Last!$Y$7</c:f>
              <c:strCache>
                <c:ptCount val="1"/>
                <c:pt idx="0">
                  <c:v>Collinsella aerofacien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lAbs_Last!$Y$19:$Y$24</c:f>
                <c:numCache>
                  <c:formatCode>General</c:formatCode>
                  <c:ptCount val="6"/>
                  <c:pt idx="0">
                    <c:v>0.82495562380186616</c:v>
                  </c:pt>
                  <c:pt idx="1">
                    <c:v>0.22203157880075142</c:v>
                  </c:pt>
                  <c:pt idx="2">
                    <c:v>0.30296109117222392</c:v>
                  </c:pt>
                  <c:pt idx="3">
                    <c:v>0.40222392920648492</c:v>
                  </c:pt>
                  <c:pt idx="4">
                    <c:v>1.0305303219901933</c:v>
                  </c:pt>
                  <c:pt idx="5">
                    <c:v>0.48031414128756644</c:v>
                  </c:pt>
                </c:numCache>
              </c:numRef>
            </c:plus>
            <c:minus>
              <c:numRef>
                <c:f>RelAbs_Last!$Y$19:$Y$24</c:f>
                <c:numCache>
                  <c:formatCode>General</c:formatCode>
                  <c:ptCount val="6"/>
                  <c:pt idx="0">
                    <c:v>0.82495562380186616</c:v>
                  </c:pt>
                  <c:pt idx="1">
                    <c:v>0.22203157880075142</c:v>
                  </c:pt>
                  <c:pt idx="2">
                    <c:v>0.30296109117222392</c:v>
                  </c:pt>
                  <c:pt idx="3">
                    <c:v>0.40222392920648492</c:v>
                  </c:pt>
                  <c:pt idx="4">
                    <c:v>1.0305303219901933</c:v>
                  </c:pt>
                  <c:pt idx="5">
                    <c:v>0.480314141287566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RelAbs_Last!$U$8:$U$13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3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RelAbs_Last!$Y$8:$Y$13</c:f>
              <c:numCache>
                <c:formatCode>General</c:formatCode>
                <c:ptCount val="6"/>
                <c:pt idx="0">
                  <c:v>9.3075105308719177</c:v>
                </c:pt>
                <c:pt idx="1">
                  <c:v>4.7890108493438426</c:v>
                </c:pt>
                <c:pt idx="2">
                  <c:v>3.9225670877939258</c:v>
                </c:pt>
                <c:pt idx="3">
                  <c:v>3.421461495835723</c:v>
                </c:pt>
                <c:pt idx="4">
                  <c:v>4.5982964113480476</c:v>
                </c:pt>
                <c:pt idx="5">
                  <c:v>4.61952567360964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6AC-4471-A1F0-B5A3E52E8A83}"/>
            </c:ext>
          </c:extLst>
        </c:ser>
        <c:ser>
          <c:idx val="4"/>
          <c:order val="4"/>
          <c:tx>
            <c:strRef>
              <c:f>RelAbs_Last!$Z$7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lAbs_Last!$Z$19:$Z$24</c:f>
                <c:numCache>
                  <c:formatCode>General</c:formatCode>
                  <c:ptCount val="6"/>
                  <c:pt idx="0">
                    <c:v>0.85535693787606015</c:v>
                  </c:pt>
                  <c:pt idx="1">
                    <c:v>0.26597489416364417</c:v>
                  </c:pt>
                  <c:pt idx="2">
                    <c:v>0.32599273506522131</c:v>
                  </c:pt>
                  <c:pt idx="3">
                    <c:v>0.65611406152454366</c:v>
                  </c:pt>
                  <c:pt idx="4">
                    <c:v>0.71001567607012894</c:v>
                  </c:pt>
                  <c:pt idx="5">
                    <c:v>0.27773724738451488</c:v>
                  </c:pt>
                </c:numCache>
              </c:numRef>
            </c:plus>
            <c:minus>
              <c:numRef>
                <c:f>RelAbs_Last!$Z$19:$Z$24</c:f>
                <c:numCache>
                  <c:formatCode>General</c:formatCode>
                  <c:ptCount val="6"/>
                  <c:pt idx="0">
                    <c:v>0.85535693787606015</c:v>
                  </c:pt>
                  <c:pt idx="1">
                    <c:v>0.26597489416364417</c:v>
                  </c:pt>
                  <c:pt idx="2">
                    <c:v>0.32599273506522131</c:v>
                  </c:pt>
                  <c:pt idx="3">
                    <c:v>0.65611406152454366</c:v>
                  </c:pt>
                  <c:pt idx="4">
                    <c:v>0.71001567607012894</c:v>
                  </c:pt>
                  <c:pt idx="5">
                    <c:v>0.277737247384514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RelAbs_Last!$U$8:$U$13</c:f>
              <c:numCache>
                <c:formatCode>General</c:formatCode>
                <c:ptCount val="6"/>
                <c:pt idx="0">
                  <c:v>12</c:v>
                </c:pt>
                <c:pt idx="1">
                  <c:v>25</c:v>
                </c:pt>
                <c:pt idx="2">
                  <c:v>37</c:v>
                </c:pt>
                <c:pt idx="3">
                  <c:v>49</c:v>
                </c:pt>
                <c:pt idx="4">
                  <c:v>61</c:v>
                </c:pt>
                <c:pt idx="5">
                  <c:v>67</c:v>
                </c:pt>
              </c:numCache>
            </c:numRef>
          </c:cat>
          <c:val>
            <c:numRef>
              <c:f>RelAbs_Last!$Z$8:$Z$13</c:f>
              <c:numCache>
                <c:formatCode>General</c:formatCode>
                <c:ptCount val="6"/>
                <c:pt idx="0">
                  <c:v>6.5499070943187192</c:v>
                </c:pt>
                <c:pt idx="1">
                  <c:v>8.7523341975874605</c:v>
                </c:pt>
                <c:pt idx="2">
                  <c:v>10.975844745744906</c:v>
                </c:pt>
                <c:pt idx="3">
                  <c:v>12.689867245786772</c:v>
                </c:pt>
                <c:pt idx="4">
                  <c:v>13.191182611328601</c:v>
                </c:pt>
                <c:pt idx="5">
                  <c:v>11.2339833170941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6AC-4471-A1F0-B5A3E52E8A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93927407"/>
        <c:axId val="201345583"/>
      </c:barChart>
      <c:catAx>
        <c:axId val="29392740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 dirty="0" err="1"/>
                  <a:t>Hours</a:t>
                </a:r>
                <a:r>
                  <a:rPr lang="nl-BE" dirty="0"/>
                  <a:t> </a:t>
                </a:r>
                <a:r>
                  <a:rPr lang="nl-BE" dirty="0" err="1"/>
                  <a:t>after</a:t>
                </a:r>
                <a:r>
                  <a:rPr lang="nl-BE" dirty="0"/>
                  <a:t> </a:t>
                </a:r>
                <a:r>
                  <a:rPr lang="nl-BE" dirty="0" err="1"/>
                  <a:t>inoculation</a:t>
                </a:r>
                <a:endParaRPr lang="nl-BE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201345583"/>
        <c:crosses val="autoZero"/>
        <c:auto val="1"/>
        <c:lblAlgn val="ctr"/>
        <c:lblOffset val="100"/>
        <c:noMultiLvlLbl val="0"/>
      </c:catAx>
      <c:valAx>
        <c:axId val="201345583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293927407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W$2</c:f>
              <c:strCache>
                <c:ptCount val="1"/>
                <c:pt idx="0">
                  <c:v>Manual gating Exp2</c:v>
                </c:pt>
              </c:strCache>
            </c:strRef>
          </c:tx>
          <c:spPr>
            <a:ln w="28575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X$4:$X$15</c:f>
                <c:numCache>
                  <c:formatCode>General</c:formatCode>
                  <c:ptCount val="12"/>
                  <c:pt idx="0">
                    <c:v>1780460.6769659987</c:v>
                  </c:pt>
                  <c:pt idx="1">
                    <c:v>177908241.53728393</c:v>
                  </c:pt>
                  <c:pt idx="2">
                    <c:v>700562773.5332973</c:v>
                  </c:pt>
                  <c:pt idx="4">
                    <c:v>696048043.52206218</c:v>
                  </c:pt>
                  <c:pt idx="6">
                    <c:v>348835931.8699199</c:v>
                  </c:pt>
                  <c:pt idx="8">
                    <c:v>254769936.64393669</c:v>
                  </c:pt>
                  <c:pt idx="11">
                    <c:v>137816180.6279977</c:v>
                  </c:pt>
                </c:numCache>
              </c:numRef>
            </c:plus>
            <c:minus>
              <c:numRef>
                <c:f>Sheet1!$X$4:$X$15</c:f>
                <c:numCache>
                  <c:formatCode>General</c:formatCode>
                  <c:ptCount val="12"/>
                  <c:pt idx="0">
                    <c:v>1780460.6769659987</c:v>
                  </c:pt>
                  <c:pt idx="1">
                    <c:v>177908241.53728393</c:v>
                  </c:pt>
                  <c:pt idx="2">
                    <c:v>700562773.5332973</c:v>
                  </c:pt>
                  <c:pt idx="4">
                    <c:v>696048043.52206218</c:v>
                  </c:pt>
                  <c:pt idx="6">
                    <c:v>348835931.8699199</c:v>
                  </c:pt>
                  <c:pt idx="8">
                    <c:v>254769936.64393669</c:v>
                  </c:pt>
                  <c:pt idx="11">
                    <c:v>137816180.6279977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accent1">
                    <a:lumMod val="75000"/>
                  </a:schemeClr>
                </a:solidFill>
                <a:round/>
              </a:ln>
              <a:effectLst/>
            </c:spPr>
          </c:errBars>
          <c:cat>
            <c:numRef>
              <c:f>Sheet1!$V$4:$V$15</c:f>
              <c:numCache>
                <c:formatCode>General</c:formatCode>
                <c:ptCount val="12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25</c:v>
                </c:pt>
                <c:pt idx="4">
                  <c:v>36</c:v>
                </c:pt>
                <c:pt idx="5">
                  <c:v>37</c:v>
                </c:pt>
                <c:pt idx="6">
                  <c:v>48</c:v>
                </c:pt>
                <c:pt idx="7">
                  <c:v>49</c:v>
                </c:pt>
                <c:pt idx="8">
                  <c:v>60</c:v>
                </c:pt>
                <c:pt idx="9">
                  <c:v>61</c:v>
                </c:pt>
                <c:pt idx="10">
                  <c:v>67</c:v>
                </c:pt>
                <c:pt idx="11">
                  <c:v>72</c:v>
                </c:pt>
              </c:numCache>
            </c:numRef>
          </c:cat>
          <c:val>
            <c:numRef>
              <c:f>Sheet1!$W$4:$W$15</c:f>
              <c:numCache>
                <c:formatCode>General</c:formatCode>
                <c:ptCount val="12"/>
                <c:pt idx="0">
                  <c:v>17293666.666666668</c:v>
                </c:pt>
                <c:pt idx="1">
                  <c:v>1551863666.6666667</c:v>
                </c:pt>
                <c:pt idx="2">
                  <c:v>2373655000</c:v>
                </c:pt>
                <c:pt idx="4">
                  <c:v>4286575666.6666665</c:v>
                </c:pt>
                <c:pt idx="6">
                  <c:v>3550597666.6666665</c:v>
                </c:pt>
                <c:pt idx="8">
                  <c:v>3392159666.6666665</c:v>
                </c:pt>
                <c:pt idx="11">
                  <c:v>2978742333.33333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622-4D74-B3EA-FA67941A5A37}"/>
            </c:ext>
          </c:extLst>
        </c:ser>
        <c:ser>
          <c:idx val="1"/>
          <c:order val="1"/>
          <c:tx>
            <c:strRef>
              <c:f>Sheet1!$Y$2</c:f>
              <c:strCache>
                <c:ptCount val="1"/>
                <c:pt idx="0">
                  <c:v>CellScanner gating Exp2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  <a:prstDash val="sysDot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Z$4:$Z$15</c:f>
                <c:numCache>
                  <c:formatCode>General</c:formatCode>
                  <c:ptCount val="12"/>
                  <c:pt idx="0">
                    <c:v>1652325.5515985826</c:v>
                  </c:pt>
                  <c:pt idx="1">
                    <c:v>177841453.58943039</c:v>
                  </c:pt>
                  <c:pt idx="2">
                    <c:v>718455289.88799179</c:v>
                  </c:pt>
                  <c:pt idx="4">
                    <c:v>457385099.10530567</c:v>
                  </c:pt>
                  <c:pt idx="6">
                    <c:v>457647258.45740056</c:v>
                  </c:pt>
                  <c:pt idx="8">
                    <c:v>268054813.50774407</c:v>
                  </c:pt>
                  <c:pt idx="11">
                    <c:v>213162694.09427428</c:v>
                  </c:pt>
                </c:numCache>
              </c:numRef>
            </c:plus>
            <c:minus>
              <c:numRef>
                <c:f>Sheet1!$Z$4:$Z$15</c:f>
                <c:numCache>
                  <c:formatCode>General</c:formatCode>
                  <c:ptCount val="12"/>
                  <c:pt idx="0">
                    <c:v>1652325.5515985826</c:v>
                  </c:pt>
                  <c:pt idx="1">
                    <c:v>177841453.58943039</c:v>
                  </c:pt>
                  <c:pt idx="2">
                    <c:v>718455289.88799179</c:v>
                  </c:pt>
                  <c:pt idx="4">
                    <c:v>457385099.10530567</c:v>
                  </c:pt>
                  <c:pt idx="6">
                    <c:v>457647258.45740056</c:v>
                  </c:pt>
                  <c:pt idx="8">
                    <c:v>268054813.50774407</c:v>
                  </c:pt>
                  <c:pt idx="11">
                    <c:v>213162694.09427428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accent1"/>
                </a:solidFill>
                <a:prstDash val="sysDot"/>
                <a:round/>
              </a:ln>
              <a:effectLst/>
            </c:spPr>
          </c:errBars>
          <c:cat>
            <c:numRef>
              <c:f>Sheet1!$V$4:$V$15</c:f>
              <c:numCache>
                <c:formatCode>General</c:formatCode>
                <c:ptCount val="12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25</c:v>
                </c:pt>
                <c:pt idx="4">
                  <c:v>36</c:v>
                </c:pt>
                <c:pt idx="5">
                  <c:v>37</c:v>
                </c:pt>
                <c:pt idx="6">
                  <c:v>48</c:v>
                </c:pt>
                <c:pt idx="7">
                  <c:v>49</c:v>
                </c:pt>
                <c:pt idx="8">
                  <c:v>60</c:v>
                </c:pt>
                <c:pt idx="9">
                  <c:v>61</c:v>
                </c:pt>
                <c:pt idx="10">
                  <c:v>67</c:v>
                </c:pt>
                <c:pt idx="11">
                  <c:v>72</c:v>
                </c:pt>
              </c:numCache>
            </c:numRef>
          </c:cat>
          <c:val>
            <c:numRef>
              <c:f>Sheet1!$Y$4:$Y$15</c:f>
              <c:numCache>
                <c:formatCode>General</c:formatCode>
                <c:ptCount val="12"/>
                <c:pt idx="0">
                  <c:v>20807076.290078644</c:v>
                </c:pt>
                <c:pt idx="1">
                  <c:v>1554743211.5733335</c:v>
                </c:pt>
                <c:pt idx="2">
                  <c:v>2419107642.7666669</c:v>
                </c:pt>
                <c:pt idx="4">
                  <c:v>4816725594.5333338</c:v>
                </c:pt>
                <c:pt idx="6">
                  <c:v>3993465672.5733337</c:v>
                </c:pt>
                <c:pt idx="8">
                  <c:v>3561459014.2333336</c:v>
                </c:pt>
                <c:pt idx="11">
                  <c:v>3108724610.47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622-4D74-B3EA-FA67941A5A37}"/>
            </c:ext>
          </c:extLst>
        </c:ser>
        <c:ser>
          <c:idx val="2"/>
          <c:order val="2"/>
          <c:tx>
            <c:strRef>
              <c:f>Sheet1!$AA$2</c:f>
              <c:strCache>
                <c:ptCount val="1"/>
                <c:pt idx="0">
                  <c:v>Manual gating Exp1</c:v>
                </c:pt>
              </c:strCache>
            </c:strRef>
          </c:tx>
          <c:spPr>
            <a:ln w="28575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accent2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B$4:$AB$15</c:f>
                <c:numCache>
                  <c:formatCode>General</c:formatCode>
                  <c:ptCount val="12"/>
                  <c:pt idx="1">
                    <c:v>415207592.8919642</c:v>
                  </c:pt>
                  <c:pt idx="3">
                    <c:v>116536004.07408665</c:v>
                  </c:pt>
                  <c:pt idx="5">
                    <c:v>72101880.038865253</c:v>
                  </c:pt>
                  <c:pt idx="7">
                    <c:v>80095594.676506996</c:v>
                  </c:pt>
                  <c:pt idx="9">
                    <c:v>64973829.572631046</c:v>
                  </c:pt>
                  <c:pt idx="10">
                    <c:v>67552518.476779059</c:v>
                  </c:pt>
                </c:numCache>
              </c:numRef>
            </c:plus>
            <c:minus>
              <c:numRef>
                <c:f>Sheet1!$AB$4:$AB$15</c:f>
                <c:numCache>
                  <c:formatCode>General</c:formatCode>
                  <c:ptCount val="12"/>
                  <c:pt idx="1">
                    <c:v>415207592.8919642</c:v>
                  </c:pt>
                  <c:pt idx="3">
                    <c:v>116536004.07408665</c:v>
                  </c:pt>
                  <c:pt idx="5">
                    <c:v>72101880.038865253</c:v>
                  </c:pt>
                  <c:pt idx="7">
                    <c:v>80095594.676506996</c:v>
                  </c:pt>
                  <c:pt idx="9">
                    <c:v>64973829.572631046</c:v>
                  </c:pt>
                  <c:pt idx="10">
                    <c:v>67552518.47677905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accent2">
                    <a:lumMod val="75000"/>
                  </a:schemeClr>
                </a:solidFill>
                <a:round/>
              </a:ln>
              <a:effectLst/>
            </c:spPr>
          </c:errBars>
          <c:cat>
            <c:numRef>
              <c:f>Sheet1!$V$4:$V$15</c:f>
              <c:numCache>
                <c:formatCode>General</c:formatCode>
                <c:ptCount val="12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25</c:v>
                </c:pt>
                <c:pt idx="4">
                  <c:v>36</c:v>
                </c:pt>
                <c:pt idx="5">
                  <c:v>37</c:v>
                </c:pt>
                <c:pt idx="6">
                  <c:v>48</c:v>
                </c:pt>
                <c:pt idx="7">
                  <c:v>49</c:v>
                </c:pt>
                <c:pt idx="8">
                  <c:v>60</c:v>
                </c:pt>
                <c:pt idx="9">
                  <c:v>61</c:v>
                </c:pt>
                <c:pt idx="10">
                  <c:v>67</c:v>
                </c:pt>
                <c:pt idx="11">
                  <c:v>72</c:v>
                </c:pt>
              </c:numCache>
            </c:numRef>
          </c:cat>
          <c:val>
            <c:numRef>
              <c:f>Sheet1!$AA$4:$AA$15</c:f>
              <c:numCache>
                <c:formatCode>General</c:formatCode>
                <c:ptCount val="12"/>
                <c:pt idx="1">
                  <c:v>2632583166.6666665</c:v>
                </c:pt>
                <c:pt idx="3">
                  <c:v>650522666.66666663</c:v>
                </c:pt>
                <c:pt idx="5">
                  <c:v>614667833.33333337</c:v>
                </c:pt>
                <c:pt idx="7">
                  <c:v>612119500</c:v>
                </c:pt>
                <c:pt idx="9">
                  <c:v>521527000</c:v>
                </c:pt>
                <c:pt idx="10">
                  <c:v>475492333.3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622-4D74-B3EA-FA67941A5A37}"/>
            </c:ext>
          </c:extLst>
        </c:ser>
        <c:ser>
          <c:idx val="3"/>
          <c:order val="3"/>
          <c:tx>
            <c:strRef>
              <c:f>Sheet1!$AC$2</c:f>
              <c:strCache>
                <c:ptCount val="1"/>
                <c:pt idx="0">
                  <c:v>CellScanner gating Exp1</c:v>
                </c:pt>
              </c:strCache>
            </c:strRef>
          </c:tx>
          <c:spPr>
            <a:ln w="28575" cap="rnd">
              <a:solidFill>
                <a:schemeClr val="accent2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  <a:prstDash val="sysDot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D$4:$AD$15</c:f>
                <c:numCache>
                  <c:formatCode>General</c:formatCode>
                  <c:ptCount val="12"/>
                  <c:pt idx="1">
                    <c:v>413060645.45339173</c:v>
                  </c:pt>
                  <c:pt idx="3">
                    <c:v>115475043.08265223</c:v>
                  </c:pt>
                  <c:pt idx="5">
                    <c:v>69504326.613581672</c:v>
                  </c:pt>
                  <c:pt idx="7">
                    <c:v>80662998.876355007</c:v>
                  </c:pt>
                  <c:pt idx="9">
                    <c:v>76171400.697391912</c:v>
                  </c:pt>
                  <c:pt idx="10">
                    <c:v>72239585.263663918</c:v>
                  </c:pt>
                </c:numCache>
              </c:numRef>
            </c:plus>
            <c:minus>
              <c:numRef>
                <c:f>Sheet1!$AD$4:$AD$15</c:f>
                <c:numCache>
                  <c:formatCode>General</c:formatCode>
                  <c:ptCount val="12"/>
                  <c:pt idx="1">
                    <c:v>413060645.45339173</c:v>
                  </c:pt>
                  <c:pt idx="3">
                    <c:v>115475043.08265223</c:v>
                  </c:pt>
                  <c:pt idx="5">
                    <c:v>69504326.613581672</c:v>
                  </c:pt>
                  <c:pt idx="7">
                    <c:v>80662998.876355007</c:v>
                  </c:pt>
                  <c:pt idx="9">
                    <c:v>76171400.697391912</c:v>
                  </c:pt>
                  <c:pt idx="10">
                    <c:v>72239585.263663918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accent2"/>
                </a:solidFill>
                <a:prstDash val="sysDot"/>
                <a:round/>
              </a:ln>
              <a:effectLst/>
            </c:spPr>
          </c:errBars>
          <c:cat>
            <c:numRef>
              <c:f>Sheet1!$V$4:$V$15</c:f>
              <c:numCache>
                <c:formatCode>General</c:formatCode>
                <c:ptCount val="12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25</c:v>
                </c:pt>
                <c:pt idx="4">
                  <c:v>36</c:v>
                </c:pt>
                <c:pt idx="5">
                  <c:v>37</c:v>
                </c:pt>
                <c:pt idx="6">
                  <c:v>48</c:v>
                </c:pt>
                <c:pt idx="7">
                  <c:v>49</c:v>
                </c:pt>
                <c:pt idx="8">
                  <c:v>60</c:v>
                </c:pt>
                <c:pt idx="9">
                  <c:v>61</c:v>
                </c:pt>
                <c:pt idx="10">
                  <c:v>67</c:v>
                </c:pt>
                <c:pt idx="11">
                  <c:v>72</c:v>
                </c:pt>
              </c:numCache>
            </c:numRef>
          </c:cat>
          <c:val>
            <c:numRef>
              <c:f>Sheet1!$AC$4:$AC$15</c:f>
              <c:numCache>
                <c:formatCode>General</c:formatCode>
                <c:ptCount val="12"/>
                <c:pt idx="1">
                  <c:v>2586218014.856667</c:v>
                </c:pt>
                <c:pt idx="3">
                  <c:v>616818480.50552404</c:v>
                </c:pt>
                <c:pt idx="5">
                  <c:v>576996950.76924407</c:v>
                </c:pt>
                <c:pt idx="7">
                  <c:v>571589558.82209039</c:v>
                </c:pt>
                <c:pt idx="9">
                  <c:v>449884580.51236099</c:v>
                </c:pt>
                <c:pt idx="10">
                  <c:v>412247732.983812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622-4D74-B3EA-FA67941A5A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99385120"/>
        <c:axId val="1599519456"/>
      </c:lineChart>
      <c:dateAx>
        <c:axId val="1599385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Hours after inocul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1599519456"/>
        <c:crosses val="autoZero"/>
        <c:auto val="0"/>
        <c:lblOffset val="100"/>
        <c:baseTimeUnit val="days"/>
        <c:majorUnit val="10"/>
        <c:majorTimeUnit val="days"/>
      </c:dateAx>
      <c:valAx>
        <c:axId val="15995194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BE"/>
                  <a:t>Cells/ml</a:t>
                </a:r>
              </a:p>
            </c:rich>
          </c:tx>
          <c:layout>
            <c:manualLayout>
              <c:xMode val="edge"/>
              <c:yMode val="edge"/>
              <c:x val="3.6301251221236975E-3"/>
              <c:y val="0.417818526357739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B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>
                <a:alpha val="88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1599385120"/>
        <c:crosses val="autoZero"/>
        <c:crossBetween val="between"/>
        <c:majorUnit val="100000000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DE5CBF-19A6-4A55-825A-CCC6191EC1C2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31D403-30DB-4E1A-8097-0C2F4CAD0DC1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066166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1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049216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2 Counts per ml 16S</a:t>
            </a:r>
          </a:p>
          <a:p>
            <a:r>
              <a:rPr lang="en-US" dirty="0"/>
              <a:t>Ambr2 and Ambr4</a:t>
            </a:r>
          </a:p>
          <a:p>
            <a:r>
              <a:rPr lang="en-US" dirty="0"/>
              <a:t>for 6 vessels except Ambr4 (B) T26-T74, only vessel 7 and 8</a:t>
            </a:r>
            <a:endParaRPr lang="nl-BE" dirty="0"/>
          </a:p>
          <a:p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3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5266739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qrt transformed / 2</a:t>
            </a:r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5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6722780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4. HPLC results for monocultures after 12h in batch mode. </a:t>
            </a:r>
            <a:r>
              <a:rPr lang="en-US" i="1" dirty="0" err="1"/>
              <a:t>Prevotella</a:t>
            </a:r>
            <a:r>
              <a:rPr lang="en-US" i="1" dirty="0"/>
              <a:t> </a:t>
            </a:r>
            <a:r>
              <a:rPr lang="en-US" i="1" dirty="0" err="1"/>
              <a:t>copri</a:t>
            </a:r>
            <a:r>
              <a:rPr lang="en-US" i="1" dirty="0"/>
              <a:t> </a:t>
            </a:r>
            <a:r>
              <a:rPr lang="en-US" dirty="0"/>
              <a:t>was excluded due to contamination (see Supplementary Figure 5A). </a:t>
            </a:r>
            <a:endParaRPr lang="en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6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93913831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3</a:t>
            </a:r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7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9501796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4</a:t>
            </a:r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8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8775012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10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2679358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11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60809881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6</a:t>
            </a:r>
            <a:endParaRPr lang="nl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31D403-30DB-4E1A-8097-0C2F4CAD0DC1}" type="slidenum">
              <a:rPr lang="nl-BE" smtClean="0"/>
              <a:t>12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72739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78316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5007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750393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11830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477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2458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833363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61372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36991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331064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426550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292247-7160-4054-B1E4-0C957E51BE0B}" type="datetimeFigureOut">
              <a:rPr lang="nl-BE" smtClean="0"/>
              <a:t>27/10/2022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7940D-69CD-41AB-8ECF-EEBD4DC29243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60785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sv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sv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svg"/><Relationship Id="rId9" Type="http://schemas.openxmlformats.org/officeDocument/2006/relationships/image" Target="../media/image7.png"/><Relationship Id="rId14" Type="http://schemas.openxmlformats.org/officeDocument/2006/relationships/image" Target="../media/image12.sv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8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emf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2C184BB1-BD0D-4FDC-96FD-571601A75994}"/>
              </a:ext>
            </a:extLst>
          </p:cNvPr>
          <p:cNvSpPr txBox="1"/>
          <p:nvPr/>
        </p:nvSpPr>
        <p:spPr>
          <a:xfrm>
            <a:off x="404660" y="265577"/>
            <a:ext cx="16867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A</a:t>
            </a:r>
            <a:endParaRPr lang="nl-BE" sz="26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5FEC093-E23A-43D7-94A9-FD2272E76647}"/>
              </a:ext>
            </a:extLst>
          </p:cNvPr>
          <p:cNvSpPr txBox="1"/>
          <p:nvPr/>
        </p:nvSpPr>
        <p:spPr>
          <a:xfrm>
            <a:off x="399927" y="5216447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B</a:t>
            </a:r>
            <a:endParaRPr lang="nl-BE" sz="2600" b="1" dirty="0"/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87718C94-31C1-4771-A585-941900626FF9}"/>
              </a:ext>
            </a:extLst>
          </p:cNvPr>
          <p:cNvGrpSpPr/>
          <p:nvPr/>
        </p:nvGrpSpPr>
        <p:grpSpPr>
          <a:xfrm>
            <a:off x="5228773" y="5934107"/>
            <a:ext cx="7316477" cy="1506889"/>
            <a:chOff x="3635411" y="6313343"/>
            <a:chExt cx="7316477" cy="150688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25203EF-3597-40DA-8925-A1E9B35BC6C8}"/>
                </a:ext>
              </a:extLst>
            </p:cNvPr>
            <p:cNvSpPr txBox="1"/>
            <p:nvPr/>
          </p:nvSpPr>
          <p:spPr>
            <a:xfrm>
              <a:off x="3635411" y="6870249"/>
              <a:ext cx="1645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250 </a:t>
              </a:r>
              <a:r>
                <a:rPr lang="el-GR" b="1" dirty="0"/>
                <a:t>μ</a:t>
              </a:r>
              <a:r>
                <a:rPr lang="en-US" b="1" dirty="0"/>
                <a:t>l samples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47CEB3FE-DACF-4F26-9774-7D783B904E78}"/>
                </a:ext>
              </a:extLst>
            </p:cNvPr>
            <p:cNvSpPr/>
            <p:nvPr/>
          </p:nvSpPr>
          <p:spPr>
            <a:xfrm>
              <a:off x="6667500" y="6313343"/>
              <a:ext cx="365759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dirty="0" err="1"/>
                <a:t>Cellcount</a:t>
              </a:r>
              <a:r>
                <a:rPr lang="en-US" dirty="0"/>
                <a:t> (Flow cytometer)</a:t>
              </a:r>
              <a:endParaRPr lang="nl-BE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6555E894-0212-44C0-9ED3-38C94F17028A}"/>
                </a:ext>
              </a:extLst>
            </p:cNvPr>
            <p:cNvSpPr/>
            <p:nvPr/>
          </p:nvSpPr>
          <p:spPr>
            <a:xfrm>
              <a:off x="6667500" y="7173901"/>
              <a:ext cx="4284388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nl-BE" dirty="0"/>
                <a:t>Pellet: 16S </a:t>
              </a:r>
              <a:r>
                <a:rPr lang="nl-BE" dirty="0" err="1"/>
                <a:t>rRNA</a:t>
              </a:r>
              <a:r>
                <a:rPr lang="nl-BE" dirty="0"/>
                <a:t> gene </a:t>
              </a:r>
              <a:r>
                <a:rPr lang="nl-BE" dirty="0" err="1"/>
                <a:t>sequencing</a:t>
              </a:r>
              <a:r>
                <a:rPr lang="nl-BE" dirty="0"/>
                <a:t> (</a:t>
              </a:r>
              <a:r>
                <a:rPr lang="nl-BE" dirty="0" err="1"/>
                <a:t>MiSeq</a:t>
              </a:r>
              <a:r>
                <a:rPr lang="nl-BE" dirty="0"/>
                <a:t>)</a:t>
              </a:r>
            </a:p>
            <a:p>
              <a:r>
                <a:rPr lang="nl-BE" dirty="0" err="1">
                  <a:sym typeface="Wingdings" panose="05000000000000000000" pitchFamily="2" charset="2"/>
                </a:rPr>
                <a:t>S</a:t>
              </a:r>
              <a:r>
                <a:rPr lang="nl-BE" dirty="0" err="1"/>
                <a:t>upernatant</a:t>
              </a:r>
              <a:r>
                <a:rPr lang="nl-BE" dirty="0"/>
                <a:t>: HPLC</a:t>
              </a:r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7DFBE393-3B42-45EA-BA86-6079D3CBB7CB}"/>
                </a:ext>
              </a:extLst>
            </p:cNvPr>
            <p:cNvCxnSpPr>
              <a:cxnSpLocks/>
              <a:stCxn id="4" idx="3"/>
              <a:endCxn id="3" idx="1"/>
            </p:cNvCxnSpPr>
            <p:nvPr/>
          </p:nvCxnSpPr>
          <p:spPr>
            <a:xfrm flipV="1">
              <a:off x="5280443" y="6498009"/>
              <a:ext cx="1387057" cy="556906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9FCC880-68B0-4A86-84E4-157EF01F02A7}"/>
                </a:ext>
              </a:extLst>
            </p:cNvPr>
            <p:cNvSpPr txBox="1"/>
            <p:nvPr/>
          </p:nvSpPr>
          <p:spPr>
            <a:xfrm rot="20357374">
              <a:off x="5494149" y="6351164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100 </a:t>
              </a:r>
              <a:r>
                <a:rPr lang="en-US" b="1" dirty="0" err="1"/>
                <a:t>μl</a:t>
              </a:r>
              <a:endParaRPr lang="nl-BE" b="1" dirty="0"/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B064F7FB-306F-467E-9715-ECC7D8EC9208}"/>
                </a:ext>
              </a:extLst>
            </p:cNvPr>
            <p:cNvCxnSpPr>
              <a:cxnSpLocks/>
              <a:stCxn id="4" idx="3"/>
              <a:endCxn id="7" idx="1"/>
            </p:cNvCxnSpPr>
            <p:nvPr/>
          </p:nvCxnSpPr>
          <p:spPr>
            <a:xfrm>
              <a:off x="5280443" y="7054915"/>
              <a:ext cx="1387057" cy="442152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204F87F5-9889-4070-8D3A-E9BCCCE8A640}"/>
                </a:ext>
              </a:extLst>
            </p:cNvPr>
            <p:cNvSpPr/>
            <p:nvPr/>
          </p:nvSpPr>
          <p:spPr>
            <a:xfrm rot="1386359">
              <a:off x="5567270" y="7266860"/>
              <a:ext cx="7681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b="1" dirty="0"/>
                <a:t>150 μ</a:t>
              </a:r>
              <a:r>
                <a:rPr lang="nl-BE" b="1" dirty="0"/>
                <a:t>l</a:t>
              </a:r>
            </a:p>
          </p:txBody>
        </p:sp>
      </p:grp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0CC4FE93-3970-4433-815E-AE4026EAF7AC}"/>
              </a:ext>
            </a:extLst>
          </p:cNvPr>
          <p:cNvGrpSpPr/>
          <p:nvPr/>
        </p:nvGrpSpPr>
        <p:grpSpPr>
          <a:xfrm>
            <a:off x="3114241" y="5714014"/>
            <a:ext cx="1280098" cy="2898544"/>
            <a:chOff x="2633511" y="3913368"/>
            <a:chExt cx="1280098" cy="2898544"/>
          </a:xfrm>
        </p:grpSpPr>
        <p:pic>
          <p:nvPicPr>
            <p:cNvPr id="97" name="Graphic 96" descr="Germ with solid fill">
              <a:extLst>
                <a:ext uri="{FF2B5EF4-FFF2-40B4-BE49-F238E27FC236}">
                  <a16:creationId xmlns:a16="http://schemas.microsoft.com/office/drawing/2014/main" id="{2DFD73D5-4A20-4AB0-9527-EE7529B2B3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 rot="13014352">
              <a:off x="3271573" y="3936797"/>
              <a:ext cx="491227" cy="491227"/>
            </a:xfrm>
            <a:prstGeom prst="rect">
              <a:avLst/>
            </a:prstGeom>
          </p:spPr>
        </p:pic>
        <p:pic>
          <p:nvPicPr>
            <p:cNvPr id="99" name="Graphic 98" descr="Germ with solid fill">
              <a:extLst>
                <a:ext uri="{FF2B5EF4-FFF2-40B4-BE49-F238E27FC236}">
                  <a16:creationId xmlns:a16="http://schemas.microsoft.com/office/drawing/2014/main" id="{79842196-3D35-44DF-9D82-CABAD6DA307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 rot="6733061">
              <a:off x="2796858" y="5128795"/>
              <a:ext cx="491227" cy="491227"/>
            </a:xfrm>
            <a:prstGeom prst="rect">
              <a:avLst/>
            </a:prstGeom>
          </p:spPr>
        </p:pic>
        <p:pic>
          <p:nvPicPr>
            <p:cNvPr id="96" name="Graphic 95" descr="Germ with solid fill">
              <a:extLst>
                <a:ext uri="{FF2B5EF4-FFF2-40B4-BE49-F238E27FC236}">
                  <a16:creationId xmlns:a16="http://schemas.microsoft.com/office/drawing/2014/main" id="{B45E8FB4-475B-4FC2-B40F-EBFDAFD59B0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 rot="3092641">
              <a:off x="2815024" y="4150433"/>
              <a:ext cx="703844" cy="703844"/>
            </a:xfrm>
            <a:prstGeom prst="rect">
              <a:avLst/>
            </a:prstGeom>
          </p:spPr>
        </p:pic>
        <p:sp>
          <p:nvSpPr>
            <p:cNvPr id="83" name="Rectangle: Rounded Corners 82">
              <a:extLst>
                <a:ext uri="{FF2B5EF4-FFF2-40B4-BE49-F238E27FC236}">
                  <a16:creationId xmlns:a16="http://schemas.microsoft.com/office/drawing/2014/main" id="{FA42E0A1-7E64-4E2C-9850-F51044996431}"/>
                </a:ext>
              </a:extLst>
            </p:cNvPr>
            <p:cNvSpPr/>
            <p:nvPr/>
          </p:nvSpPr>
          <p:spPr>
            <a:xfrm>
              <a:off x="3335087" y="6370681"/>
              <a:ext cx="308723" cy="330200"/>
            </a:xfrm>
            <a:prstGeom prst="roundRect">
              <a:avLst/>
            </a:prstGeom>
            <a:solidFill>
              <a:srgbClr val="E6E3C4"/>
            </a:solidFill>
            <a:ln>
              <a:solidFill>
                <a:srgbClr val="E6E3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pic>
          <p:nvPicPr>
            <p:cNvPr id="86" name="Graphic 85" descr="Baby bottle">
              <a:extLst>
                <a:ext uri="{FF2B5EF4-FFF2-40B4-BE49-F238E27FC236}">
                  <a16:creationId xmlns:a16="http://schemas.microsoft.com/office/drawing/2014/main" id="{4CB62820-540E-4238-8D82-19611DC9160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3065290" y="5959131"/>
              <a:ext cx="848319" cy="848319"/>
            </a:xfrm>
            <a:prstGeom prst="rect">
              <a:avLst/>
            </a:prstGeom>
          </p:spPr>
        </p:pic>
        <p:pic>
          <p:nvPicPr>
            <p:cNvPr id="81" name="Graphic 80" descr="Baby bottle">
              <a:extLst>
                <a:ext uri="{FF2B5EF4-FFF2-40B4-BE49-F238E27FC236}">
                  <a16:creationId xmlns:a16="http://schemas.microsoft.com/office/drawing/2014/main" id="{C02DC92F-D418-43FD-8F67-E2C4605B71F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2633511" y="5963593"/>
              <a:ext cx="848319" cy="848319"/>
            </a:xfrm>
            <a:prstGeom prst="rect">
              <a:avLst/>
            </a:prstGeom>
          </p:spPr>
        </p:pic>
        <p:pic>
          <p:nvPicPr>
            <p:cNvPr id="88" name="Graphic 87" descr="Germ with solid fill">
              <a:extLst>
                <a:ext uri="{FF2B5EF4-FFF2-40B4-BE49-F238E27FC236}">
                  <a16:creationId xmlns:a16="http://schemas.microsoft.com/office/drawing/2014/main" id="{7D18621C-57B4-4448-8F22-E0E876E54C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p:blipFill>
          <p:spPr>
            <a:xfrm>
              <a:off x="3208222" y="5005263"/>
              <a:ext cx="599383" cy="599383"/>
            </a:xfrm>
            <a:prstGeom prst="rect">
              <a:avLst/>
            </a:prstGeom>
          </p:spPr>
        </p:pic>
        <p:sp>
          <p:nvSpPr>
            <p:cNvPr id="89" name="Oval 88">
              <a:extLst>
                <a:ext uri="{FF2B5EF4-FFF2-40B4-BE49-F238E27FC236}">
                  <a16:creationId xmlns:a16="http://schemas.microsoft.com/office/drawing/2014/main" id="{C3D427E6-4EF1-44E6-9AD1-AE08C3F23C90}"/>
                </a:ext>
              </a:extLst>
            </p:cNvPr>
            <p:cNvSpPr/>
            <p:nvPr/>
          </p:nvSpPr>
          <p:spPr>
            <a:xfrm>
              <a:off x="3029046" y="5356276"/>
              <a:ext cx="279656" cy="88896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dirty="0"/>
            </a:p>
          </p:txBody>
        </p:sp>
        <p:pic>
          <p:nvPicPr>
            <p:cNvPr id="90" name="Graphic 89" descr="Germ with solid fill">
              <a:extLst>
                <a:ext uri="{FF2B5EF4-FFF2-40B4-BE49-F238E27FC236}">
                  <a16:creationId xmlns:a16="http://schemas.microsoft.com/office/drawing/2014/main" id="{61CAFB2E-B604-4208-9532-08A4DE05549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4"/>
                </a:ext>
              </a:extLst>
            </a:blip>
            <a:stretch>
              <a:fillRect/>
            </a:stretch>
          </p:blipFill>
          <p:spPr>
            <a:xfrm rot="10222312">
              <a:off x="3049262" y="4767123"/>
              <a:ext cx="369332" cy="369332"/>
            </a:xfrm>
            <a:prstGeom prst="rect">
              <a:avLst/>
            </a:prstGeom>
          </p:spPr>
        </p:pic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6E7CBED6-9EF0-4DCB-941E-0042F2F5B109}"/>
                </a:ext>
              </a:extLst>
            </p:cNvPr>
            <p:cNvCxnSpPr>
              <a:cxnSpLocks/>
            </p:cNvCxnSpPr>
            <p:nvPr/>
          </p:nvCxnSpPr>
          <p:spPr>
            <a:xfrm>
              <a:off x="3296676" y="3913368"/>
              <a:ext cx="0" cy="145243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Oval 92">
              <a:extLst>
                <a:ext uri="{FF2B5EF4-FFF2-40B4-BE49-F238E27FC236}">
                  <a16:creationId xmlns:a16="http://schemas.microsoft.com/office/drawing/2014/main" id="{291F6AE3-BBE5-4D83-A362-C690FA1FA099}"/>
                </a:ext>
              </a:extLst>
            </p:cNvPr>
            <p:cNvSpPr/>
            <p:nvPr/>
          </p:nvSpPr>
          <p:spPr>
            <a:xfrm>
              <a:off x="3296676" y="5356276"/>
              <a:ext cx="279656" cy="88896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94" name="Rectangle: Rounded Corners 93">
              <a:extLst>
                <a:ext uri="{FF2B5EF4-FFF2-40B4-BE49-F238E27FC236}">
                  <a16:creationId xmlns:a16="http://schemas.microsoft.com/office/drawing/2014/main" id="{A19B322B-A3A3-4708-B86D-3948A336FB64}"/>
                </a:ext>
              </a:extLst>
            </p:cNvPr>
            <p:cNvSpPr/>
            <p:nvPr/>
          </p:nvSpPr>
          <p:spPr>
            <a:xfrm>
              <a:off x="2801097" y="3913368"/>
              <a:ext cx="985924" cy="1729675"/>
            </a:xfrm>
            <a:prstGeom prst="round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104" name="Freeform: Shape 103">
              <a:extLst>
                <a:ext uri="{FF2B5EF4-FFF2-40B4-BE49-F238E27FC236}">
                  <a16:creationId xmlns:a16="http://schemas.microsoft.com/office/drawing/2014/main" id="{5A960315-7EB0-4720-81B2-561388748840}"/>
                </a:ext>
              </a:extLst>
            </p:cNvPr>
            <p:cNvSpPr/>
            <p:nvPr/>
          </p:nvSpPr>
          <p:spPr>
            <a:xfrm>
              <a:off x="2991461" y="5640705"/>
              <a:ext cx="163447" cy="396240"/>
            </a:xfrm>
            <a:custGeom>
              <a:avLst/>
              <a:gdLst>
                <a:gd name="connsiteX0" fmla="*/ 71779 w 163447"/>
                <a:gd name="connsiteY0" fmla="*/ 396240 h 396240"/>
                <a:gd name="connsiteX1" fmla="*/ 3199 w 163447"/>
                <a:gd name="connsiteY1" fmla="*/ 236220 h 396240"/>
                <a:gd name="connsiteX2" fmla="*/ 163219 w 163447"/>
                <a:gd name="connsiteY2" fmla="*/ 152400 h 396240"/>
                <a:gd name="connsiteX3" fmla="*/ 41299 w 163447"/>
                <a:gd name="connsiteY3" fmla="*/ 0 h 396240"/>
                <a:gd name="connsiteX4" fmla="*/ 41299 w 163447"/>
                <a:gd name="connsiteY4" fmla="*/ 0 h 396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3447" h="396240">
                  <a:moveTo>
                    <a:pt x="71779" y="396240"/>
                  </a:moveTo>
                  <a:cubicBezTo>
                    <a:pt x="29869" y="336550"/>
                    <a:pt x="-12041" y="276860"/>
                    <a:pt x="3199" y="236220"/>
                  </a:cubicBezTo>
                  <a:cubicBezTo>
                    <a:pt x="18439" y="195580"/>
                    <a:pt x="156869" y="191770"/>
                    <a:pt x="163219" y="152400"/>
                  </a:cubicBezTo>
                  <a:cubicBezTo>
                    <a:pt x="169569" y="113030"/>
                    <a:pt x="41299" y="0"/>
                    <a:pt x="41299" y="0"/>
                  </a:cubicBezTo>
                  <a:lnTo>
                    <a:pt x="41299" y="0"/>
                  </a:lnTo>
                </a:path>
              </a:pathLst>
            </a:cu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105" name="Freeform: Shape 104">
              <a:extLst>
                <a:ext uri="{FF2B5EF4-FFF2-40B4-BE49-F238E27FC236}">
                  <a16:creationId xmlns:a16="http://schemas.microsoft.com/office/drawing/2014/main" id="{E538FA0F-AF2D-4C6A-AAF3-678873D9F976}"/>
                </a:ext>
              </a:extLst>
            </p:cNvPr>
            <p:cNvSpPr/>
            <p:nvPr/>
          </p:nvSpPr>
          <p:spPr>
            <a:xfrm>
              <a:off x="3352800" y="5648325"/>
              <a:ext cx="210001" cy="419100"/>
            </a:xfrm>
            <a:custGeom>
              <a:avLst/>
              <a:gdLst>
                <a:gd name="connsiteX0" fmla="*/ 104775 w 210001"/>
                <a:gd name="connsiteY0" fmla="*/ 419100 h 419100"/>
                <a:gd name="connsiteX1" fmla="*/ 180975 w 210001"/>
                <a:gd name="connsiteY1" fmla="*/ 304800 h 419100"/>
                <a:gd name="connsiteX2" fmla="*/ 0 w 210001"/>
                <a:gd name="connsiteY2" fmla="*/ 219075 h 419100"/>
                <a:gd name="connsiteX3" fmla="*/ 180975 w 210001"/>
                <a:gd name="connsiteY3" fmla="*/ 152400 h 419100"/>
                <a:gd name="connsiteX4" fmla="*/ 209550 w 210001"/>
                <a:gd name="connsiteY4" fmla="*/ 0 h 419100"/>
                <a:gd name="connsiteX5" fmla="*/ 209550 w 210001"/>
                <a:gd name="connsiteY5" fmla="*/ 0 h 4191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210001" h="419100">
                  <a:moveTo>
                    <a:pt x="104775" y="419100"/>
                  </a:moveTo>
                  <a:cubicBezTo>
                    <a:pt x="151606" y="378618"/>
                    <a:pt x="198437" y="338137"/>
                    <a:pt x="180975" y="304800"/>
                  </a:cubicBezTo>
                  <a:cubicBezTo>
                    <a:pt x="163513" y="271463"/>
                    <a:pt x="0" y="244475"/>
                    <a:pt x="0" y="219075"/>
                  </a:cubicBezTo>
                  <a:cubicBezTo>
                    <a:pt x="0" y="193675"/>
                    <a:pt x="146050" y="188912"/>
                    <a:pt x="180975" y="152400"/>
                  </a:cubicBezTo>
                  <a:cubicBezTo>
                    <a:pt x="215900" y="115888"/>
                    <a:pt x="209550" y="0"/>
                    <a:pt x="209550" y="0"/>
                  </a:cubicBezTo>
                  <a:lnTo>
                    <a:pt x="209550" y="0"/>
                  </a:lnTo>
                </a:path>
              </a:pathLst>
            </a:cu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nl-BE">
                <a:solidFill>
                  <a:schemeClr val="tx1"/>
                </a:solidFill>
              </a:endParaRPr>
            </a:p>
          </p:txBody>
        </p: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86AE205F-11D7-4A43-8BC0-D0B224A3F741}"/>
              </a:ext>
            </a:extLst>
          </p:cNvPr>
          <p:cNvGrpSpPr/>
          <p:nvPr/>
        </p:nvGrpSpPr>
        <p:grpSpPr>
          <a:xfrm>
            <a:off x="1349449" y="5717347"/>
            <a:ext cx="1010747" cy="1729675"/>
            <a:chOff x="7046152" y="4423187"/>
            <a:chExt cx="1010747" cy="1729675"/>
          </a:xfrm>
        </p:grpSpPr>
        <p:pic>
          <p:nvPicPr>
            <p:cNvPr id="119" name="Graphic 118" descr="Germ with solid fill">
              <a:extLst>
                <a:ext uri="{FF2B5EF4-FFF2-40B4-BE49-F238E27FC236}">
                  <a16:creationId xmlns:a16="http://schemas.microsoft.com/office/drawing/2014/main" id="{B07411FA-4B25-4D83-B03D-9613CED0B4C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 rot="13014352">
              <a:off x="7520867" y="4446616"/>
              <a:ext cx="491227" cy="491227"/>
            </a:xfrm>
            <a:prstGeom prst="rect">
              <a:avLst/>
            </a:prstGeom>
          </p:spPr>
        </p:pic>
        <p:pic>
          <p:nvPicPr>
            <p:cNvPr id="118" name="Graphic 117" descr="Germ with solid fill">
              <a:extLst>
                <a:ext uri="{FF2B5EF4-FFF2-40B4-BE49-F238E27FC236}">
                  <a16:creationId xmlns:a16="http://schemas.microsoft.com/office/drawing/2014/main" id="{F87691F0-3009-43D1-89E1-D06D623947B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 rot="3092641">
              <a:off x="7064318" y="4660252"/>
              <a:ext cx="703844" cy="703844"/>
            </a:xfrm>
            <a:prstGeom prst="rect">
              <a:avLst/>
            </a:prstGeom>
          </p:spPr>
        </p:pic>
        <p:pic>
          <p:nvPicPr>
            <p:cNvPr id="121" name="Graphic 120" descr="Germ with solid fill">
              <a:extLst>
                <a:ext uri="{FF2B5EF4-FFF2-40B4-BE49-F238E27FC236}">
                  <a16:creationId xmlns:a16="http://schemas.microsoft.com/office/drawing/2014/main" id="{38E1AABA-0824-425E-B84A-2734C7CB61C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 rot="6733061">
              <a:off x="7046152" y="5638614"/>
              <a:ext cx="491227" cy="491227"/>
            </a:xfrm>
            <a:prstGeom prst="rect">
              <a:avLst/>
            </a:prstGeom>
          </p:spPr>
        </p:pic>
        <p:pic>
          <p:nvPicPr>
            <p:cNvPr id="110" name="Graphic 109" descr="Germ with solid fill">
              <a:extLst>
                <a:ext uri="{FF2B5EF4-FFF2-40B4-BE49-F238E27FC236}">
                  <a16:creationId xmlns:a16="http://schemas.microsoft.com/office/drawing/2014/main" id="{0DA2EF73-892B-4E18-B483-C8DCD2A7F9A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p:blipFill>
          <p:spPr>
            <a:xfrm>
              <a:off x="7457516" y="5515082"/>
              <a:ext cx="599383" cy="599383"/>
            </a:xfrm>
            <a:prstGeom prst="rect">
              <a:avLst/>
            </a:prstGeom>
          </p:spPr>
        </p:pic>
        <p:sp>
          <p:nvSpPr>
            <p:cNvPr id="111" name="Oval 110">
              <a:extLst>
                <a:ext uri="{FF2B5EF4-FFF2-40B4-BE49-F238E27FC236}">
                  <a16:creationId xmlns:a16="http://schemas.microsoft.com/office/drawing/2014/main" id="{9F71BB1B-A0E9-413B-BF4E-143816ADD49B}"/>
                </a:ext>
              </a:extLst>
            </p:cNvPr>
            <p:cNvSpPr/>
            <p:nvPr/>
          </p:nvSpPr>
          <p:spPr>
            <a:xfrm>
              <a:off x="7278340" y="5866095"/>
              <a:ext cx="279656" cy="88896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dirty="0"/>
            </a:p>
          </p:txBody>
        </p:sp>
        <p:pic>
          <p:nvPicPr>
            <p:cNvPr id="112" name="Graphic 111" descr="Germ with solid fill">
              <a:extLst>
                <a:ext uri="{FF2B5EF4-FFF2-40B4-BE49-F238E27FC236}">
                  <a16:creationId xmlns:a16="http://schemas.microsoft.com/office/drawing/2014/main" id="{FE6AE104-BEEB-48CA-A67B-85C45F5FC28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4"/>
                </a:ext>
              </a:extLst>
            </a:blip>
            <a:stretch>
              <a:fillRect/>
            </a:stretch>
          </p:blipFill>
          <p:spPr>
            <a:xfrm rot="10222312">
              <a:off x="7298556" y="5276942"/>
              <a:ext cx="369332" cy="369332"/>
            </a:xfrm>
            <a:prstGeom prst="rect">
              <a:avLst/>
            </a:prstGeom>
          </p:spPr>
        </p:pic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37380734-B4DE-4E29-B675-9CAAF2CD9C3D}"/>
                </a:ext>
              </a:extLst>
            </p:cNvPr>
            <p:cNvCxnSpPr>
              <a:cxnSpLocks/>
            </p:cNvCxnSpPr>
            <p:nvPr/>
          </p:nvCxnSpPr>
          <p:spPr>
            <a:xfrm>
              <a:off x="7545970" y="4423187"/>
              <a:ext cx="0" cy="145243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Oval 114">
              <a:extLst>
                <a:ext uri="{FF2B5EF4-FFF2-40B4-BE49-F238E27FC236}">
                  <a16:creationId xmlns:a16="http://schemas.microsoft.com/office/drawing/2014/main" id="{5FBB425F-1672-47B5-BDEE-0DE284F5F045}"/>
                </a:ext>
              </a:extLst>
            </p:cNvPr>
            <p:cNvSpPr/>
            <p:nvPr/>
          </p:nvSpPr>
          <p:spPr>
            <a:xfrm>
              <a:off x="7545970" y="5866095"/>
              <a:ext cx="279656" cy="88896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116" name="Rectangle: Rounded Corners 115">
              <a:extLst>
                <a:ext uri="{FF2B5EF4-FFF2-40B4-BE49-F238E27FC236}">
                  <a16:creationId xmlns:a16="http://schemas.microsoft.com/office/drawing/2014/main" id="{DE9286DC-3EF4-4A28-B07A-4EBEB5A54FCA}"/>
                </a:ext>
              </a:extLst>
            </p:cNvPr>
            <p:cNvSpPr/>
            <p:nvPr/>
          </p:nvSpPr>
          <p:spPr>
            <a:xfrm>
              <a:off x="7050391" y="4423187"/>
              <a:ext cx="985924" cy="1729675"/>
            </a:xfrm>
            <a:prstGeom prst="round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</p:grpSp>
      <p:sp>
        <p:nvSpPr>
          <p:cNvPr id="122" name="Arrow: Right 121">
            <a:extLst>
              <a:ext uri="{FF2B5EF4-FFF2-40B4-BE49-F238E27FC236}">
                <a16:creationId xmlns:a16="http://schemas.microsoft.com/office/drawing/2014/main" id="{5413616F-E2CC-4947-9DF3-2C62C58B5A28}"/>
              </a:ext>
            </a:extLst>
          </p:cNvPr>
          <p:cNvSpPr/>
          <p:nvPr/>
        </p:nvSpPr>
        <p:spPr>
          <a:xfrm>
            <a:off x="2599684" y="6390353"/>
            <a:ext cx="336500" cy="310412"/>
          </a:xfrm>
          <a:prstGeom prst="rightArrow">
            <a:avLst/>
          </a:prstGeom>
          <a:solidFill>
            <a:srgbClr val="B4C7E7"/>
          </a:solidFill>
          <a:ln>
            <a:solidFill>
              <a:srgbClr val="B4C7E7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dirty="0">
              <a:solidFill>
                <a:schemeClr val="accent5"/>
              </a:solidFill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D3C486DB-D101-49F9-B1FB-64BD4F7BA0E5}"/>
              </a:ext>
            </a:extLst>
          </p:cNvPr>
          <p:cNvSpPr txBox="1"/>
          <p:nvPr/>
        </p:nvSpPr>
        <p:spPr>
          <a:xfrm>
            <a:off x="2349771" y="6136860"/>
            <a:ext cx="8195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1"/>
                </a:solidFill>
              </a:rPr>
              <a:t>12 hours</a:t>
            </a:r>
            <a:endParaRPr lang="nl-BE" sz="1400" dirty="0">
              <a:solidFill>
                <a:schemeClr val="accent1"/>
              </a:solidFill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35840C40-C656-474E-9E21-2DD4B48A739C}"/>
              </a:ext>
            </a:extLst>
          </p:cNvPr>
          <p:cNvSpPr txBox="1"/>
          <p:nvPr/>
        </p:nvSpPr>
        <p:spPr>
          <a:xfrm>
            <a:off x="4022846" y="8005535"/>
            <a:ext cx="13362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+ Feed</a:t>
            </a:r>
          </a:p>
          <a:p>
            <a:pPr algn="ctr"/>
            <a:r>
              <a:rPr lang="en-US" sz="1400" dirty="0"/>
              <a:t>10 ml/24h</a:t>
            </a:r>
            <a:endParaRPr lang="nl-BE" sz="14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5D68EFE8-CD57-494C-89AB-0ADB4954AA2F}"/>
              </a:ext>
            </a:extLst>
          </p:cNvPr>
          <p:cNvSpPr txBox="1"/>
          <p:nvPr/>
        </p:nvSpPr>
        <p:spPr>
          <a:xfrm>
            <a:off x="280659" y="7871309"/>
            <a:ext cx="116681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Automatic base addition</a:t>
            </a:r>
          </a:p>
          <a:p>
            <a:pPr algn="ctr"/>
            <a:r>
              <a:rPr lang="en-US" sz="1400" dirty="0"/>
              <a:t>to pH 6.5</a:t>
            </a:r>
            <a:endParaRPr lang="nl-BE" sz="1400" dirty="0"/>
          </a:p>
        </p:txBody>
      </p:sp>
      <p:pic>
        <p:nvPicPr>
          <p:cNvPr id="128" name="Graphic 127" descr="Baby bottle">
            <a:extLst>
              <a:ext uri="{FF2B5EF4-FFF2-40B4-BE49-F238E27FC236}">
                <a16:creationId xmlns:a16="http://schemas.microsoft.com/office/drawing/2014/main" id="{846CDCC7-D953-40EB-9B95-C86C5AA9975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196290" y="7788158"/>
            <a:ext cx="848319" cy="848319"/>
          </a:xfrm>
          <a:prstGeom prst="rect">
            <a:avLst/>
          </a:prstGeom>
        </p:spPr>
      </p:pic>
      <p:sp>
        <p:nvSpPr>
          <p:cNvPr id="129" name="Freeform: Shape 128">
            <a:extLst>
              <a:ext uri="{FF2B5EF4-FFF2-40B4-BE49-F238E27FC236}">
                <a16:creationId xmlns:a16="http://schemas.microsoft.com/office/drawing/2014/main" id="{4C6921E0-EB2C-4F67-B1B7-75618065176D}"/>
              </a:ext>
            </a:extLst>
          </p:cNvPr>
          <p:cNvSpPr/>
          <p:nvPr/>
        </p:nvSpPr>
        <p:spPr>
          <a:xfrm>
            <a:off x="1554240" y="7465270"/>
            <a:ext cx="163447" cy="396240"/>
          </a:xfrm>
          <a:custGeom>
            <a:avLst/>
            <a:gdLst>
              <a:gd name="connsiteX0" fmla="*/ 71779 w 163447"/>
              <a:gd name="connsiteY0" fmla="*/ 396240 h 396240"/>
              <a:gd name="connsiteX1" fmla="*/ 3199 w 163447"/>
              <a:gd name="connsiteY1" fmla="*/ 236220 h 396240"/>
              <a:gd name="connsiteX2" fmla="*/ 163219 w 163447"/>
              <a:gd name="connsiteY2" fmla="*/ 152400 h 396240"/>
              <a:gd name="connsiteX3" fmla="*/ 41299 w 163447"/>
              <a:gd name="connsiteY3" fmla="*/ 0 h 396240"/>
              <a:gd name="connsiteX4" fmla="*/ 41299 w 163447"/>
              <a:gd name="connsiteY4" fmla="*/ 0 h 3962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63447" h="396240">
                <a:moveTo>
                  <a:pt x="71779" y="396240"/>
                </a:moveTo>
                <a:cubicBezTo>
                  <a:pt x="29869" y="336550"/>
                  <a:pt x="-12041" y="276860"/>
                  <a:pt x="3199" y="236220"/>
                </a:cubicBezTo>
                <a:cubicBezTo>
                  <a:pt x="18439" y="195580"/>
                  <a:pt x="156869" y="191770"/>
                  <a:pt x="163219" y="152400"/>
                </a:cubicBezTo>
                <a:cubicBezTo>
                  <a:pt x="169569" y="113030"/>
                  <a:pt x="41299" y="0"/>
                  <a:pt x="41299" y="0"/>
                </a:cubicBezTo>
                <a:lnTo>
                  <a:pt x="41299" y="0"/>
                </a:lnTo>
              </a:path>
            </a:pathLst>
          </a:cu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130" name="Arrow: Right 129">
            <a:extLst>
              <a:ext uri="{FF2B5EF4-FFF2-40B4-BE49-F238E27FC236}">
                <a16:creationId xmlns:a16="http://schemas.microsoft.com/office/drawing/2014/main" id="{479C2F0E-6F0F-479B-87F5-AD795C0C96E4}"/>
              </a:ext>
            </a:extLst>
          </p:cNvPr>
          <p:cNvSpPr/>
          <p:nvPr/>
        </p:nvSpPr>
        <p:spPr>
          <a:xfrm>
            <a:off x="4585927" y="6570904"/>
            <a:ext cx="569596" cy="23329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dirty="0"/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C9D04F8E-A854-4689-8349-DC8155FAD4A2}"/>
              </a:ext>
            </a:extLst>
          </p:cNvPr>
          <p:cNvGrpSpPr/>
          <p:nvPr/>
        </p:nvGrpSpPr>
        <p:grpSpPr>
          <a:xfrm>
            <a:off x="5517582" y="2577405"/>
            <a:ext cx="5516127" cy="1679665"/>
            <a:chOff x="6401774" y="2412134"/>
            <a:chExt cx="5516127" cy="1679665"/>
          </a:xfrm>
        </p:grpSpPr>
        <p:sp>
          <p:nvSpPr>
            <p:cNvPr id="34" name="Arrow: Down 33">
              <a:extLst>
                <a:ext uri="{FF2B5EF4-FFF2-40B4-BE49-F238E27FC236}">
                  <a16:creationId xmlns:a16="http://schemas.microsoft.com/office/drawing/2014/main" id="{29EA6E6E-F8F1-45A3-A405-B8D4000B674E}"/>
                </a:ext>
              </a:extLst>
            </p:cNvPr>
            <p:cNvSpPr/>
            <p:nvPr/>
          </p:nvSpPr>
          <p:spPr>
            <a:xfrm>
              <a:off x="7279712" y="2464436"/>
              <a:ext cx="382096" cy="797936"/>
            </a:xfrm>
            <a:prstGeom prst="downArrow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accent1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16" name="Arrow: Right 15">
              <a:extLst>
                <a:ext uri="{FF2B5EF4-FFF2-40B4-BE49-F238E27FC236}">
                  <a16:creationId xmlns:a16="http://schemas.microsoft.com/office/drawing/2014/main" id="{3052D6CF-7542-46C2-B13D-0512A856C5D0}"/>
                </a:ext>
              </a:extLst>
            </p:cNvPr>
            <p:cNvSpPr/>
            <p:nvPr/>
          </p:nvSpPr>
          <p:spPr>
            <a:xfrm>
              <a:off x="6970168" y="3164538"/>
              <a:ext cx="3534004" cy="543450"/>
            </a:xfrm>
            <a:prstGeom prst="rightArrow">
              <a:avLst/>
            </a:prstGeom>
            <a:gradFill flip="none" rotWithShape="1">
              <a:gsLst>
                <a:gs pos="0">
                  <a:schemeClr val="bg1">
                    <a:shade val="30000"/>
                    <a:satMod val="115000"/>
                  </a:schemeClr>
                </a:gs>
                <a:gs pos="50000">
                  <a:schemeClr val="bg1">
                    <a:shade val="67500"/>
                    <a:satMod val="115000"/>
                  </a:schemeClr>
                </a:gs>
                <a:gs pos="100000">
                  <a:schemeClr val="bg1">
                    <a:shade val="100000"/>
                    <a:satMod val="115000"/>
                  </a:schemeClr>
                </a:gs>
              </a:gsLst>
              <a:lin ang="10800000" scaled="1"/>
              <a:tileRect/>
            </a:gradFill>
            <a:ln w="285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dirty="0"/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7D6CBEC7-9E2E-42BE-BC6C-7092AF2C5C69}"/>
                </a:ext>
              </a:extLst>
            </p:cNvPr>
            <p:cNvSpPr txBox="1"/>
            <p:nvPr/>
          </p:nvSpPr>
          <p:spPr>
            <a:xfrm>
              <a:off x="9823470" y="3722467"/>
              <a:ext cx="464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67</a:t>
              </a:r>
              <a:endParaRPr lang="nl-BE" dirty="0"/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3D67E435-A773-4ECE-867C-53FE79E3F3EE}"/>
                </a:ext>
              </a:extLst>
            </p:cNvPr>
            <p:cNvSpPr txBox="1"/>
            <p:nvPr/>
          </p:nvSpPr>
          <p:spPr>
            <a:xfrm>
              <a:off x="8789435" y="3722467"/>
              <a:ext cx="464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49</a:t>
              </a:r>
              <a:endParaRPr lang="nl-BE" dirty="0"/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81EC2293-6AF8-42CF-A298-130D276C4831}"/>
                </a:ext>
              </a:extLst>
            </p:cNvPr>
            <p:cNvSpPr txBox="1"/>
            <p:nvPr/>
          </p:nvSpPr>
          <p:spPr>
            <a:xfrm>
              <a:off x="8272418" y="3722467"/>
              <a:ext cx="464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37</a:t>
              </a:r>
              <a:endParaRPr lang="nl-BE" dirty="0"/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8A4DDC0B-C3C6-4CAD-A5AF-E4DD6E5403AE}"/>
                </a:ext>
              </a:extLst>
            </p:cNvPr>
            <p:cNvSpPr txBox="1"/>
            <p:nvPr/>
          </p:nvSpPr>
          <p:spPr>
            <a:xfrm>
              <a:off x="9306452" y="3722467"/>
              <a:ext cx="464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61</a:t>
              </a:r>
              <a:endParaRPr lang="nl-BE" dirty="0"/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3784699B-6FCB-4650-82AF-4419B958658D}"/>
                </a:ext>
              </a:extLst>
            </p:cNvPr>
            <p:cNvSpPr txBox="1"/>
            <p:nvPr/>
          </p:nvSpPr>
          <p:spPr>
            <a:xfrm>
              <a:off x="6892015" y="3722467"/>
              <a:ext cx="2941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0</a:t>
              </a:r>
              <a:endParaRPr lang="nl-BE" dirty="0"/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8FDC3526-600D-4FC5-B531-C974BD2F587E}"/>
                </a:ext>
              </a:extLst>
            </p:cNvPr>
            <p:cNvSpPr txBox="1"/>
            <p:nvPr/>
          </p:nvSpPr>
          <p:spPr>
            <a:xfrm>
              <a:off x="7238384" y="3722467"/>
              <a:ext cx="464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12</a:t>
              </a:r>
              <a:endParaRPr lang="nl-BE" dirty="0"/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BEBE4EEA-6557-4BA1-9307-221C4B9A13DE}"/>
                </a:ext>
              </a:extLst>
            </p:cNvPr>
            <p:cNvSpPr txBox="1"/>
            <p:nvPr/>
          </p:nvSpPr>
          <p:spPr>
            <a:xfrm>
              <a:off x="7755401" y="3722467"/>
              <a:ext cx="464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25</a:t>
              </a:r>
              <a:endParaRPr lang="nl-BE" dirty="0"/>
            </a:p>
          </p:txBody>
        </p:sp>
        <p:cxnSp>
          <p:nvCxnSpPr>
            <p:cNvPr id="250" name="Straight Arrow Connector 249">
              <a:extLst>
                <a:ext uri="{FF2B5EF4-FFF2-40B4-BE49-F238E27FC236}">
                  <a16:creationId xmlns:a16="http://schemas.microsoft.com/office/drawing/2014/main" id="{D07BF20A-5878-411B-A12A-F52CD83D321E}"/>
                </a:ext>
              </a:extLst>
            </p:cNvPr>
            <p:cNvCxnSpPr/>
            <p:nvPr/>
          </p:nvCxnSpPr>
          <p:spPr>
            <a:xfrm>
              <a:off x="10055846" y="2877996"/>
              <a:ext cx="0" cy="30747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Straight Arrow Connector 250">
              <a:extLst>
                <a:ext uri="{FF2B5EF4-FFF2-40B4-BE49-F238E27FC236}">
                  <a16:creationId xmlns:a16="http://schemas.microsoft.com/office/drawing/2014/main" id="{3382CF38-DDA9-489D-889C-945213364538}"/>
                </a:ext>
              </a:extLst>
            </p:cNvPr>
            <p:cNvCxnSpPr/>
            <p:nvPr/>
          </p:nvCxnSpPr>
          <p:spPr>
            <a:xfrm>
              <a:off x="7987777" y="2877996"/>
              <a:ext cx="0" cy="30747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Straight Arrow Connector 251">
              <a:extLst>
                <a:ext uri="{FF2B5EF4-FFF2-40B4-BE49-F238E27FC236}">
                  <a16:creationId xmlns:a16="http://schemas.microsoft.com/office/drawing/2014/main" id="{BC955C5E-7A79-4A5F-B52F-4BCE8BE6C6B1}"/>
                </a:ext>
              </a:extLst>
            </p:cNvPr>
            <p:cNvCxnSpPr/>
            <p:nvPr/>
          </p:nvCxnSpPr>
          <p:spPr>
            <a:xfrm>
              <a:off x="8504794" y="2877996"/>
              <a:ext cx="0" cy="30747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Straight Arrow Connector 252">
              <a:extLst>
                <a:ext uri="{FF2B5EF4-FFF2-40B4-BE49-F238E27FC236}">
                  <a16:creationId xmlns:a16="http://schemas.microsoft.com/office/drawing/2014/main" id="{ED1573AF-507D-470E-B421-9769A72FBF51}"/>
                </a:ext>
              </a:extLst>
            </p:cNvPr>
            <p:cNvCxnSpPr/>
            <p:nvPr/>
          </p:nvCxnSpPr>
          <p:spPr>
            <a:xfrm>
              <a:off x="9021811" y="2877996"/>
              <a:ext cx="0" cy="30747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Straight Arrow Connector 253">
              <a:extLst>
                <a:ext uri="{FF2B5EF4-FFF2-40B4-BE49-F238E27FC236}">
                  <a16:creationId xmlns:a16="http://schemas.microsoft.com/office/drawing/2014/main" id="{9740996E-02A5-4ACE-A4D6-B9C62114D0DA}"/>
                </a:ext>
              </a:extLst>
            </p:cNvPr>
            <p:cNvCxnSpPr/>
            <p:nvPr/>
          </p:nvCxnSpPr>
          <p:spPr>
            <a:xfrm>
              <a:off x="9538828" y="2877996"/>
              <a:ext cx="0" cy="30747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CDB181C-0F87-4171-92F9-5462FA4F5B76}"/>
                </a:ext>
              </a:extLst>
            </p:cNvPr>
            <p:cNvSpPr txBox="1"/>
            <p:nvPr/>
          </p:nvSpPr>
          <p:spPr>
            <a:xfrm>
              <a:off x="6401774" y="2412134"/>
              <a:ext cx="102612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solidFill>
                    <a:schemeClr val="accent1"/>
                  </a:solidFill>
                </a:rPr>
                <a:t>Switch to chemostat</a:t>
              </a:r>
              <a:endParaRPr lang="nl-BE" sz="1400" dirty="0">
                <a:solidFill>
                  <a:schemeClr val="accent1"/>
                </a:solidFill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0A4C8DD-DAF2-4AD9-96D2-3210B015814B}"/>
                </a:ext>
              </a:extLst>
            </p:cNvPr>
            <p:cNvSpPr txBox="1"/>
            <p:nvPr/>
          </p:nvSpPr>
          <p:spPr>
            <a:xfrm>
              <a:off x="7858407" y="2495813"/>
              <a:ext cx="18620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Sampling</a:t>
              </a:r>
              <a:endParaRPr lang="nl-BE" dirty="0"/>
            </a:p>
          </p:txBody>
        </p:sp>
        <p:cxnSp>
          <p:nvCxnSpPr>
            <p:cNvPr id="255" name="Straight Arrow Connector 254">
              <a:extLst>
                <a:ext uri="{FF2B5EF4-FFF2-40B4-BE49-F238E27FC236}">
                  <a16:creationId xmlns:a16="http://schemas.microsoft.com/office/drawing/2014/main" id="{1703190B-F73A-4268-AD59-51E9B5DFDBA9}"/>
                </a:ext>
              </a:extLst>
            </p:cNvPr>
            <p:cNvCxnSpPr/>
            <p:nvPr/>
          </p:nvCxnSpPr>
          <p:spPr>
            <a:xfrm>
              <a:off x="7470760" y="2874147"/>
              <a:ext cx="0" cy="30747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B327D34A-41EB-4AC7-8B84-9568FCE2918D}"/>
                </a:ext>
              </a:extLst>
            </p:cNvPr>
            <p:cNvSpPr txBox="1"/>
            <p:nvPr/>
          </p:nvSpPr>
          <p:spPr>
            <a:xfrm>
              <a:off x="10055846" y="3517654"/>
              <a:ext cx="18620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Time in hours</a:t>
              </a:r>
              <a:endParaRPr lang="nl-BE" sz="1400" dirty="0"/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425D169B-69FD-4EE3-9242-9AA7D2387FE2}"/>
              </a:ext>
            </a:extLst>
          </p:cNvPr>
          <p:cNvGrpSpPr/>
          <p:nvPr/>
        </p:nvGrpSpPr>
        <p:grpSpPr>
          <a:xfrm>
            <a:off x="649845" y="703959"/>
            <a:ext cx="5340607" cy="3798968"/>
            <a:chOff x="55343" y="727596"/>
            <a:chExt cx="5340607" cy="3798968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5315E7A-5E66-4820-8EC7-3CEB4E135D6E}"/>
                </a:ext>
              </a:extLst>
            </p:cNvPr>
            <p:cNvSpPr txBox="1"/>
            <p:nvPr/>
          </p:nvSpPr>
          <p:spPr>
            <a:xfrm>
              <a:off x="3768311" y="3594599"/>
              <a:ext cx="16276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6x</a:t>
              </a:r>
              <a:endParaRPr lang="nl-BE" sz="2400" dirty="0"/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14982C3C-BE9F-4E00-B1EC-E990750A6568}"/>
                </a:ext>
              </a:extLst>
            </p:cNvPr>
            <p:cNvGrpSpPr/>
            <p:nvPr/>
          </p:nvGrpSpPr>
          <p:grpSpPr>
            <a:xfrm>
              <a:off x="55343" y="727596"/>
              <a:ext cx="3796664" cy="3798968"/>
              <a:chOff x="55343" y="727596"/>
              <a:chExt cx="3796664" cy="3798968"/>
            </a:xfrm>
          </p:grpSpPr>
          <p:sp>
            <p:nvSpPr>
              <p:cNvPr id="135" name="Rectangle: Rounded Corners 134">
                <a:extLst>
                  <a:ext uri="{FF2B5EF4-FFF2-40B4-BE49-F238E27FC236}">
                    <a16:creationId xmlns:a16="http://schemas.microsoft.com/office/drawing/2014/main" id="{740C6E6E-6CDF-49A4-9E8E-968B6AA52337}"/>
                  </a:ext>
                </a:extLst>
              </p:cNvPr>
              <p:cNvSpPr/>
              <p:nvPr/>
            </p:nvSpPr>
            <p:spPr>
              <a:xfrm>
                <a:off x="2667199" y="805938"/>
                <a:ext cx="805582" cy="1413288"/>
              </a:xfrm>
              <a:prstGeom prst="roundRect">
                <a:avLst/>
              </a:prstGeom>
              <a:solidFill>
                <a:schemeClr val="bg1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nl-BE"/>
              </a:p>
            </p:txBody>
          </p: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739681EA-4130-4CDE-8779-442CB221996F}"/>
                  </a:ext>
                </a:extLst>
              </p:cNvPr>
              <p:cNvGrpSpPr/>
              <p:nvPr/>
            </p:nvGrpSpPr>
            <p:grpSpPr>
              <a:xfrm>
                <a:off x="2248524" y="1076764"/>
                <a:ext cx="805581" cy="1413288"/>
                <a:chOff x="2248524" y="1076764"/>
                <a:chExt cx="805581" cy="1413288"/>
              </a:xfrm>
            </p:grpSpPr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0E948318-3CE2-4838-94A2-C83C4ABE9840}"/>
                    </a:ext>
                  </a:extLst>
                </p:cNvPr>
                <p:cNvGrpSpPr/>
                <p:nvPr/>
              </p:nvGrpSpPr>
              <p:grpSpPr>
                <a:xfrm>
                  <a:off x="2248524" y="1076764"/>
                  <a:ext cx="805581" cy="1413288"/>
                  <a:chOff x="7050391" y="4423187"/>
                  <a:chExt cx="985924" cy="1729675"/>
                </a:xfrm>
              </p:grpSpPr>
              <p:sp>
                <p:nvSpPr>
                  <p:cNvPr id="126" name="Rectangle: Rounded Corners 125">
                    <a:extLst>
                      <a:ext uri="{FF2B5EF4-FFF2-40B4-BE49-F238E27FC236}">
                        <a16:creationId xmlns:a16="http://schemas.microsoft.com/office/drawing/2014/main" id="{CC03F807-21AB-40FE-A691-9B43B28B120C}"/>
                      </a:ext>
                    </a:extLst>
                  </p:cNvPr>
                  <p:cNvSpPr/>
                  <p:nvPr/>
                </p:nvSpPr>
                <p:spPr>
                  <a:xfrm>
                    <a:off x="7050391" y="4423187"/>
                    <a:ext cx="985924" cy="172967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381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1">
                    <a:schemeClr val="lt1"/>
                  </a:fillRef>
                  <a:effectRef idx="0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124" name="Rectangle: Rounded Corners 123">
                    <a:extLst>
                      <a:ext uri="{FF2B5EF4-FFF2-40B4-BE49-F238E27FC236}">
                        <a16:creationId xmlns:a16="http://schemas.microsoft.com/office/drawing/2014/main" id="{840EB286-7D7E-48B5-B272-326D38C3AB70}"/>
                      </a:ext>
                    </a:extLst>
                  </p:cNvPr>
                  <p:cNvSpPr/>
                  <p:nvPr/>
                </p:nvSpPr>
                <p:spPr>
                  <a:xfrm>
                    <a:off x="7252862" y="5829791"/>
                    <a:ext cx="7171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127" name="Rectangle: Rounded Corners 126">
                    <a:extLst>
                      <a:ext uri="{FF2B5EF4-FFF2-40B4-BE49-F238E27FC236}">
                        <a16:creationId xmlns:a16="http://schemas.microsoft.com/office/drawing/2014/main" id="{EFEE2BD9-B591-4423-8C43-A76B5967CD51}"/>
                      </a:ext>
                    </a:extLst>
                  </p:cNvPr>
                  <p:cNvSpPr/>
                  <p:nvPr/>
                </p:nvSpPr>
                <p:spPr>
                  <a:xfrm>
                    <a:off x="7484474" y="4917696"/>
                    <a:ext cx="12652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pic>
                <p:nvPicPr>
                  <p:cNvPr id="132" name="Graphic 131" descr="Germ with solid fill">
                    <a:extLst>
                      <a:ext uri="{FF2B5EF4-FFF2-40B4-BE49-F238E27FC236}">
                        <a16:creationId xmlns:a16="http://schemas.microsoft.com/office/drawing/2014/main" id="{B8F02FFF-D5F6-4F0A-9D42-149ECAA67A3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  <a:ext uri="{96DAC541-7B7A-43D3-8B79-37D633B846F1}">
                        <asvg:svgBlip xmlns:asvg="http://schemas.microsoft.com/office/drawing/2016/SVG/main" r:embed="rId4"/>
                      </a:ext>
                    </a:extLst>
                  </a:blip>
                  <a:stretch>
                    <a:fillRect/>
                  </a:stretch>
                </p:blipFill>
                <p:spPr>
                  <a:xfrm rot="13014352">
                    <a:off x="7520867" y="4446616"/>
                    <a:ext cx="491227" cy="491227"/>
                  </a:xfrm>
                  <a:prstGeom prst="rect">
                    <a:avLst/>
                  </a:prstGeom>
                </p:spPr>
              </p:pic>
              <p:sp>
                <p:nvSpPr>
                  <p:cNvPr id="133" name="Rectangle: Rounded Corners 132">
                    <a:extLst>
                      <a:ext uri="{FF2B5EF4-FFF2-40B4-BE49-F238E27FC236}">
                        <a16:creationId xmlns:a16="http://schemas.microsoft.com/office/drawing/2014/main" id="{C6A36981-C217-4564-A285-76D94324B012}"/>
                      </a:ext>
                    </a:extLst>
                  </p:cNvPr>
                  <p:cNvSpPr/>
                  <p:nvPr/>
                </p:nvSpPr>
                <p:spPr>
                  <a:xfrm>
                    <a:off x="7204284" y="5902168"/>
                    <a:ext cx="185865" cy="119205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</p:grpSp>
            <p:pic>
              <p:nvPicPr>
                <p:cNvPr id="226" name="Graphic 225" descr="Germ with solid fill">
                  <a:extLst>
                    <a:ext uri="{FF2B5EF4-FFF2-40B4-BE49-F238E27FC236}">
                      <a16:creationId xmlns:a16="http://schemas.microsoft.com/office/drawing/2014/main" id="{6A014488-D575-4A11-B1CC-1DDE58ED639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  <a:stretch>
                  <a:fillRect/>
                </a:stretch>
              </p:blipFill>
              <p:spPr>
                <a:xfrm rot="4468559">
                  <a:off x="2351954" y="2035673"/>
                  <a:ext cx="401373" cy="401373"/>
                </a:xfrm>
                <a:prstGeom prst="rect">
                  <a:avLst/>
                </a:prstGeom>
              </p:spPr>
            </p:pic>
            <p:pic>
              <p:nvPicPr>
                <p:cNvPr id="227" name="Graphic 226" descr="Germ with solid fill">
                  <a:extLst>
                    <a:ext uri="{FF2B5EF4-FFF2-40B4-BE49-F238E27FC236}">
                      <a16:creationId xmlns:a16="http://schemas.microsoft.com/office/drawing/2014/main" id="{EE2E2701-BBEB-4310-B19B-919E6FAE61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  <a:stretch>
                  <a:fillRect/>
                </a:stretch>
              </p:blipFill>
              <p:spPr>
                <a:xfrm rot="2431986">
                  <a:off x="2284440" y="1382099"/>
                  <a:ext cx="401373" cy="401373"/>
                </a:xfrm>
                <a:prstGeom prst="rect">
                  <a:avLst/>
                </a:prstGeom>
              </p:spPr>
            </p:pic>
            <p:pic>
              <p:nvPicPr>
                <p:cNvPr id="228" name="Graphic 227" descr="Germ with solid fill">
                  <a:extLst>
                    <a:ext uri="{FF2B5EF4-FFF2-40B4-BE49-F238E27FC236}">
                      <a16:creationId xmlns:a16="http://schemas.microsoft.com/office/drawing/2014/main" id="{D4ADF9BB-B97D-4F9B-920F-F9E52C7293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  <a:stretch>
                  <a:fillRect/>
                </a:stretch>
              </p:blipFill>
              <p:spPr>
                <a:xfrm rot="8503288">
                  <a:off x="2590644" y="1651941"/>
                  <a:ext cx="401373" cy="401373"/>
                </a:xfrm>
                <a:prstGeom prst="rect">
                  <a:avLst/>
                </a:prstGeom>
              </p:spPr>
            </p:pic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D575C292-9AC2-4DEF-9359-C5639101B453}"/>
                  </a:ext>
                </a:extLst>
              </p:cNvPr>
              <p:cNvGrpSpPr/>
              <p:nvPr/>
            </p:nvGrpSpPr>
            <p:grpSpPr>
              <a:xfrm>
                <a:off x="1770430" y="1339212"/>
                <a:ext cx="805581" cy="1444150"/>
                <a:chOff x="1779851" y="1416776"/>
                <a:chExt cx="805581" cy="1444150"/>
              </a:xfrm>
            </p:grpSpPr>
            <p:grpSp>
              <p:nvGrpSpPr>
                <p:cNvPr id="136" name="Group 135">
                  <a:extLst>
                    <a:ext uri="{FF2B5EF4-FFF2-40B4-BE49-F238E27FC236}">
                      <a16:creationId xmlns:a16="http://schemas.microsoft.com/office/drawing/2014/main" id="{D1D102E3-30C6-40C5-9AFA-851F6F3C1086}"/>
                    </a:ext>
                  </a:extLst>
                </p:cNvPr>
                <p:cNvGrpSpPr/>
                <p:nvPr/>
              </p:nvGrpSpPr>
              <p:grpSpPr>
                <a:xfrm>
                  <a:off x="1779851" y="1436313"/>
                  <a:ext cx="805581" cy="1413288"/>
                  <a:chOff x="7050391" y="4423187"/>
                  <a:chExt cx="985924" cy="1729675"/>
                </a:xfrm>
              </p:grpSpPr>
              <p:sp>
                <p:nvSpPr>
                  <p:cNvPr id="137" name="Rectangle: Rounded Corners 136">
                    <a:extLst>
                      <a:ext uri="{FF2B5EF4-FFF2-40B4-BE49-F238E27FC236}">
                        <a16:creationId xmlns:a16="http://schemas.microsoft.com/office/drawing/2014/main" id="{7FE468C7-6696-459A-BF99-A89F3083033E}"/>
                      </a:ext>
                    </a:extLst>
                  </p:cNvPr>
                  <p:cNvSpPr/>
                  <p:nvPr/>
                </p:nvSpPr>
                <p:spPr>
                  <a:xfrm>
                    <a:off x="7050391" y="4423187"/>
                    <a:ext cx="985924" cy="172967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381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1">
                    <a:schemeClr val="lt1"/>
                  </a:fillRef>
                  <a:effectRef idx="0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140" name="Rectangle: Rounded Corners 139">
                    <a:extLst>
                      <a:ext uri="{FF2B5EF4-FFF2-40B4-BE49-F238E27FC236}">
                        <a16:creationId xmlns:a16="http://schemas.microsoft.com/office/drawing/2014/main" id="{D7466EE4-DA59-4D43-81C9-FC53D6F70875}"/>
                      </a:ext>
                    </a:extLst>
                  </p:cNvPr>
                  <p:cNvSpPr/>
                  <p:nvPr/>
                </p:nvSpPr>
                <p:spPr>
                  <a:xfrm>
                    <a:off x="7252862" y="5829791"/>
                    <a:ext cx="7171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141" name="Rectangle: Rounded Corners 140">
                    <a:extLst>
                      <a:ext uri="{FF2B5EF4-FFF2-40B4-BE49-F238E27FC236}">
                        <a16:creationId xmlns:a16="http://schemas.microsoft.com/office/drawing/2014/main" id="{230A3BE9-6E67-4208-8CDB-F2FE30411DA0}"/>
                      </a:ext>
                    </a:extLst>
                  </p:cNvPr>
                  <p:cNvSpPr/>
                  <p:nvPr/>
                </p:nvSpPr>
                <p:spPr>
                  <a:xfrm>
                    <a:off x="7484474" y="4917696"/>
                    <a:ext cx="12652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pic>
                <p:nvPicPr>
                  <p:cNvPr id="142" name="Graphic 141" descr="Germ with solid fill">
                    <a:extLst>
                      <a:ext uri="{FF2B5EF4-FFF2-40B4-BE49-F238E27FC236}">
                        <a16:creationId xmlns:a16="http://schemas.microsoft.com/office/drawing/2014/main" id="{46D8DA29-7123-4F0E-8A72-6738A4D016C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  <a:ext uri="{96DAC541-7B7A-43D3-8B79-37D633B846F1}">
                        <asvg:svgBlip xmlns:asvg="http://schemas.microsoft.com/office/drawing/2016/SVG/main" r:embed="rId8"/>
                      </a:ext>
                    </a:extLst>
                  </a:blip>
                  <a:stretch>
                    <a:fillRect/>
                  </a:stretch>
                </p:blipFill>
                <p:spPr>
                  <a:xfrm rot="3092641">
                    <a:off x="7054191" y="4860610"/>
                    <a:ext cx="703844" cy="703843"/>
                  </a:xfrm>
                  <a:prstGeom prst="rect">
                    <a:avLst/>
                  </a:prstGeom>
                </p:spPr>
              </p:pic>
              <p:sp>
                <p:nvSpPr>
                  <p:cNvPr id="144" name="Rectangle: Rounded Corners 143">
                    <a:extLst>
                      <a:ext uri="{FF2B5EF4-FFF2-40B4-BE49-F238E27FC236}">
                        <a16:creationId xmlns:a16="http://schemas.microsoft.com/office/drawing/2014/main" id="{6B771076-8644-45E4-B3D0-FD26256A54F5}"/>
                      </a:ext>
                    </a:extLst>
                  </p:cNvPr>
                  <p:cNvSpPr/>
                  <p:nvPr/>
                </p:nvSpPr>
                <p:spPr>
                  <a:xfrm>
                    <a:off x="7204284" y="5902168"/>
                    <a:ext cx="185865" cy="119205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</p:grpSp>
            <p:pic>
              <p:nvPicPr>
                <p:cNvPr id="224" name="Graphic 223" descr="Germ with solid fill">
                  <a:extLst>
                    <a:ext uri="{FF2B5EF4-FFF2-40B4-BE49-F238E27FC236}">
                      <a16:creationId xmlns:a16="http://schemas.microsoft.com/office/drawing/2014/main" id="{4F15F840-C586-4636-B9BD-17B77A3FF6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8"/>
                    </a:ext>
                  </a:extLst>
                </a:blip>
                <a:stretch>
                  <a:fillRect/>
                </a:stretch>
              </p:blipFill>
              <p:spPr>
                <a:xfrm rot="12470933">
                  <a:off x="1992051" y="2285828"/>
                  <a:ext cx="575099" cy="575098"/>
                </a:xfrm>
                <a:prstGeom prst="rect">
                  <a:avLst/>
                </a:prstGeom>
              </p:spPr>
            </p:pic>
            <p:pic>
              <p:nvPicPr>
                <p:cNvPr id="225" name="Graphic 224" descr="Germ with solid fill">
                  <a:extLst>
                    <a:ext uri="{FF2B5EF4-FFF2-40B4-BE49-F238E27FC236}">
                      <a16:creationId xmlns:a16="http://schemas.microsoft.com/office/drawing/2014/main" id="{39175CAB-4DBA-4AEA-889E-CF75576C4A5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8"/>
                    </a:ext>
                  </a:extLst>
                </a:blip>
                <a:stretch>
                  <a:fillRect/>
                </a:stretch>
              </p:blipFill>
              <p:spPr>
                <a:xfrm rot="14765988">
                  <a:off x="1968902" y="1416777"/>
                  <a:ext cx="575099" cy="575098"/>
                </a:xfrm>
                <a:prstGeom prst="rect">
                  <a:avLst/>
                </a:prstGeom>
              </p:spPr>
            </p:pic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E1465FBE-EE70-4B2A-893E-ED485316502D}"/>
                  </a:ext>
                </a:extLst>
              </p:cNvPr>
              <p:cNvGrpSpPr/>
              <p:nvPr/>
            </p:nvGrpSpPr>
            <p:grpSpPr>
              <a:xfrm>
                <a:off x="1331466" y="1644447"/>
                <a:ext cx="805581" cy="1413288"/>
                <a:chOff x="1341242" y="1587754"/>
                <a:chExt cx="805581" cy="1413288"/>
              </a:xfrm>
            </p:grpSpPr>
            <p:grpSp>
              <p:nvGrpSpPr>
                <p:cNvPr id="176" name="Group 175">
                  <a:extLst>
                    <a:ext uri="{FF2B5EF4-FFF2-40B4-BE49-F238E27FC236}">
                      <a16:creationId xmlns:a16="http://schemas.microsoft.com/office/drawing/2014/main" id="{926B6059-221C-4ECF-898F-C903C66976F0}"/>
                    </a:ext>
                  </a:extLst>
                </p:cNvPr>
                <p:cNvGrpSpPr/>
                <p:nvPr/>
              </p:nvGrpSpPr>
              <p:grpSpPr>
                <a:xfrm>
                  <a:off x="1341242" y="1587754"/>
                  <a:ext cx="805581" cy="1413288"/>
                  <a:chOff x="7050391" y="4423187"/>
                  <a:chExt cx="985924" cy="1729675"/>
                </a:xfrm>
              </p:grpSpPr>
              <p:sp>
                <p:nvSpPr>
                  <p:cNvPr id="177" name="Rectangle: Rounded Corners 176">
                    <a:extLst>
                      <a:ext uri="{FF2B5EF4-FFF2-40B4-BE49-F238E27FC236}">
                        <a16:creationId xmlns:a16="http://schemas.microsoft.com/office/drawing/2014/main" id="{A52F8612-2459-4090-BD5D-4DAE419166B8}"/>
                      </a:ext>
                    </a:extLst>
                  </p:cNvPr>
                  <p:cNvSpPr/>
                  <p:nvPr/>
                </p:nvSpPr>
                <p:spPr>
                  <a:xfrm>
                    <a:off x="7050391" y="4423187"/>
                    <a:ext cx="985924" cy="172967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381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1">
                    <a:schemeClr val="lt1"/>
                  </a:fillRef>
                  <a:effectRef idx="0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pic>
                <p:nvPicPr>
                  <p:cNvPr id="179" name="Graphic 178" descr="Germ with solid fill">
                    <a:extLst>
                      <a:ext uri="{FF2B5EF4-FFF2-40B4-BE49-F238E27FC236}">
                        <a16:creationId xmlns:a16="http://schemas.microsoft.com/office/drawing/2014/main" id="{08B87B1A-265F-4B3A-8896-5561E0A666F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  <a:ext uri="{96DAC541-7B7A-43D3-8B79-37D633B846F1}">
                        <asvg:svgBlip xmlns:asvg="http://schemas.microsoft.com/office/drawing/2016/SVG/main" r:embed="rId14"/>
                      </a:ext>
                    </a:extLst>
                  </a:blip>
                  <a:stretch>
                    <a:fillRect/>
                  </a:stretch>
                </p:blipFill>
                <p:spPr>
                  <a:xfrm rot="10222312">
                    <a:off x="7298556" y="5276942"/>
                    <a:ext cx="369332" cy="369332"/>
                  </a:xfrm>
                  <a:prstGeom prst="rect">
                    <a:avLst/>
                  </a:prstGeom>
                </p:spPr>
              </p:pic>
              <p:sp>
                <p:nvSpPr>
                  <p:cNvPr id="180" name="Rectangle: Rounded Corners 179">
                    <a:extLst>
                      <a:ext uri="{FF2B5EF4-FFF2-40B4-BE49-F238E27FC236}">
                        <a16:creationId xmlns:a16="http://schemas.microsoft.com/office/drawing/2014/main" id="{CB0B6450-7D91-49D9-AD50-3EFB5D278A5A}"/>
                      </a:ext>
                    </a:extLst>
                  </p:cNvPr>
                  <p:cNvSpPr/>
                  <p:nvPr/>
                </p:nvSpPr>
                <p:spPr>
                  <a:xfrm>
                    <a:off x="7252862" y="5829791"/>
                    <a:ext cx="7171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181" name="Rectangle: Rounded Corners 180">
                    <a:extLst>
                      <a:ext uri="{FF2B5EF4-FFF2-40B4-BE49-F238E27FC236}">
                        <a16:creationId xmlns:a16="http://schemas.microsoft.com/office/drawing/2014/main" id="{5AFF2CD1-C255-4DF7-92E0-D563065A3D5F}"/>
                      </a:ext>
                    </a:extLst>
                  </p:cNvPr>
                  <p:cNvSpPr/>
                  <p:nvPr/>
                </p:nvSpPr>
                <p:spPr>
                  <a:xfrm>
                    <a:off x="7484474" y="4917696"/>
                    <a:ext cx="12652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184" name="Rectangle: Rounded Corners 183">
                    <a:extLst>
                      <a:ext uri="{FF2B5EF4-FFF2-40B4-BE49-F238E27FC236}">
                        <a16:creationId xmlns:a16="http://schemas.microsoft.com/office/drawing/2014/main" id="{68363960-083C-45F3-930E-E2D33BA50C20}"/>
                      </a:ext>
                    </a:extLst>
                  </p:cNvPr>
                  <p:cNvSpPr/>
                  <p:nvPr/>
                </p:nvSpPr>
                <p:spPr>
                  <a:xfrm>
                    <a:off x="7204284" y="5902168"/>
                    <a:ext cx="185865" cy="119205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</p:grpSp>
            <p:pic>
              <p:nvPicPr>
                <p:cNvPr id="220" name="Graphic 219" descr="Germ with solid fill">
                  <a:extLst>
                    <a:ext uri="{FF2B5EF4-FFF2-40B4-BE49-F238E27FC236}">
                      <a16:creationId xmlns:a16="http://schemas.microsoft.com/office/drawing/2014/main" id="{3F3FD523-46D2-49BD-B6C0-6E6F3E3E97E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4"/>
                    </a:ext>
                  </a:extLst>
                </a:blip>
                <a:stretch>
                  <a:fillRect/>
                </a:stretch>
              </p:blipFill>
              <p:spPr>
                <a:xfrm rot="12563764">
                  <a:off x="1782136" y="1705763"/>
                  <a:ext cx="301775" cy="301775"/>
                </a:xfrm>
                <a:prstGeom prst="rect">
                  <a:avLst/>
                </a:prstGeom>
              </p:spPr>
            </p:pic>
            <p:pic>
              <p:nvPicPr>
                <p:cNvPr id="221" name="Graphic 220" descr="Germ with solid fill">
                  <a:extLst>
                    <a:ext uri="{FF2B5EF4-FFF2-40B4-BE49-F238E27FC236}">
                      <a16:creationId xmlns:a16="http://schemas.microsoft.com/office/drawing/2014/main" id="{35787616-152A-4E8C-9C45-6027C580CD7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4"/>
                    </a:ext>
                  </a:extLst>
                </a:blip>
                <a:stretch>
                  <a:fillRect/>
                </a:stretch>
              </p:blipFill>
              <p:spPr>
                <a:xfrm rot="14990679">
                  <a:off x="1474976" y="1967409"/>
                  <a:ext cx="301775" cy="301775"/>
                </a:xfrm>
                <a:prstGeom prst="rect">
                  <a:avLst/>
                </a:prstGeom>
              </p:spPr>
            </p:pic>
            <p:pic>
              <p:nvPicPr>
                <p:cNvPr id="222" name="Graphic 221" descr="Germ with solid fill">
                  <a:extLst>
                    <a:ext uri="{FF2B5EF4-FFF2-40B4-BE49-F238E27FC236}">
                      <a16:creationId xmlns:a16="http://schemas.microsoft.com/office/drawing/2014/main" id="{025E489D-82FF-41EC-8E52-416D0751DF3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4"/>
                    </a:ext>
                  </a:extLst>
                </a:blip>
                <a:stretch>
                  <a:fillRect/>
                </a:stretch>
              </p:blipFill>
              <p:spPr>
                <a:xfrm rot="4644932">
                  <a:off x="1802049" y="2648613"/>
                  <a:ext cx="301775" cy="301775"/>
                </a:xfrm>
                <a:prstGeom prst="rect">
                  <a:avLst/>
                </a:prstGeom>
              </p:spPr>
            </p:pic>
            <p:pic>
              <p:nvPicPr>
                <p:cNvPr id="223" name="Graphic 222" descr="Germ with solid fill">
                  <a:extLst>
                    <a:ext uri="{FF2B5EF4-FFF2-40B4-BE49-F238E27FC236}">
                      <a16:creationId xmlns:a16="http://schemas.microsoft.com/office/drawing/2014/main" id="{5138CBF5-11CC-4AA7-AF1E-8166340E20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4"/>
                    </a:ext>
                  </a:extLst>
                </a:blip>
                <a:stretch>
                  <a:fillRect/>
                </a:stretch>
              </p:blipFill>
              <p:spPr>
                <a:xfrm rot="14697382">
                  <a:off x="1831232" y="2100946"/>
                  <a:ext cx="301775" cy="301775"/>
                </a:xfrm>
                <a:prstGeom prst="rect">
                  <a:avLst/>
                </a:prstGeom>
              </p:spPr>
            </p:pic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F9A87078-DDFD-4EC4-B67E-FABF085262F0}"/>
                  </a:ext>
                </a:extLst>
              </p:cNvPr>
              <p:cNvGrpSpPr/>
              <p:nvPr/>
            </p:nvGrpSpPr>
            <p:grpSpPr>
              <a:xfrm>
                <a:off x="860204" y="1890843"/>
                <a:ext cx="822400" cy="1413288"/>
                <a:chOff x="861061" y="1803921"/>
                <a:chExt cx="822400" cy="1413288"/>
              </a:xfrm>
            </p:grpSpPr>
            <p:grpSp>
              <p:nvGrpSpPr>
                <p:cNvPr id="196" name="Group 195">
                  <a:extLst>
                    <a:ext uri="{FF2B5EF4-FFF2-40B4-BE49-F238E27FC236}">
                      <a16:creationId xmlns:a16="http://schemas.microsoft.com/office/drawing/2014/main" id="{C457960C-AADB-4EC1-979F-1365FA251CDF}"/>
                    </a:ext>
                  </a:extLst>
                </p:cNvPr>
                <p:cNvGrpSpPr/>
                <p:nvPr/>
              </p:nvGrpSpPr>
              <p:grpSpPr>
                <a:xfrm>
                  <a:off x="861061" y="1803921"/>
                  <a:ext cx="822400" cy="1413288"/>
                  <a:chOff x="7050391" y="4423187"/>
                  <a:chExt cx="1006508" cy="1729675"/>
                </a:xfrm>
              </p:grpSpPr>
              <p:sp>
                <p:nvSpPr>
                  <p:cNvPr id="197" name="Rectangle: Rounded Corners 196">
                    <a:extLst>
                      <a:ext uri="{FF2B5EF4-FFF2-40B4-BE49-F238E27FC236}">
                        <a16:creationId xmlns:a16="http://schemas.microsoft.com/office/drawing/2014/main" id="{7F707586-AAF6-4751-87F1-1D8D5808E27E}"/>
                      </a:ext>
                    </a:extLst>
                  </p:cNvPr>
                  <p:cNvSpPr/>
                  <p:nvPr/>
                </p:nvSpPr>
                <p:spPr>
                  <a:xfrm>
                    <a:off x="7050391" y="4423187"/>
                    <a:ext cx="985924" cy="172967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381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1">
                    <a:schemeClr val="lt1"/>
                  </a:fillRef>
                  <a:effectRef idx="0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pic>
                <p:nvPicPr>
                  <p:cNvPr id="198" name="Graphic 197" descr="Germ with solid fill">
                    <a:extLst>
                      <a:ext uri="{FF2B5EF4-FFF2-40B4-BE49-F238E27FC236}">
                        <a16:creationId xmlns:a16="http://schemas.microsoft.com/office/drawing/2014/main" id="{B45CB3D7-765D-4BB9-9DF9-7FD9B811C65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  <a:ext uri="{96DAC541-7B7A-43D3-8B79-37D633B846F1}">
                        <asvg:svgBlip xmlns:asvg="http://schemas.microsoft.com/office/drawing/2016/SVG/main" r:embed="rId12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457516" y="5515082"/>
                    <a:ext cx="599383" cy="599383"/>
                  </a:xfrm>
                  <a:prstGeom prst="rect">
                    <a:avLst/>
                  </a:prstGeom>
                </p:spPr>
              </p:pic>
              <p:sp>
                <p:nvSpPr>
                  <p:cNvPr id="200" name="Rectangle: Rounded Corners 199">
                    <a:extLst>
                      <a:ext uri="{FF2B5EF4-FFF2-40B4-BE49-F238E27FC236}">
                        <a16:creationId xmlns:a16="http://schemas.microsoft.com/office/drawing/2014/main" id="{AD2BAF4C-46CA-4DF8-8068-CE47EFA6A16C}"/>
                      </a:ext>
                    </a:extLst>
                  </p:cNvPr>
                  <p:cNvSpPr/>
                  <p:nvPr/>
                </p:nvSpPr>
                <p:spPr>
                  <a:xfrm>
                    <a:off x="7252862" y="5829791"/>
                    <a:ext cx="7171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201" name="Rectangle: Rounded Corners 200">
                    <a:extLst>
                      <a:ext uri="{FF2B5EF4-FFF2-40B4-BE49-F238E27FC236}">
                        <a16:creationId xmlns:a16="http://schemas.microsoft.com/office/drawing/2014/main" id="{2FCA7F09-F165-4720-8B63-4CEC97DD064B}"/>
                      </a:ext>
                    </a:extLst>
                  </p:cNvPr>
                  <p:cNvSpPr/>
                  <p:nvPr/>
                </p:nvSpPr>
                <p:spPr>
                  <a:xfrm>
                    <a:off x="7484474" y="4917696"/>
                    <a:ext cx="12652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204" name="Rectangle: Rounded Corners 203">
                    <a:extLst>
                      <a:ext uri="{FF2B5EF4-FFF2-40B4-BE49-F238E27FC236}">
                        <a16:creationId xmlns:a16="http://schemas.microsoft.com/office/drawing/2014/main" id="{D8B8765E-5EBF-41C7-BCA2-2DD4D626A986}"/>
                      </a:ext>
                    </a:extLst>
                  </p:cNvPr>
                  <p:cNvSpPr/>
                  <p:nvPr/>
                </p:nvSpPr>
                <p:spPr>
                  <a:xfrm>
                    <a:off x="7204284" y="5902168"/>
                    <a:ext cx="185865" cy="119205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</p:grpSp>
            <p:pic>
              <p:nvPicPr>
                <p:cNvPr id="218" name="Graphic 217" descr="Germ with solid fill">
                  <a:extLst>
                    <a:ext uri="{FF2B5EF4-FFF2-40B4-BE49-F238E27FC236}">
                      <a16:creationId xmlns:a16="http://schemas.microsoft.com/office/drawing/2014/main" id="{60DF7FDF-E6C9-4F8B-A44C-8298E43658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2"/>
                    </a:ext>
                  </a:extLst>
                </a:blip>
                <a:stretch>
                  <a:fillRect/>
                </a:stretch>
              </p:blipFill>
              <p:spPr>
                <a:xfrm rot="5085256">
                  <a:off x="1047466" y="1894265"/>
                  <a:ext cx="489745" cy="489746"/>
                </a:xfrm>
                <a:prstGeom prst="rect">
                  <a:avLst/>
                </a:prstGeom>
              </p:spPr>
            </p:pic>
            <p:pic>
              <p:nvPicPr>
                <p:cNvPr id="219" name="Graphic 218" descr="Germ with solid fill">
                  <a:extLst>
                    <a:ext uri="{FF2B5EF4-FFF2-40B4-BE49-F238E27FC236}">
                      <a16:creationId xmlns:a16="http://schemas.microsoft.com/office/drawing/2014/main" id="{B3C51F55-559E-44CC-BB54-26E87C4BEF4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2"/>
                    </a:ext>
                  </a:extLst>
                </a:blip>
                <a:stretch>
                  <a:fillRect/>
                </a:stretch>
              </p:blipFill>
              <p:spPr>
                <a:xfrm rot="15611448">
                  <a:off x="874787" y="2320658"/>
                  <a:ext cx="489745" cy="489746"/>
                </a:xfrm>
                <a:prstGeom prst="rect">
                  <a:avLst/>
                </a:prstGeom>
              </p:spPr>
            </p:pic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E98A2EC1-6431-4131-9953-B0F69E8F9740}"/>
                  </a:ext>
                </a:extLst>
              </p:cNvPr>
              <p:cNvGrpSpPr/>
              <p:nvPr/>
            </p:nvGrpSpPr>
            <p:grpSpPr>
              <a:xfrm>
                <a:off x="401428" y="2134491"/>
                <a:ext cx="805581" cy="1413288"/>
                <a:chOff x="392327" y="2029272"/>
                <a:chExt cx="805581" cy="1413288"/>
              </a:xfrm>
            </p:grpSpPr>
            <p:grpSp>
              <p:nvGrpSpPr>
                <p:cNvPr id="206" name="Group 205">
                  <a:extLst>
                    <a:ext uri="{FF2B5EF4-FFF2-40B4-BE49-F238E27FC236}">
                      <a16:creationId xmlns:a16="http://schemas.microsoft.com/office/drawing/2014/main" id="{2A957786-604E-45A2-9656-4A0F12E9CA7C}"/>
                    </a:ext>
                  </a:extLst>
                </p:cNvPr>
                <p:cNvGrpSpPr/>
                <p:nvPr/>
              </p:nvGrpSpPr>
              <p:grpSpPr>
                <a:xfrm>
                  <a:off x="392327" y="2029272"/>
                  <a:ext cx="805581" cy="1413288"/>
                  <a:chOff x="7050391" y="4423187"/>
                  <a:chExt cx="985924" cy="1729675"/>
                </a:xfrm>
              </p:grpSpPr>
              <p:sp>
                <p:nvSpPr>
                  <p:cNvPr id="207" name="Rectangle: Rounded Corners 206">
                    <a:extLst>
                      <a:ext uri="{FF2B5EF4-FFF2-40B4-BE49-F238E27FC236}">
                        <a16:creationId xmlns:a16="http://schemas.microsoft.com/office/drawing/2014/main" id="{56119754-EFB2-4B0E-ACB9-1DEEDBCE7354}"/>
                      </a:ext>
                    </a:extLst>
                  </p:cNvPr>
                  <p:cNvSpPr/>
                  <p:nvPr/>
                </p:nvSpPr>
                <p:spPr>
                  <a:xfrm>
                    <a:off x="7050391" y="4423187"/>
                    <a:ext cx="985924" cy="1729675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381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1">
                    <a:schemeClr val="lt1"/>
                  </a:fillRef>
                  <a:effectRef idx="0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210" name="Rectangle: Rounded Corners 209">
                    <a:extLst>
                      <a:ext uri="{FF2B5EF4-FFF2-40B4-BE49-F238E27FC236}">
                        <a16:creationId xmlns:a16="http://schemas.microsoft.com/office/drawing/2014/main" id="{881AB0FB-4E5A-4C3A-B118-A9E4484E200E}"/>
                      </a:ext>
                    </a:extLst>
                  </p:cNvPr>
                  <p:cNvSpPr/>
                  <p:nvPr/>
                </p:nvSpPr>
                <p:spPr>
                  <a:xfrm>
                    <a:off x="7252862" y="5829791"/>
                    <a:ext cx="7171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211" name="Rectangle: Rounded Corners 210">
                    <a:extLst>
                      <a:ext uri="{FF2B5EF4-FFF2-40B4-BE49-F238E27FC236}">
                        <a16:creationId xmlns:a16="http://schemas.microsoft.com/office/drawing/2014/main" id="{7D2DFE07-913F-40CC-A1D6-BBF5EE7BB514}"/>
                      </a:ext>
                    </a:extLst>
                  </p:cNvPr>
                  <p:cNvSpPr/>
                  <p:nvPr/>
                </p:nvSpPr>
                <p:spPr>
                  <a:xfrm>
                    <a:off x="7484474" y="4917696"/>
                    <a:ext cx="126520" cy="237489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sp>
                <p:nvSpPr>
                  <p:cNvPr id="214" name="Rectangle: Rounded Corners 213">
                    <a:extLst>
                      <a:ext uri="{FF2B5EF4-FFF2-40B4-BE49-F238E27FC236}">
                        <a16:creationId xmlns:a16="http://schemas.microsoft.com/office/drawing/2014/main" id="{473A0DCF-4EFD-493F-A428-73CC1DD657D7}"/>
                      </a:ext>
                    </a:extLst>
                  </p:cNvPr>
                  <p:cNvSpPr/>
                  <p:nvPr/>
                </p:nvSpPr>
                <p:spPr>
                  <a:xfrm>
                    <a:off x="7204284" y="5902168"/>
                    <a:ext cx="185865" cy="119205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nl-BE"/>
                  </a:p>
                </p:txBody>
              </p:sp>
              <p:pic>
                <p:nvPicPr>
                  <p:cNvPr id="215" name="Graphic 214" descr="Germ with solid fill">
                    <a:extLst>
                      <a:ext uri="{FF2B5EF4-FFF2-40B4-BE49-F238E27FC236}">
                        <a16:creationId xmlns:a16="http://schemas.microsoft.com/office/drawing/2014/main" id="{2E3967CC-DB3F-4A75-9C0C-44371248210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  <a:ext uri="{96DAC541-7B7A-43D3-8B79-37D633B846F1}">
                        <asvg:svgBlip xmlns:asvg="http://schemas.microsoft.com/office/drawing/2016/SVG/main" r:embed="rId6"/>
                      </a:ext>
                    </a:extLst>
                  </a:blip>
                  <a:stretch>
                    <a:fillRect/>
                  </a:stretch>
                </p:blipFill>
                <p:spPr>
                  <a:xfrm rot="6733061">
                    <a:off x="7067026" y="5471654"/>
                    <a:ext cx="491227" cy="491227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216" name="Graphic 215" descr="Germ with solid fill">
                  <a:extLst>
                    <a:ext uri="{FF2B5EF4-FFF2-40B4-BE49-F238E27FC236}">
                      <a16:creationId xmlns:a16="http://schemas.microsoft.com/office/drawing/2014/main" id="{895960CE-69C3-430C-877D-2ED4919EEB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6"/>
                    </a:ext>
                  </a:extLst>
                </a:blip>
                <a:stretch>
                  <a:fillRect/>
                </a:stretch>
              </p:blipFill>
              <p:spPr>
                <a:xfrm rot="13126538">
                  <a:off x="519932" y="2174042"/>
                  <a:ext cx="401373" cy="401373"/>
                </a:xfrm>
                <a:prstGeom prst="rect">
                  <a:avLst/>
                </a:prstGeom>
              </p:spPr>
            </p:pic>
            <p:pic>
              <p:nvPicPr>
                <p:cNvPr id="217" name="Graphic 216" descr="Germ with solid fill">
                  <a:extLst>
                    <a:ext uri="{FF2B5EF4-FFF2-40B4-BE49-F238E27FC236}">
                      <a16:creationId xmlns:a16="http://schemas.microsoft.com/office/drawing/2014/main" id="{2CD243EC-5E38-45FE-812A-DA100049A1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6"/>
                    </a:ext>
                  </a:extLst>
                </a:blip>
                <a:stretch>
                  <a:fillRect/>
                </a:stretch>
              </p:blipFill>
              <p:spPr>
                <a:xfrm rot="6733061">
                  <a:off x="740692" y="2644490"/>
                  <a:ext cx="401373" cy="401373"/>
                </a:xfrm>
                <a:prstGeom prst="rect">
                  <a:avLst/>
                </a:prstGeom>
              </p:spPr>
            </p:pic>
          </p:grp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D2B1AA7-F398-4D39-ABDC-EB148094ACB9}"/>
                  </a:ext>
                </a:extLst>
              </p:cNvPr>
              <p:cNvSpPr txBox="1"/>
              <p:nvPr/>
            </p:nvSpPr>
            <p:spPr>
              <a:xfrm>
                <a:off x="244073" y="4218787"/>
                <a:ext cx="36079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/>
                  <a:t>12 mini bioreactors: 10 ml per vessel</a:t>
                </a:r>
              </a:p>
            </p:txBody>
          </p:sp>
          <p:grpSp>
            <p:nvGrpSpPr>
              <p:cNvPr id="229" name="Group 228">
                <a:extLst>
                  <a:ext uri="{FF2B5EF4-FFF2-40B4-BE49-F238E27FC236}">
                    <a16:creationId xmlns:a16="http://schemas.microsoft.com/office/drawing/2014/main" id="{574D6257-0DDE-4F71-A251-7CBA5559F860}"/>
                  </a:ext>
                </a:extLst>
              </p:cNvPr>
              <p:cNvGrpSpPr/>
              <p:nvPr/>
            </p:nvGrpSpPr>
            <p:grpSpPr>
              <a:xfrm>
                <a:off x="2913987" y="2636881"/>
                <a:ext cx="805581" cy="1374431"/>
                <a:chOff x="7043103" y="4423187"/>
                <a:chExt cx="1013796" cy="1729675"/>
              </a:xfrm>
            </p:grpSpPr>
            <p:pic>
              <p:nvPicPr>
                <p:cNvPr id="230" name="Graphic 229" descr="Germ with solid fill">
                  <a:extLst>
                    <a:ext uri="{FF2B5EF4-FFF2-40B4-BE49-F238E27FC236}">
                      <a16:creationId xmlns:a16="http://schemas.microsoft.com/office/drawing/2014/main" id="{999E7D11-8C22-4F5C-A26F-677064E23DF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2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57516" y="5515082"/>
                  <a:ext cx="599383" cy="599383"/>
                </a:xfrm>
                <a:prstGeom prst="rect">
                  <a:avLst/>
                </a:prstGeom>
              </p:spPr>
            </p:pic>
            <p:pic>
              <p:nvPicPr>
                <p:cNvPr id="231" name="Graphic 230" descr="Germ with solid fill">
                  <a:extLst>
                    <a:ext uri="{FF2B5EF4-FFF2-40B4-BE49-F238E27FC236}">
                      <a16:creationId xmlns:a16="http://schemas.microsoft.com/office/drawing/2014/main" id="{BF51EF5A-EB5B-4712-82D7-DA86A3AF6C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4"/>
                    </a:ext>
                  </a:extLst>
                </a:blip>
                <a:stretch>
                  <a:fillRect/>
                </a:stretch>
              </p:blipFill>
              <p:spPr>
                <a:xfrm rot="10222312">
                  <a:off x="7298556" y="5276942"/>
                  <a:ext cx="369332" cy="369332"/>
                </a:xfrm>
                <a:prstGeom prst="rect">
                  <a:avLst/>
                </a:prstGeom>
              </p:spPr>
            </p:pic>
            <p:sp>
              <p:nvSpPr>
                <p:cNvPr id="232" name="Rectangle: Rounded Corners 231">
                  <a:extLst>
                    <a:ext uri="{FF2B5EF4-FFF2-40B4-BE49-F238E27FC236}">
                      <a16:creationId xmlns:a16="http://schemas.microsoft.com/office/drawing/2014/main" id="{CC6B6325-DF94-423E-92B2-F14F79266240}"/>
                    </a:ext>
                  </a:extLst>
                </p:cNvPr>
                <p:cNvSpPr/>
                <p:nvPr/>
              </p:nvSpPr>
              <p:spPr>
                <a:xfrm>
                  <a:off x="7252862" y="5829791"/>
                  <a:ext cx="71710" cy="237489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/>
                </a:p>
              </p:txBody>
            </p:sp>
            <p:sp>
              <p:nvSpPr>
                <p:cNvPr id="233" name="Rectangle: Rounded Corners 232">
                  <a:extLst>
                    <a:ext uri="{FF2B5EF4-FFF2-40B4-BE49-F238E27FC236}">
                      <a16:creationId xmlns:a16="http://schemas.microsoft.com/office/drawing/2014/main" id="{7031A5FE-17DC-4434-BF0A-06E54BD3CB18}"/>
                    </a:ext>
                  </a:extLst>
                </p:cNvPr>
                <p:cNvSpPr/>
                <p:nvPr/>
              </p:nvSpPr>
              <p:spPr>
                <a:xfrm>
                  <a:off x="7050391" y="4423187"/>
                  <a:ext cx="985924" cy="1729675"/>
                </a:xfrm>
                <a:prstGeom prst="roundRect">
                  <a:avLst/>
                </a:prstGeom>
                <a:no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1">
                  <a:schemeClr val="l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nl-BE"/>
                </a:p>
              </p:txBody>
            </p:sp>
            <p:sp>
              <p:nvSpPr>
                <p:cNvPr id="234" name="Rectangle: Rounded Corners 233">
                  <a:extLst>
                    <a:ext uri="{FF2B5EF4-FFF2-40B4-BE49-F238E27FC236}">
                      <a16:creationId xmlns:a16="http://schemas.microsoft.com/office/drawing/2014/main" id="{6D6E59ED-57EC-4C03-B50E-882ADED3AE4C}"/>
                    </a:ext>
                  </a:extLst>
                </p:cNvPr>
                <p:cNvSpPr/>
                <p:nvPr/>
              </p:nvSpPr>
              <p:spPr>
                <a:xfrm>
                  <a:off x="7484474" y="4917696"/>
                  <a:ext cx="126520" cy="237489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/>
                </a:p>
              </p:txBody>
            </p:sp>
            <p:pic>
              <p:nvPicPr>
                <p:cNvPr id="235" name="Graphic 234" descr="Germ with solid fill">
                  <a:extLst>
                    <a:ext uri="{FF2B5EF4-FFF2-40B4-BE49-F238E27FC236}">
                      <a16:creationId xmlns:a16="http://schemas.microsoft.com/office/drawing/2014/main" id="{C6F858F8-650F-4578-9BC6-99390D7CB59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8"/>
                    </a:ext>
                  </a:extLst>
                </a:blip>
                <a:stretch>
                  <a:fillRect/>
                </a:stretch>
              </p:blipFill>
              <p:spPr>
                <a:xfrm rot="3092641">
                  <a:off x="7064318" y="4660252"/>
                  <a:ext cx="703844" cy="703844"/>
                </a:xfrm>
                <a:prstGeom prst="rect">
                  <a:avLst/>
                </a:prstGeom>
              </p:spPr>
            </p:pic>
            <p:pic>
              <p:nvPicPr>
                <p:cNvPr id="236" name="Graphic 235" descr="Germ with solid fill">
                  <a:extLst>
                    <a:ext uri="{FF2B5EF4-FFF2-40B4-BE49-F238E27FC236}">
                      <a16:creationId xmlns:a16="http://schemas.microsoft.com/office/drawing/2014/main" id="{2E04A0A6-5597-4635-99B8-C90B3FFE589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4"/>
                    </a:ext>
                  </a:extLst>
                </a:blip>
                <a:stretch>
                  <a:fillRect/>
                </a:stretch>
              </p:blipFill>
              <p:spPr>
                <a:xfrm rot="13014352">
                  <a:off x="7520867" y="4446616"/>
                  <a:ext cx="491227" cy="491227"/>
                </a:xfrm>
                <a:prstGeom prst="rect">
                  <a:avLst/>
                </a:prstGeom>
              </p:spPr>
            </p:pic>
            <p:sp>
              <p:nvSpPr>
                <p:cNvPr id="237" name="Rectangle: Rounded Corners 236">
                  <a:extLst>
                    <a:ext uri="{FF2B5EF4-FFF2-40B4-BE49-F238E27FC236}">
                      <a16:creationId xmlns:a16="http://schemas.microsoft.com/office/drawing/2014/main" id="{F53261CB-5CFA-4F60-9B2A-35C98DD89853}"/>
                    </a:ext>
                  </a:extLst>
                </p:cNvPr>
                <p:cNvSpPr/>
                <p:nvPr/>
              </p:nvSpPr>
              <p:spPr>
                <a:xfrm>
                  <a:off x="7204284" y="5902168"/>
                  <a:ext cx="185865" cy="119205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nl-BE"/>
                </a:p>
              </p:txBody>
            </p:sp>
            <p:pic>
              <p:nvPicPr>
                <p:cNvPr id="238" name="Graphic 237" descr="Germ with solid fill">
                  <a:extLst>
                    <a:ext uri="{FF2B5EF4-FFF2-40B4-BE49-F238E27FC236}">
                      <a16:creationId xmlns:a16="http://schemas.microsoft.com/office/drawing/2014/main" id="{C3CE2A26-7B9A-47C2-B396-25DEB23286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6"/>
                    </a:ext>
                  </a:extLst>
                </a:blip>
                <a:stretch>
                  <a:fillRect/>
                </a:stretch>
              </p:blipFill>
              <p:spPr>
                <a:xfrm rot="6733061">
                  <a:off x="7043103" y="5613611"/>
                  <a:ext cx="491227" cy="491227"/>
                </a:xfrm>
                <a:prstGeom prst="rect">
                  <a:avLst/>
                </a:prstGeom>
              </p:spPr>
            </p:pic>
          </p:grp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E7F25AA-BCB4-42FE-9DF9-B17983D6FF08}"/>
                  </a:ext>
                </a:extLst>
              </p:cNvPr>
              <p:cNvSpPr txBox="1"/>
              <p:nvPr/>
            </p:nvSpPr>
            <p:spPr>
              <a:xfrm>
                <a:off x="55343" y="1234253"/>
                <a:ext cx="15222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/>
                  <a:t>Monocultures</a:t>
                </a:r>
                <a:endParaRPr lang="nl-BE" b="1" dirty="0"/>
              </a:p>
            </p:txBody>
          </p: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0C396C1F-703E-40D1-B149-892A1FBC9539}"/>
                  </a:ext>
                </a:extLst>
              </p:cNvPr>
              <p:cNvSpPr txBox="1"/>
              <p:nvPr/>
            </p:nvSpPr>
            <p:spPr>
              <a:xfrm>
                <a:off x="1985841" y="727596"/>
                <a:ext cx="71846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lank</a:t>
                </a:r>
                <a:endParaRPr lang="nl-BE" dirty="0"/>
              </a:p>
            </p:txBody>
          </p:sp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49B1CD9F-05CB-4813-AC3A-98A697CE61DA}"/>
                  </a:ext>
                </a:extLst>
              </p:cNvPr>
              <p:cNvSpPr txBox="1"/>
              <p:nvPr/>
            </p:nvSpPr>
            <p:spPr>
              <a:xfrm>
                <a:off x="1608255" y="3698396"/>
                <a:ext cx="12971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/>
                  <a:t>Community</a:t>
                </a:r>
                <a:endParaRPr lang="nl-BE" b="1" dirty="0"/>
              </a:p>
            </p:txBody>
          </p:sp>
        </p:grp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C2527CFF-1CC4-49D9-8682-2C509CDBFE05}"/>
              </a:ext>
            </a:extLst>
          </p:cNvPr>
          <p:cNvSpPr txBox="1"/>
          <p:nvPr/>
        </p:nvSpPr>
        <p:spPr>
          <a:xfrm>
            <a:off x="6271573" y="618714"/>
            <a:ext cx="3162809" cy="1384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Monoculture and community members:</a:t>
            </a:r>
          </a:p>
          <a:p>
            <a:pPr algn="ctr"/>
            <a:r>
              <a:rPr lang="en-US" sz="1400" i="1" dirty="0" err="1"/>
              <a:t>Roseburia</a:t>
            </a:r>
            <a:r>
              <a:rPr lang="en-US" sz="1400" i="1" dirty="0"/>
              <a:t> intestinalis</a:t>
            </a:r>
          </a:p>
          <a:p>
            <a:pPr algn="ctr"/>
            <a:r>
              <a:rPr lang="en-US" sz="1400" i="1" dirty="0" err="1"/>
              <a:t>Blautia</a:t>
            </a:r>
            <a:r>
              <a:rPr lang="en-US" sz="1400" i="1" dirty="0"/>
              <a:t> </a:t>
            </a:r>
            <a:r>
              <a:rPr lang="en-US" sz="1400" i="1" dirty="0" err="1"/>
              <a:t>hydrogenotrophica</a:t>
            </a:r>
            <a:endParaRPr lang="en-US" sz="1400" i="1" dirty="0"/>
          </a:p>
          <a:p>
            <a:pPr algn="ctr"/>
            <a:r>
              <a:rPr lang="en-US" sz="1400" i="1" dirty="0"/>
              <a:t>Bacteroides </a:t>
            </a:r>
            <a:r>
              <a:rPr lang="en-US" sz="1400" i="1" dirty="0" err="1"/>
              <a:t>thetaiotaomicron</a:t>
            </a:r>
            <a:endParaRPr lang="en-US" sz="1400" i="1" dirty="0"/>
          </a:p>
          <a:p>
            <a:pPr algn="ctr"/>
            <a:r>
              <a:rPr lang="en-US" sz="1400" i="1" dirty="0" err="1"/>
              <a:t>Collinsella</a:t>
            </a:r>
            <a:r>
              <a:rPr lang="en-US" sz="1400" i="1" dirty="0"/>
              <a:t> </a:t>
            </a:r>
            <a:r>
              <a:rPr lang="en-US" sz="1400" i="1" dirty="0" err="1"/>
              <a:t>aerofaciens</a:t>
            </a:r>
            <a:endParaRPr lang="en-US" sz="1400" i="1" dirty="0"/>
          </a:p>
          <a:p>
            <a:pPr algn="ctr"/>
            <a:r>
              <a:rPr lang="en-US" sz="1400" i="1" dirty="0" err="1"/>
              <a:t>Prevotella</a:t>
            </a:r>
            <a:r>
              <a:rPr lang="en-US" sz="1400" i="1" dirty="0"/>
              <a:t> </a:t>
            </a:r>
            <a:r>
              <a:rPr lang="en-US" sz="1400" i="1" dirty="0" err="1"/>
              <a:t>copri</a:t>
            </a:r>
            <a:endParaRPr lang="nl-BE" sz="1400" i="1" dirty="0"/>
          </a:p>
        </p:txBody>
      </p:sp>
    </p:spTree>
    <p:extLst>
      <p:ext uri="{BB962C8B-B14F-4D97-AF65-F5344CB8AC3E}">
        <p14:creationId xmlns:p14="http://schemas.microsoft.com/office/powerpoint/2010/main" val="33989547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9B23668E-1252-4AAF-89AC-CCFBF54C21E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1784880"/>
              </p:ext>
            </p:extLst>
          </p:nvPr>
        </p:nvGraphicFramePr>
        <p:xfrm>
          <a:off x="-383939" y="1672660"/>
          <a:ext cx="7626857" cy="48452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EDF31241-FB24-4CE2-89AF-490ACE378C1A}"/>
              </a:ext>
            </a:extLst>
          </p:cNvPr>
          <p:cNvSpPr txBox="1"/>
          <p:nvPr/>
        </p:nvSpPr>
        <p:spPr>
          <a:xfrm>
            <a:off x="-383939" y="1449832"/>
            <a:ext cx="16867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A</a:t>
            </a:r>
            <a:endParaRPr lang="nl-BE" sz="26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FA05A76-25BB-4FA8-BE48-78CC3D5BF07F}"/>
              </a:ext>
            </a:extLst>
          </p:cNvPr>
          <p:cNvSpPr txBox="1"/>
          <p:nvPr/>
        </p:nvSpPr>
        <p:spPr>
          <a:xfrm>
            <a:off x="7648743" y="1449832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B</a:t>
            </a:r>
            <a:endParaRPr lang="nl-BE" sz="2600" b="1" dirty="0"/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8FB0B573-64D9-4CE9-AA02-8C44BC5C43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8227918"/>
              </p:ext>
            </p:extLst>
          </p:nvPr>
        </p:nvGraphicFramePr>
        <p:xfrm>
          <a:off x="7648743" y="1671835"/>
          <a:ext cx="7626857" cy="48452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23" name="Group 22">
            <a:extLst>
              <a:ext uri="{FF2B5EF4-FFF2-40B4-BE49-F238E27FC236}">
                <a16:creationId xmlns:a16="http://schemas.microsoft.com/office/drawing/2014/main" id="{71E82C7D-AF91-4937-88BF-BCA6B8FFCBFA}"/>
              </a:ext>
            </a:extLst>
          </p:cNvPr>
          <p:cNvGrpSpPr/>
          <p:nvPr/>
        </p:nvGrpSpPr>
        <p:grpSpPr>
          <a:xfrm>
            <a:off x="4322485" y="6815368"/>
            <a:ext cx="9074934" cy="993187"/>
            <a:chOff x="3291971" y="7077406"/>
            <a:chExt cx="9074934" cy="993187"/>
          </a:xfrm>
        </p:grpSpPr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E9FE0004-E404-49AA-99BB-15ADF4DA3BB5}"/>
                </a:ext>
              </a:extLst>
            </p:cNvPr>
            <p:cNvSpPr/>
            <p:nvPr/>
          </p:nvSpPr>
          <p:spPr>
            <a:xfrm>
              <a:off x="3291971" y="7095917"/>
              <a:ext cx="240005" cy="240005"/>
            </a:xfrm>
            <a:prstGeom prst="ellipse">
              <a:avLst/>
            </a:prstGeom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600" dirty="0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B754AE20-3F01-4101-AC34-C327D4F2EBEA}"/>
                </a:ext>
              </a:extLst>
            </p:cNvPr>
            <p:cNvSpPr/>
            <p:nvPr/>
          </p:nvSpPr>
          <p:spPr>
            <a:xfrm>
              <a:off x="8058919" y="7095917"/>
              <a:ext cx="240005" cy="240005"/>
            </a:xfrm>
            <a:prstGeom prst="ellipse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600" dirty="0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42A2E8FC-0E54-4349-84B8-B608D70EBA04}"/>
                </a:ext>
              </a:extLst>
            </p:cNvPr>
            <p:cNvSpPr/>
            <p:nvPr/>
          </p:nvSpPr>
          <p:spPr>
            <a:xfrm>
              <a:off x="5601743" y="7095917"/>
              <a:ext cx="240005" cy="240005"/>
            </a:xfrm>
            <a:prstGeom prst="ellipse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600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700044D7-23B3-4E98-9BC8-2B29D8BB08F2}"/>
                </a:ext>
              </a:extLst>
            </p:cNvPr>
            <p:cNvSpPr/>
            <p:nvPr/>
          </p:nvSpPr>
          <p:spPr>
            <a:xfrm>
              <a:off x="3291971" y="7607163"/>
              <a:ext cx="240005" cy="240005"/>
            </a:xfrm>
            <a:prstGeom prst="ellipse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6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B463E49-0DDB-4FAA-99FB-00E6CBDE5A5D}"/>
                </a:ext>
              </a:extLst>
            </p:cNvPr>
            <p:cNvSpPr txBox="1"/>
            <p:nvPr/>
          </p:nvSpPr>
          <p:spPr>
            <a:xfrm>
              <a:off x="3498405" y="7077406"/>
              <a:ext cx="4101553" cy="480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err="1"/>
                <a:t>Roseburia</a:t>
              </a:r>
              <a:r>
                <a:rPr lang="en-US" sz="1200" i="1" dirty="0"/>
                <a:t> intestinalis</a:t>
              </a:r>
              <a:endParaRPr lang="nl-BE" sz="1200" i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D926CC2-7A63-407F-9E5A-81D0F9960345}"/>
                </a:ext>
              </a:extLst>
            </p:cNvPr>
            <p:cNvSpPr txBox="1"/>
            <p:nvPr/>
          </p:nvSpPr>
          <p:spPr>
            <a:xfrm>
              <a:off x="8265352" y="7077406"/>
              <a:ext cx="4101553" cy="480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Bacteroides </a:t>
              </a:r>
              <a:r>
                <a:rPr lang="en-US" sz="1200" i="1" dirty="0" err="1"/>
                <a:t>thetaiotaomicron</a:t>
              </a:r>
              <a:endParaRPr lang="nl-BE" sz="1200" i="1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78A9881-EDC1-4F82-828E-BEF00927C703}"/>
                </a:ext>
              </a:extLst>
            </p:cNvPr>
            <p:cNvSpPr txBox="1"/>
            <p:nvPr/>
          </p:nvSpPr>
          <p:spPr>
            <a:xfrm>
              <a:off x="5808177" y="7077406"/>
              <a:ext cx="4101553" cy="480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err="1"/>
                <a:t>Blautia</a:t>
              </a:r>
              <a:r>
                <a:rPr lang="en-US" sz="1200" i="1" dirty="0"/>
                <a:t> </a:t>
              </a:r>
              <a:r>
                <a:rPr lang="en-US" sz="1200" i="1" dirty="0" err="1"/>
                <a:t>hydrogenotrophica</a:t>
              </a:r>
              <a:endParaRPr lang="nl-BE" sz="1200" i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BA95936-D1C2-469A-B7E6-CD4EBF98F927}"/>
                </a:ext>
              </a:extLst>
            </p:cNvPr>
            <p:cNvSpPr txBox="1"/>
            <p:nvPr/>
          </p:nvSpPr>
          <p:spPr>
            <a:xfrm>
              <a:off x="3483891" y="7590370"/>
              <a:ext cx="4101553" cy="480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err="1"/>
                <a:t>Collinsella</a:t>
              </a:r>
              <a:r>
                <a:rPr lang="en-US" sz="1200" i="1" dirty="0"/>
                <a:t> </a:t>
              </a:r>
              <a:r>
                <a:rPr lang="en-US" sz="1200" i="1" dirty="0" err="1"/>
                <a:t>aerofaciens</a:t>
              </a:r>
              <a:endParaRPr lang="nl-BE" sz="1200" i="1" dirty="0"/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AFB59E80-8B76-4DF2-A009-F69194A4934C}"/>
                </a:ext>
              </a:extLst>
            </p:cNvPr>
            <p:cNvSpPr/>
            <p:nvPr/>
          </p:nvSpPr>
          <p:spPr>
            <a:xfrm>
              <a:off x="5608033" y="7607163"/>
              <a:ext cx="240005" cy="240005"/>
            </a:xfrm>
            <a:prstGeom prst="ellipse">
              <a:avLst/>
            </a:prstGeom>
            <a:solidFill>
              <a:schemeClr val="accent5"/>
            </a:solidFill>
            <a:ln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6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83F0945-D86C-4FC9-A425-A54918CAD634}"/>
                </a:ext>
              </a:extLst>
            </p:cNvPr>
            <p:cNvSpPr txBox="1"/>
            <p:nvPr/>
          </p:nvSpPr>
          <p:spPr>
            <a:xfrm>
              <a:off x="5793663" y="7590370"/>
              <a:ext cx="4101553" cy="480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err="1"/>
                <a:t>Prevotella</a:t>
              </a:r>
              <a:r>
                <a:rPr lang="en-US" sz="1200" i="1" dirty="0"/>
                <a:t> </a:t>
              </a:r>
              <a:r>
                <a:rPr lang="en-US" sz="1200" i="1" dirty="0" err="1"/>
                <a:t>copri</a:t>
              </a:r>
              <a:endParaRPr lang="nl-BE" sz="1200" i="1" dirty="0"/>
            </a:p>
          </p:txBody>
        </p:sp>
        <p:sp>
          <p:nvSpPr>
            <p:cNvPr id="20" name="Oval 19">
              <a:extLst>
                <a:ext uri="{FF2B5EF4-FFF2-40B4-BE49-F238E27FC236}">
                  <a16:creationId xmlns:a16="http://schemas.microsoft.com/office/drawing/2014/main" id="{FA518B28-7F6A-47A5-AD12-457471172770}"/>
                </a:ext>
              </a:extLst>
            </p:cNvPr>
            <p:cNvSpPr/>
            <p:nvPr/>
          </p:nvSpPr>
          <p:spPr>
            <a:xfrm>
              <a:off x="8065208" y="7607163"/>
              <a:ext cx="240005" cy="240005"/>
            </a:xfrm>
            <a:prstGeom prst="ellipse">
              <a:avLst/>
            </a:prstGeom>
            <a:solidFill>
              <a:srgbClr val="7C7C7C"/>
            </a:solidFill>
            <a:ln>
              <a:solidFill>
                <a:srgbClr val="7C7C7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6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FF4D88F-48FF-45F8-BDE7-52A1B0986317}"/>
                </a:ext>
              </a:extLst>
            </p:cNvPr>
            <p:cNvSpPr txBox="1"/>
            <p:nvPr/>
          </p:nvSpPr>
          <p:spPr>
            <a:xfrm>
              <a:off x="8250838" y="7590370"/>
              <a:ext cx="4101553" cy="480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Unknown</a:t>
              </a:r>
              <a:endParaRPr lang="nl-B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654539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6D9786D-D72E-470B-9135-E73A1C163B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270045"/>
            <a:ext cx="13208000" cy="53659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450924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A3805AA-10F6-48D6-A811-503D1574009A}"/>
              </a:ext>
            </a:extLst>
          </p:cNvPr>
          <p:cNvSpPr txBox="1"/>
          <p:nvPr/>
        </p:nvSpPr>
        <p:spPr>
          <a:xfrm>
            <a:off x="0" y="1718374"/>
            <a:ext cx="16867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A</a:t>
            </a:r>
            <a:endParaRPr lang="nl-BE" sz="26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718200E-BB1B-47DC-A71A-CFFFD9832426}"/>
              </a:ext>
            </a:extLst>
          </p:cNvPr>
          <p:cNvSpPr txBox="1"/>
          <p:nvPr/>
        </p:nvSpPr>
        <p:spPr>
          <a:xfrm>
            <a:off x="7242448" y="1706691"/>
            <a:ext cx="1143961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B</a:t>
            </a:r>
            <a:endParaRPr lang="nl-BE" sz="2600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85B8223-95A0-42A9-90D1-F0549685E7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26995" y="2070648"/>
            <a:ext cx="5335563" cy="5107304"/>
          </a:xfrm>
          <a:prstGeom prst="rect">
            <a:avLst/>
          </a:prstGeom>
        </p:spPr>
      </p:pic>
      <p:sp>
        <p:nvSpPr>
          <p:cNvPr id="18" name="Oval 17">
            <a:extLst>
              <a:ext uri="{FF2B5EF4-FFF2-40B4-BE49-F238E27FC236}">
                <a16:creationId xmlns:a16="http://schemas.microsoft.com/office/drawing/2014/main" id="{CD8D54BE-702E-431E-ABB3-652BECFC32AA}"/>
              </a:ext>
            </a:extLst>
          </p:cNvPr>
          <p:cNvSpPr/>
          <p:nvPr/>
        </p:nvSpPr>
        <p:spPr>
          <a:xfrm>
            <a:off x="2631012" y="7413323"/>
            <a:ext cx="240005" cy="240005"/>
          </a:xfrm>
          <a:prstGeom prst="ellipse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600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0819A8F2-65BC-41F9-9C2D-31928B19C426}"/>
              </a:ext>
            </a:extLst>
          </p:cNvPr>
          <p:cNvSpPr/>
          <p:nvPr/>
        </p:nvSpPr>
        <p:spPr>
          <a:xfrm>
            <a:off x="4930998" y="7413323"/>
            <a:ext cx="240005" cy="240005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60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4A29F23-8D9D-4557-A7B4-31D8A3068A9F}"/>
              </a:ext>
            </a:extLst>
          </p:cNvPr>
          <p:cNvSpPr txBox="1"/>
          <p:nvPr/>
        </p:nvSpPr>
        <p:spPr>
          <a:xfrm>
            <a:off x="3108391" y="7431806"/>
            <a:ext cx="1814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anual gating Exp1</a:t>
            </a:r>
            <a:endParaRPr lang="nl-BE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83B1C8D-730D-45FC-A28A-BDBF1A68EF3F}"/>
              </a:ext>
            </a:extLst>
          </p:cNvPr>
          <p:cNvSpPr txBox="1"/>
          <p:nvPr/>
        </p:nvSpPr>
        <p:spPr>
          <a:xfrm>
            <a:off x="5418164" y="7431806"/>
            <a:ext cx="15064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anual gating Exp2</a:t>
            </a:r>
            <a:endParaRPr lang="nl-BE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B74D6E4-E8F2-4E8C-97CB-2AF280D62FDD}"/>
              </a:ext>
            </a:extLst>
          </p:cNvPr>
          <p:cNvSpPr txBox="1"/>
          <p:nvPr/>
        </p:nvSpPr>
        <p:spPr>
          <a:xfrm>
            <a:off x="3093878" y="7958024"/>
            <a:ext cx="1539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achine gating Exp1</a:t>
            </a:r>
            <a:endParaRPr lang="nl-BE" sz="1200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1CAEC340-822D-4A63-8768-AF090DA19EA4}"/>
              </a:ext>
            </a:extLst>
          </p:cNvPr>
          <p:cNvSpPr/>
          <p:nvPr/>
        </p:nvSpPr>
        <p:spPr>
          <a:xfrm>
            <a:off x="4921373" y="7976521"/>
            <a:ext cx="240005" cy="240005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6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0FEC463-990E-44B6-AC8F-8D2C0ED1C7C3}"/>
              </a:ext>
            </a:extLst>
          </p:cNvPr>
          <p:cNvSpPr txBox="1"/>
          <p:nvPr/>
        </p:nvSpPr>
        <p:spPr>
          <a:xfrm>
            <a:off x="5403650" y="7958024"/>
            <a:ext cx="1539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achine gating Exp2</a:t>
            </a:r>
            <a:endParaRPr lang="nl-BE" sz="1200" dirty="0"/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5C5A7386-3418-4BB0-B59C-4B35C029D36B}"/>
              </a:ext>
            </a:extLst>
          </p:cNvPr>
          <p:cNvCxnSpPr/>
          <p:nvPr/>
        </p:nvCxnSpPr>
        <p:spPr>
          <a:xfrm>
            <a:off x="2438193" y="7542950"/>
            <a:ext cx="625642" cy="0"/>
          </a:xfrm>
          <a:prstGeom prst="line">
            <a:avLst/>
          </a:prstGeom>
          <a:ln w="38100"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Oval 31">
            <a:extLst>
              <a:ext uri="{FF2B5EF4-FFF2-40B4-BE49-F238E27FC236}">
                <a16:creationId xmlns:a16="http://schemas.microsoft.com/office/drawing/2014/main" id="{F1E9737A-EAE4-4E84-8A4F-CD7EEE7F85BE}"/>
              </a:ext>
            </a:extLst>
          </p:cNvPr>
          <p:cNvSpPr/>
          <p:nvPr/>
        </p:nvSpPr>
        <p:spPr>
          <a:xfrm>
            <a:off x="2621387" y="7976521"/>
            <a:ext cx="240005" cy="240005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600" dirty="0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9ABE1E9-1360-41F0-A8D3-16003381EBEF}"/>
              </a:ext>
            </a:extLst>
          </p:cNvPr>
          <p:cNvCxnSpPr>
            <a:cxnSpLocks/>
          </p:cNvCxnSpPr>
          <p:nvPr/>
        </p:nvCxnSpPr>
        <p:spPr>
          <a:xfrm>
            <a:off x="2408151" y="8096523"/>
            <a:ext cx="685727" cy="1"/>
          </a:xfrm>
          <a:prstGeom prst="line">
            <a:avLst/>
          </a:prstGeom>
          <a:ln w="3810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0D881864-FE3A-4927-875F-58948563572F}"/>
              </a:ext>
            </a:extLst>
          </p:cNvPr>
          <p:cNvCxnSpPr>
            <a:cxnSpLocks/>
          </p:cNvCxnSpPr>
          <p:nvPr/>
        </p:nvCxnSpPr>
        <p:spPr>
          <a:xfrm>
            <a:off x="4712293" y="8096523"/>
            <a:ext cx="677415" cy="1"/>
          </a:xfrm>
          <a:prstGeom prst="line">
            <a:avLst/>
          </a:prstGeom>
          <a:ln w="38100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34B5AA66-CE2C-4EE0-965E-AF02EABE1C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330805"/>
              </p:ext>
            </p:extLst>
          </p:nvPr>
        </p:nvGraphicFramePr>
        <p:xfrm>
          <a:off x="245444" y="2282941"/>
          <a:ext cx="6997004" cy="49170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A4E23F6A-F093-429A-B930-A726E43BFFEE}"/>
              </a:ext>
            </a:extLst>
          </p:cNvPr>
          <p:cNvCxnSpPr/>
          <p:nvPr/>
        </p:nvCxnSpPr>
        <p:spPr>
          <a:xfrm>
            <a:off x="4748407" y="7542950"/>
            <a:ext cx="625642" cy="0"/>
          </a:xfrm>
          <a:prstGeom prst="line">
            <a:avLst/>
          </a:prstGeom>
          <a:ln w="3810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61C89479-F507-4F7C-9F59-0F7F3EECC7B6}"/>
              </a:ext>
            </a:extLst>
          </p:cNvPr>
          <p:cNvSpPr txBox="1"/>
          <p:nvPr/>
        </p:nvSpPr>
        <p:spPr>
          <a:xfrm>
            <a:off x="5418164" y="8521221"/>
            <a:ext cx="1539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tart feed Exp2</a:t>
            </a:r>
            <a:endParaRPr lang="nl-BE" sz="1200" dirty="0"/>
          </a:p>
        </p:txBody>
      </p:sp>
      <p:sp>
        <p:nvSpPr>
          <p:cNvPr id="29" name="Explosion: 8 Points 28">
            <a:extLst>
              <a:ext uri="{FF2B5EF4-FFF2-40B4-BE49-F238E27FC236}">
                <a16:creationId xmlns:a16="http://schemas.microsoft.com/office/drawing/2014/main" id="{3BC5ECF3-2427-4D75-881A-C4C39B15D068}"/>
              </a:ext>
            </a:extLst>
          </p:cNvPr>
          <p:cNvSpPr/>
          <p:nvPr/>
        </p:nvSpPr>
        <p:spPr>
          <a:xfrm>
            <a:off x="1917693" y="4720391"/>
            <a:ext cx="170414" cy="246257"/>
          </a:xfrm>
          <a:prstGeom prst="irregularSeal1">
            <a:avLst/>
          </a:prstGeom>
          <a:solidFill>
            <a:schemeClr val="accent2">
              <a:lumMod val="50000"/>
            </a:schemeClr>
          </a:solidFill>
          <a:ln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31" name="Explosion: 8 Points 30">
            <a:extLst>
              <a:ext uri="{FF2B5EF4-FFF2-40B4-BE49-F238E27FC236}">
                <a16:creationId xmlns:a16="http://schemas.microsoft.com/office/drawing/2014/main" id="{F01C0183-2521-42D1-832A-C8EAEE69859E}"/>
              </a:ext>
            </a:extLst>
          </p:cNvPr>
          <p:cNvSpPr/>
          <p:nvPr/>
        </p:nvSpPr>
        <p:spPr>
          <a:xfrm>
            <a:off x="2656497" y="8536591"/>
            <a:ext cx="170414" cy="246257"/>
          </a:xfrm>
          <a:prstGeom prst="irregularSeal1">
            <a:avLst/>
          </a:prstGeom>
          <a:solidFill>
            <a:schemeClr val="accent2">
              <a:lumMod val="50000"/>
            </a:schemeClr>
          </a:solidFill>
          <a:ln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B7BE1DE-802C-4EC8-9F8C-7033EAA7EE8F}"/>
              </a:ext>
            </a:extLst>
          </p:cNvPr>
          <p:cNvSpPr txBox="1"/>
          <p:nvPr/>
        </p:nvSpPr>
        <p:spPr>
          <a:xfrm>
            <a:off x="3093878" y="8521221"/>
            <a:ext cx="1539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tart feed Exp1</a:t>
            </a:r>
            <a:endParaRPr lang="nl-BE" sz="1200" dirty="0"/>
          </a:p>
        </p:txBody>
      </p:sp>
      <p:sp>
        <p:nvSpPr>
          <p:cNvPr id="38" name="Explosion: 8 Points 37">
            <a:extLst>
              <a:ext uri="{FF2B5EF4-FFF2-40B4-BE49-F238E27FC236}">
                <a16:creationId xmlns:a16="http://schemas.microsoft.com/office/drawing/2014/main" id="{FA34B1C7-A3B6-4B76-A6D7-B51EF7273F12}"/>
              </a:ext>
            </a:extLst>
          </p:cNvPr>
          <p:cNvSpPr/>
          <p:nvPr/>
        </p:nvSpPr>
        <p:spPr>
          <a:xfrm>
            <a:off x="4952295" y="8521221"/>
            <a:ext cx="170414" cy="246257"/>
          </a:xfrm>
          <a:prstGeom prst="irregularSeal1">
            <a:avLst/>
          </a:prstGeom>
          <a:solidFill>
            <a:schemeClr val="accent1">
              <a:lumMod val="5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40" name="Explosion: 8 Points 39">
            <a:extLst>
              <a:ext uri="{FF2B5EF4-FFF2-40B4-BE49-F238E27FC236}">
                <a16:creationId xmlns:a16="http://schemas.microsoft.com/office/drawing/2014/main" id="{BCD697AD-6478-48DE-B365-DDE824761F81}"/>
              </a:ext>
            </a:extLst>
          </p:cNvPr>
          <p:cNvSpPr/>
          <p:nvPr/>
        </p:nvSpPr>
        <p:spPr>
          <a:xfrm>
            <a:off x="1228731" y="6107842"/>
            <a:ext cx="170414" cy="246257"/>
          </a:xfrm>
          <a:prstGeom prst="irregularSeal1">
            <a:avLst/>
          </a:prstGeom>
          <a:solidFill>
            <a:schemeClr val="accent1">
              <a:lumMod val="5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402810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BC1442E-DC96-40C3-8FAB-75A78FE723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21" y="1359096"/>
            <a:ext cx="13070957" cy="71878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47208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0E0E2F3-2381-44F6-A6D0-B487F1246B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747" y="725057"/>
            <a:ext cx="12284505" cy="84558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85655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DFA6978E-E9E7-47E3-91EB-460254FEE423}"/>
              </a:ext>
            </a:extLst>
          </p:cNvPr>
          <p:cNvSpPr txBox="1"/>
          <p:nvPr/>
        </p:nvSpPr>
        <p:spPr>
          <a:xfrm>
            <a:off x="43930" y="88449"/>
            <a:ext cx="16867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A</a:t>
            </a:r>
            <a:endParaRPr lang="nl-BE" sz="26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10495CF-A7EF-4029-B587-A1BDE3D9A34B}"/>
              </a:ext>
            </a:extLst>
          </p:cNvPr>
          <p:cNvSpPr txBox="1"/>
          <p:nvPr/>
        </p:nvSpPr>
        <p:spPr>
          <a:xfrm>
            <a:off x="7164287" y="88449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B</a:t>
            </a:r>
            <a:endParaRPr lang="nl-BE" sz="26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0ABCAAE-290E-49FB-89F4-3A0D772907A1}"/>
              </a:ext>
            </a:extLst>
          </p:cNvPr>
          <p:cNvSpPr txBox="1"/>
          <p:nvPr/>
        </p:nvSpPr>
        <p:spPr>
          <a:xfrm>
            <a:off x="165097" y="4057659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C</a:t>
            </a:r>
            <a:endParaRPr lang="nl-BE" sz="26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216B68-1CC6-4B74-8A63-89D5DCFC6596}"/>
              </a:ext>
            </a:extLst>
          </p:cNvPr>
          <p:cNvSpPr txBox="1"/>
          <p:nvPr/>
        </p:nvSpPr>
        <p:spPr>
          <a:xfrm>
            <a:off x="6935056" y="4057659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D</a:t>
            </a:r>
            <a:endParaRPr lang="nl-BE" sz="2600" b="1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5E4788C3-000F-450B-ACDE-9161D55C40EE}"/>
              </a:ext>
            </a:extLst>
          </p:cNvPr>
          <p:cNvGrpSpPr/>
          <p:nvPr/>
        </p:nvGrpSpPr>
        <p:grpSpPr>
          <a:xfrm>
            <a:off x="5700976" y="1727937"/>
            <a:ext cx="2468159" cy="1182676"/>
            <a:chOff x="4653851" y="7545650"/>
            <a:chExt cx="2468159" cy="1182676"/>
          </a:xfrm>
        </p:grpSpPr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B2B129EB-11AD-4CAE-8710-2694F53FC104}"/>
                </a:ext>
              </a:extLst>
            </p:cNvPr>
            <p:cNvSpPr/>
            <p:nvPr/>
          </p:nvSpPr>
          <p:spPr>
            <a:xfrm>
              <a:off x="4653851" y="7605567"/>
              <a:ext cx="138438" cy="138438"/>
            </a:xfrm>
            <a:prstGeom prst="ellipse">
              <a:avLst/>
            </a:prstGeom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 dirty="0"/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D9A4EB63-3922-41E0-A0F7-05A1E601BD08}"/>
                </a:ext>
              </a:extLst>
            </p:cNvPr>
            <p:cNvSpPr/>
            <p:nvPr/>
          </p:nvSpPr>
          <p:spPr>
            <a:xfrm>
              <a:off x="4653851" y="8219611"/>
              <a:ext cx="138438" cy="138438"/>
            </a:xfrm>
            <a:prstGeom prst="ellipse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 dirty="0"/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A704DEC8-EA5C-4306-90C4-FD754F6D292D}"/>
                </a:ext>
              </a:extLst>
            </p:cNvPr>
            <p:cNvSpPr/>
            <p:nvPr/>
          </p:nvSpPr>
          <p:spPr>
            <a:xfrm>
              <a:off x="4653851" y="7912589"/>
              <a:ext cx="138438" cy="138438"/>
            </a:xfrm>
            <a:prstGeom prst="ellipse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/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54B9E0A8-3BAE-4A88-9516-2C0C4CEBB566}"/>
                </a:ext>
              </a:extLst>
            </p:cNvPr>
            <p:cNvSpPr/>
            <p:nvPr/>
          </p:nvSpPr>
          <p:spPr>
            <a:xfrm>
              <a:off x="4657479" y="8526634"/>
              <a:ext cx="138438" cy="138438"/>
            </a:xfrm>
            <a:prstGeom prst="ellipse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 sz="12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E27016F-1700-4592-B650-B829B239A9D9}"/>
                </a:ext>
              </a:extLst>
            </p:cNvPr>
            <p:cNvSpPr txBox="1"/>
            <p:nvPr/>
          </p:nvSpPr>
          <p:spPr>
            <a:xfrm>
              <a:off x="4756181" y="7545650"/>
              <a:ext cx="23658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dirty="0" err="1"/>
                <a:t>Roseburia</a:t>
              </a:r>
              <a:r>
                <a:rPr lang="en-US" sz="1050" i="1" dirty="0"/>
                <a:t> intestinalis</a:t>
              </a:r>
              <a:endParaRPr lang="nl-BE" sz="1050" i="1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388F56D-F797-4667-B5E7-1C35B43B4F1E}"/>
                </a:ext>
              </a:extLst>
            </p:cNvPr>
            <p:cNvSpPr txBox="1"/>
            <p:nvPr/>
          </p:nvSpPr>
          <p:spPr>
            <a:xfrm>
              <a:off x="4756181" y="8159694"/>
              <a:ext cx="23658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dirty="0"/>
                <a:t>Bacteroides </a:t>
              </a:r>
              <a:r>
                <a:rPr lang="en-US" sz="1050" i="1" dirty="0" err="1"/>
                <a:t>thetaiotaomicron</a:t>
              </a:r>
              <a:endParaRPr lang="nl-BE" sz="1050" i="1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C5896B0-3A3A-4D9A-9F90-3F127421BDF8}"/>
                </a:ext>
              </a:extLst>
            </p:cNvPr>
            <p:cNvSpPr txBox="1"/>
            <p:nvPr/>
          </p:nvSpPr>
          <p:spPr>
            <a:xfrm>
              <a:off x="4756181" y="7852672"/>
              <a:ext cx="23658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dirty="0" err="1"/>
                <a:t>Blautia</a:t>
              </a:r>
              <a:r>
                <a:rPr lang="en-US" sz="1050" i="1" dirty="0"/>
                <a:t> </a:t>
              </a:r>
              <a:r>
                <a:rPr lang="en-US" sz="1050" i="1" dirty="0" err="1"/>
                <a:t>hydrogenotrophica</a:t>
              </a:r>
              <a:endParaRPr lang="nl-BE" sz="1050" i="1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915EBF9-52CD-44C5-9B8B-629112E33259}"/>
                </a:ext>
              </a:extLst>
            </p:cNvPr>
            <p:cNvSpPr txBox="1"/>
            <p:nvPr/>
          </p:nvSpPr>
          <p:spPr>
            <a:xfrm>
              <a:off x="4756181" y="8466716"/>
              <a:ext cx="23658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dirty="0" err="1"/>
                <a:t>Collinsella</a:t>
              </a:r>
              <a:r>
                <a:rPr lang="en-US" sz="1050" i="1" dirty="0"/>
                <a:t> </a:t>
              </a:r>
              <a:r>
                <a:rPr lang="en-US" sz="1050" i="1" dirty="0" err="1"/>
                <a:t>aerofaciens</a:t>
              </a:r>
              <a:endParaRPr lang="nl-BE" sz="1050" i="1" dirty="0"/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2291C6D5-C846-4BAF-9A15-74C5B57A298C}"/>
              </a:ext>
            </a:extLst>
          </p:cNvPr>
          <p:cNvGrpSpPr/>
          <p:nvPr/>
        </p:nvGrpSpPr>
        <p:grpSpPr>
          <a:xfrm>
            <a:off x="670609" y="4278791"/>
            <a:ext cx="5774556" cy="5270332"/>
            <a:chOff x="670609" y="4278791"/>
            <a:chExt cx="5774556" cy="5270332"/>
          </a:xfrm>
        </p:grpSpPr>
        <p:graphicFrame>
          <p:nvGraphicFramePr>
            <p:cNvPr id="31" name="Chart 30">
              <a:extLst>
                <a:ext uri="{FF2B5EF4-FFF2-40B4-BE49-F238E27FC236}">
                  <a16:creationId xmlns:a16="http://schemas.microsoft.com/office/drawing/2014/main" id="{5232B377-4E5A-4DB7-A20C-6CCA051C4D4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41001874"/>
                </p:ext>
              </p:extLst>
            </p:nvPr>
          </p:nvGraphicFramePr>
          <p:xfrm>
            <a:off x="670609" y="4278791"/>
            <a:ext cx="5774556" cy="52703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117AFCC-8A20-42BB-B7DB-27A8A453D7BC}"/>
                </a:ext>
              </a:extLst>
            </p:cNvPr>
            <p:cNvSpPr txBox="1"/>
            <p:nvPr/>
          </p:nvSpPr>
          <p:spPr>
            <a:xfrm>
              <a:off x="1133874" y="8743808"/>
              <a:ext cx="596799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blank</a:t>
              </a:r>
              <a:endParaRPr lang="nl-BE" sz="1100" dirty="0"/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46157BBF-91B0-452E-9A10-5EB68E2E78D4}"/>
              </a:ext>
            </a:extLst>
          </p:cNvPr>
          <p:cNvGrpSpPr/>
          <p:nvPr/>
        </p:nvGrpSpPr>
        <p:grpSpPr>
          <a:xfrm>
            <a:off x="7167071" y="4282094"/>
            <a:ext cx="5774555" cy="5270332"/>
            <a:chOff x="7167071" y="4282094"/>
            <a:chExt cx="5774555" cy="5270332"/>
          </a:xfrm>
        </p:grpSpPr>
        <p:graphicFrame>
          <p:nvGraphicFramePr>
            <p:cNvPr id="32" name="Chart 31">
              <a:extLst>
                <a:ext uri="{FF2B5EF4-FFF2-40B4-BE49-F238E27FC236}">
                  <a16:creationId xmlns:a16="http://schemas.microsoft.com/office/drawing/2014/main" id="{66C2F4E4-12C9-4930-BB02-947EE4599BC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00971507"/>
                </p:ext>
              </p:extLst>
            </p:nvPr>
          </p:nvGraphicFramePr>
          <p:xfrm>
            <a:off x="7167071" y="4282094"/>
            <a:ext cx="5774555" cy="52703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4DB5BF7-98C6-4BEC-91A9-840375F1631B}"/>
                </a:ext>
              </a:extLst>
            </p:cNvPr>
            <p:cNvSpPr txBox="1"/>
            <p:nvPr/>
          </p:nvSpPr>
          <p:spPr>
            <a:xfrm>
              <a:off x="7639049" y="8743808"/>
              <a:ext cx="596799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blank</a:t>
              </a:r>
              <a:endParaRPr lang="nl-BE" sz="1100" dirty="0"/>
            </a:p>
          </p:txBody>
        </p:sp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132A7571-C199-4DAC-B2A7-4878CB963640}"/>
                </a:ext>
              </a:extLst>
            </p:cNvPr>
            <p:cNvSpPr/>
            <p:nvPr/>
          </p:nvSpPr>
          <p:spPr>
            <a:xfrm>
              <a:off x="7863509" y="8616950"/>
              <a:ext cx="120654" cy="120654"/>
            </a:xfrm>
            <a:prstGeom prst="ellipse">
              <a:avLst/>
            </a:prstGeom>
            <a:solidFill>
              <a:srgbClr val="38572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</p:grpSp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6050AC2F-8388-4C44-9ECC-F92FB8C5F2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4026769"/>
              </p:ext>
            </p:extLst>
          </p:nvPr>
        </p:nvGraphicFramePr>
        <p:xfrm>
          <a:off x="291743" y="287670"/>
          <a:ext cx="5187016" cy="3752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4" name="Chart 33">
            <a:extLst>
              <a:ext uri="{FF2B5EF4-FFF2-40B4-BE49-F238E27FC236}">
                <a16:creationId xmlns:a16="http://schemas.microsoft.com/office/drawing/2014/main" id="{B805C288-8466-4247-B576-A7D5B52BFD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4921133"/>
              </p:ext>
            </p:extLst>
          </p:nvPr>
        </p:nvGraphicFramePr>
        <p:xfrm>
          <a:off x="7440568" y="287670"/>
          <a:ext cx="5187016" cy="3752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5" name="Oval 34">
            <a:extLst>
              <a:ext uri="{FF2B5EF4-FFF2-40B4-BE49-F238E27FC236}">
                <a16:creationId xmlns:a16="http://schemas.microsoft.com/office/drawing/2014/main" id="{24FA9522-32BF-4828-8210-BF443E8393A8}"/>
              </a:ext>
            </a:extLst>
          </p:cNvPr>
          <p:cNvSpPr/>
          <p:nvPr/>
        </p:nvSpPr>
        <p:spPr>
          <a:xfrm>
            <a:off x="8291776" y="3383291"/>
            <a:ext cx="105240" cy="105240"/>
          </a:xfrm>
          <a:prstGeom prst="ellips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3E28F988-6702-4A40-A612-3766D825C32A}"/>
              </a:ext>
            </a:extLst>
          </p:cNvPr>
          <p:cNvSpPr/>
          <p:nvPr/>
        </p:nvSpPr>
        <p:spPr>
          <a:xfrm>
            <a:off x="8324488" y="3383291"/>
            <a:ext cx="105240" cy="105240"/>
          </a:xfrm>
          <a:prstGeom prst="ellipse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FFA80958-53C5-4AE1-8CB8-7405DF2A1507}"/>
              </a:ext>
            </a:extLst>
          </p:cNvPr>
          <p:cNvSpPr/>
          <p:nvPr/>
        </p:nvSpPr>
        <p:spPr>
          <a:xfrm>
            <a:off x="8357200" y="3383291"/>
            <a:ext cx="105240" cy="105240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200" dirty="0"/>
          </a:p>
        </p:txBody>
      </p:sp>
    </p:spTree>
    <p:extLst>
      <p:ext uri="{BB962C8B-B14F-4D97-AF65-F5344CB8AC3E}">
        <p14:creationId xmlns:p14="http://schemas.microsoft.com/office/powerpoint/2010/main" val="33637228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F36DA7A-B8F3-4BE5-BD5B-FFED452A3C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004" y="194659"/>
            <a:ext cx="13009992" cy="95166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660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Oval 56">
            <a:extLst>
              <a:ext uri="{FF2B5EF4-FFF2-40B4-BE49-F238E27FC236}">
                <a16:creationId xmlns:a16="http://schemas.microsoft.com/office/drawing/2014/main" id="{A19C4C20-522A-4B8C-BDE3-AA50D23BEE64}"/>
              </a:ext>
            </a:extLst>
          </p:cNvPr>
          <p:cNvSpPr/>
          <p:nvPr/>
        </p:nvSpPr>
        <p:spPr>
          <a:xfrm>
            <a:off x="9038780" y="3172364"/>
            <a:ext cx="3637498" cy="116853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i="1" dirty="0"/>
              <a:t>Bacteroides </a:t>
            </a:r>
            <a:r>
              <a:rPr lang="en-US" sz="2400" i="1" dirty="0" err="1"/>
              <a:t>thetaiotaomicron</a:t>
            </a:r>
            <a:endParaRPr lang="nl-BE" sz="2400" i="1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BA858398-50E6-4B1F-9B4C-9993D9AF7AD6}"/>
              </a:ext>
            </a:extLst>
          </p:cNvPr>
          <p:cNvSpPr/>
          <p:nvPr/>
        </p:nvSpPr>
        <p:spPr>
          <a:xfrm>
            <a:off x="9038780" y="6242689"/>
            <a:ext cx="3637498" cy="116853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i="1" dirty="0" err="1"/>
              <a:t>Collinsella</a:t>
            </a:r>
            <a:r>
              <a:rPr lang="en-US" sz="2400" i="1" dirty="0"/>
              <a:t> </a:t>
            </a:r>
            <a:r>
              <a:rPr lang="en-US" sz="2400" i="1" dirty="0" err="1"/>
              <a:t>aerofaciens</a:t>
            </a:r>
            <a:endParaRPr lang="nl-BE" sz="2400" i="1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3E6B3CE7-438B-46C8-8693-903E9241496E}"/>
              </a:ext>
            </a:extLst>
          </p:cNvPr>
          <p:cNvSpPr/>
          <p:nvPr/>
        </p:nvSpPr>
        <p:spPr>
          <a:xfrm>
            <a:off x="236600" y="6242689"/>
            <a:ext cx="3009773" cy="1168539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i="1" dirty="0" err="1"/>
              <a:t>Roseburia</a:t>
            </a:r>
            <a:r>
              <a:rPr lang="en-US" sz="2400" i="1" dirty="0"/>
              <a:t> intestinalis</a:t>
            </a:r>
            <a:endParaRPr lang="nl-BE" sz="2400" i="1" dirty="0"/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0AF1DCDA-350A-4D0B-A46F-79AF1BC9C393}"/>
              </a:ext>
            </a:extLst>
          </p:cNvPr>
          <p:cNvSpPr/>
          <p:nvPr/>
        </p:nvSpPr>
        <p:spPr>
          <a:xfrm>
            <a:off x="-77263" y="3166530"/>
            <a:ext cx="3637498" cy="1180206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i="1" dirty="0" err="1"/>
              <a:t>Blautia</a:t>
            </a:r>
            <a:r>
              <a:rPr lang="en-US" sz="2400" i="1" dirty="0"/>
              <a:t> </a:t>
            </a:r>
            <a:r>
              <a:rPr lang="en-US" sz="2400" i="1" dirty="0" err="1"/>
              <a:t>hydrogenotrophica</a:t>
            </a:r>
            <a:endParaRPr lang="nl-BE" sz="2400" i="1" dirty="0"/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5510ADF4-DD0E-4E9C-BE0F-1CDFBAE2F7CE}"/>
              </a:ext>
            </a:extLst>
          </p:cNvPr>
          <p:cNvSpPr/>
          <p:nvPr/>
        </p:nvSpPr>
        <p:spPr>
          <a:xfrm>
            <a:off x="5267569" y="1587589"/>
            <a:ext cx="2264348" cy="661316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 err="1">
                <a:solidFill>
                  <a:schemeClr val="tx1"/>
                </a:solidFill>
              </a:rPr>
              <a:t>Trehalose</a:t>
            </a:r>
            <a:endParaRPr lang="nl-BE" sz="2800" dirty="0">
              <a:solidFill>
                <a:schemeClr val="tx1"/>
              </a:solidFill>
            </a:endParaRP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0E5997BC-F828-4593-8BAA-1C979413082C}"/>
              </a:ext>
            </a:extLst>
          </p:cNvPr>
          <p:cNvCxnSpPr>
            <a:cxnSpLocks/>
            <a:stCxn id="10" idx="1"/>
            <a:endCxn id="2" idx="7"/>
          </p:cNvCxnSpPr>
          <p:nvPr/>
        </p:nvCxnSpPr>
        <p:spPr>
          <a:xfrm flipH="1">
            <a:off x="3027536" y="1918247"/>
            <a:ext cx="2240033" cy="1421120"/>
          </a:xfrm>
          <a:prstGeom prst="straightConnector1">
            <a:avLst/>
          </a:prstGeom>
          <a:ln w="635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7AF1DF1A-065E-42A7-B16F-6A8F4F61CA00}"/>
              </a:ext>
            </a:extLst>
          </p:cNvPr>
          <p:cNvCxnSpPr>
            <a:cxnSpLocks/>
            <a:stCxn id="57" idx="0"/>
            <a:endCxn id="89" idx="2"/>
          </p:cNvCxnSpPr>
          <p:nvPr/>
        </p:nvCxnSpPr>
        <p:spPr>
          <a:xfrm flipV="1">
            <a:off x="10857529" y="1954987"/>
            <a:ext cx="0" cy="1217377"/>
          </a:xfrm>
          <a:prstGeom prst="straightConnector1">
            <a:avLst/>
          </a:prstGeom>
          <a:ln w="21336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C66DB2F8-B7B9-474F-BF79-C9072AC1E987}"/>
              </a:ext>
            </a:extLst>
          </p:cNvPr>
          <p:cNvCxnSpPr>
            <a:cxnSpLocks/>
            <a:stCxn id="16" idx="1"/>
            <a:endCxn id="37" idx="5"/>
          </p:cNvCxnSpPr>
          <p:nvPr/>
        </p:nvCxnSpPr>
        <p:spPr>
          <a:xfrm flipH="1" flipV="1">
            <a:off x="2805602" y="7240099"/>
            <a:ext cx="2461967" cy="1229542"/>
          </a:xfrm>
          <a:prstGeom prst="straightConnector1">
            <a:avLst/>
          </a:prstGeom>
          <a:ln w="889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9EC25A04-864D-4CD0-8585-28AC851D4ABE}"/>
              </a:ext>
            </a:extLst>
          </p:cNvPr>
          <p:cNvCxnSpPr>
            <a:cxnSpLocks/>
            <a:stCxn id="16" idx="3"/>
            <a:endCxn id="47" idx="3"/>
          </p:cNvCxnSpPr>
          <p:nvPr/>
        </p:nvCxnSpPr>
        <p:spPr>
          <a:xfrm flipV="1">
            <a:off x="7531917" y="7240099"/>
            <a:ext cx="2039562" cy="1229542"/>
          </a:xfrm>
          <a:prstGeom prst="straightConnector1">
            <a:avLst/>
          </a:prstGeom>
          <a:ln w="15748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: Rounded Corners 88">
            <a:extLst>
              <a:ext uri="{FF2B5EF4-FFF2-40B4-BE49-F238E27FC236}">
                <a16:creationId xmlns:a16="http://schemas.microsoft.com/office/drawing/2014/main" id="{4AF2B20C-74E3-4E5B-8463-D6FB552A2661}"/>
              </a:ext>
            </a:extLst>
          </p:cNvPr>
          <p:cNvSpPr/>
          <p:nvPr/>
        </p:nvSpPr>
        <p:spPr>
          <a:xfrm>
            <a:off x="9725355" y="1293671"/>
            <a:ext cx="2264348" cy="661316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chemeClr val="tx1"/>
                </a:solidFill>
              </a:rPr>
              <a:t>Succinic acid</a:t>
            </a:r>
            <a:endParaRPr lang="nl-BE" sz="2800" dirty="0">
              <a:solidFill>
                <a:schemeClr val="tx1"/>
              </a:solidFill>
            </a:endParaRPr>
          </a:p>
        </p:txBody>
      </p:sp>
      <p:sp>
        <p:nvSpPr>
          <p:cNvPr id="94" name="Rectangle: Rounded Corners 93">
            <a:extLst>
              <a:ext uri="{FF2B5EF4-FFF2-40B4-BE49-F238E27FC236}">
                <a16:creationId xmlns:a16="http://schemas.microsoft.com/office/drawing/2014/main" id="{E8BB7050-D5AE-44EC-BA88-787D9FBE4701}"/>
              </a:ext>
            </a:extLst>
          </p:cNvPr>
          <p:cNvSpPr/>
          <p:nvPr/>
        </p:nvSpPr>
        <p:spPr>
          <a:xfrm>
            <a:off x="5267569" y="6496300"/>
            <a:ext cx="2264348" cy="661316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 w="762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chemeClr val="tx1"/>
                </a:solidFill>
              </a:rPr>
              <a:t>Lactic acid</a:t>
            </a:r>
            <a:endParaRPr lang="nl-BE" sz="2800" dirty="0">
              <a:solidFill>
                <a:schemeClr val="tx1"/>
              </a:solidFill>
            </a:endParaRPr>
          </a:p>
        </p:txBody>
      </p:sp>
      <p:sp>
        <p:nvSpPr>
          <p:cNvPr id="149" name="Rectangle: Rounded Corners 148">
            <a:extLst>
              <a:ext uri="{FF2B5EF4-FFF2-40B4-BE49-F238E27FC236}">
                <a16:creationId xmlns:a16="http://schemas.microsoft.com/office/drawing/2014/main" id="{B80A8301-6749-4758-A703-C3DB910378C6}"/>
              </a:ext>
            </a:extLst>
          </p:cNvPr>
          <p:cNvSpPr/>
          <p:nvPr/>
        </p:nvSpPr>
        <p:spPr>
          <a:xfrm>
            <a:off x="11601636" y="4966583"/>
            <a:ext cx="2264348" cy="661316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chemeClr val="tx1"/>
                </a:solidFill>
              </a:rPr>
              <a:t>Formic acid</a:t>
            </a:r>
            <a:endParaRPr lang="nl-BE" sz="2800" dirty="0">
              <a:solidFill>
                <a:schemeClr val="tx1"/>
              </a:solidFill>
            </a:endParaRPr>
          </a:p>
        </p:txBody>
      </p:sp>
      <p:sp>
        <p:nvSpPr>
          <p:cNvPr id="165" name="Rectangle: Rounded Corners 164">
            <a:extLst>
              <a:ext uri="{FF2B5EF4-FFF2-40B4-BE49-F238E27FC236}">
                <a16:creationId xmlns:a16="http://schemas.microsoft.com/office/drawing/2014/main" id="{8BC90DD7-2762-4228-B490-F73344F600EE}"/>
              </a:ext>
            </a:extLst>
          </p:cNvPr>
          <p:cNvSpPr/>
          <p:nvPr/>
        </p:nvSpPr>
        <p:spPr>
          <a:xfrm>
            <a:off x="5267569" y="3425975"/>
            <a:ext cx="2264348" cy="661316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 w="762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chemeClr val="tx1"/>
                </a:solidFill>
              </a:rPr>
              <a:t>Pyruvic acid</a:t>
            </a:r>
            <a:endParaRPr lang="nl-BE" sz="2800" dirty="0">
              <a:solidFill>
                <a:schemeClr val="tx1"/>
              </a:solidFill>
            </a:endParaRPr>
          </a:p>
        </p:txBody>
      </p:sp>
      <p:cxnSp>
        <p:nvCxnSpPr>
          <p:cNvPr id="173" name="Straight Arrow Connector 172">
            <a:extLst>
              <a:ext uri="{FF2B5EF4-FFF2-40B4-BE49-F238E27FC236}">
                <a16:creationId xmlns:a16="http://schemas.microsoft.com/office/drawing/2014/main" id="{88CDF93F-FAE9-45D6-A0E8-A7A6622B29E5}"/>
              </a:ext>
            </a:extLst>
          </p:cNvPr>
          <p:cNvCxnSpPr>
            <a:cxnSpLocks/>
            <a:stCxn id="57" idx="5"/>
            <a:endCxn id="149" idx="0"/>
          </p:cNvCxnSpPr>
          <p:nvPr/>
        </p:nvCxnSpPr>
        <p:spPr>
          <a:xfrm>
            <a:off x="12143579" y="4169774"/>
            <a:ext cx="590231" cy="796809"/>
          </a:xfrm>
          <a:prstGeom prst="straightConnector1">
            <a:avLst/>
          </a:prstGeom>
          <a:ln w="9144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Arrow Connector 176">
            <a:extLst>
              <a:ext uri="{FF2B5EF4-FFF2-40B4-BE49-F238E27FC236}">
                <a16:creationId xmlns:a16="http://schemas.microsoft.com/office/drawing/2014/main" id="{EE9CE299-B872-46A5-A1B8-3E57AD5FB4F5}"/>
              </a:ext>
            </a:extLst>
          </p:cNvPr>
          <p:cNvCxnSpPr>
            <a:cxnSpLocks/>
            <a:stCxn id="47" idx="7"/>
            <a:endCxn id="149" idx="2"/>
          </p:cNvCxnSpPr>
          <p:nvPr/>
        </p:nvCxnSpPr>
        <p:spPr>
          <a:xfrm flipV="1">
            <a:off x="12143579" y="5627899"/>
            <a:ext cx="590231" cy="785919"/>
          </a:xfrm>
          <a:prstGeom prst="straightConnector1">
            <a:avLst/>
          </a:prstGeom>
          <a:ln w="9398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Rectangle: Rounded Corners 184">
            <a:extLst>
              <a:ext uri="{FF2B5EF4-FFF2-40B4-BE49-F238E27FC236}">
                <a16:creationId xmlns:a16="http://schemas.microsoft.com/office/drawing/2014/main" id="{EF86B553-A39C-4D2C-94FF-B238ABBCE6FA}"/>
              </a:ext>
            </a:extLst>
          </p:cNvPr>
          <p:cNvSpPr/>
          <p:nvPr/>
        </p:nvSpPr>
        <p:spPr>
          <a:xfrm>
            <a:off x="5267569" y="5068657"/>
            <a:ext cx="2264348" cy="661316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 w="762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chemeClr val="tx1"/>
                </a:solidFill>
              </a:rPr>
              <a:t>Acetic acid</a:t>
            </a:r>
            <a:endParaRPr lang="nl-BE" sz="2800" dirty="0">
              <a:solidFill>
                <a:schemeClr val="tx1"/>
              </a:solidFill>
            </a:endParaRPr>
          </a:p>
        </p:txBody>
      </p:sp>
      <p:sp>
        <p:nvSpPr>
          <p:cNvPr id="214" name="Rectangle: Rounded Corners 213">
            <a:extLst>
              <a:ext uri="{FF2B5EF4-FFF2-40B4-BE49-F238E27FC236}">
                <a16:creationId xmlns:a16="http://schemas.microsoft.com/office/drawing/2014/main" id="{B1BC99C2-A3EA-4520-8312-AB2584784258}"/>
              </a:ext>
            </a:extLst>
          </p:cNvPr>
          <p:cNvSpPr/>
          <p:nvPr/>
        </p:nvSpPr>
        <p:spPr>
          <a:xfrm>
            <a:off x="609312" y="8138983"/>
            <a:ext cx="2264348" cy="661316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 w="762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>
                <a:solidFill>
                  <a:schemeClr val="tx1"/>
                </a:solidFill>
              </a:rPr>
              <a:t>Butyric acid</a:t>
            </a:r>
            <a:endParaRPr lang="nl-BE" sz="2800" dirty="0">
              <a:solidFill>
                <a:schemeClr val="tx1"/>
              </a:solidFill>
            </a:endParaRP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1A3BAB57-646C-4EC7-AC5D-BBC19BA544F6}"/>
              </a:ext>
            </a:extLst>
          </p:cNvPr>
          <p:cNvCxnSpPr>
            <a:cxnSpLocks/>
            <a:stCxn id="165" idx="1"/>
            <a:endCxn id="2" idx="6"/>
          </p:cNvCxnSpPr>
          <p:nvPr/>
        </p:nvCxnSpPr>
        <p:spPr>
          <a:xfrm flipH="1">
            <a:off x="3560235" y="3756633"/>
            <a:ext cx="1707334" cy="0"/>
          </a:xfrm>
          <a:prstGeom prst="straightConnector1">
            <a:avLst/>
          </a:prstGeom>
          <a:ln w="9271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6857456D-11AA-404D-959C-2846DEAEA300}"/>
              </a:ext>
            </a:extLst>
          </p:cNvPr>
          <p:cNvCxnSpPr>
            <a:cxnSpLocks/>
            <a:stCxn id="47" idx="2"/>
            <a:endCxn id="94" idx="3"/>
          </p:cNvCxnSpPr>
          <p:nvPr/>
        </p:nvCxnSpPr>
        <p:spPr>
          <a:xfrm flipH="1" flipV="1">
            <a:off x="7531917" y="6826958"/>
            <a:ext cx="1506863" cy="1"/>
          </a:xfrm>
          <a:prstGeom prst="straightConnector1">
            <a:avLst/>
          </a:prstGeom>
          <a:ln w="10668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29E64BE0-7D10-4DD1-A318-555470B58E19}"/>
              </a:ext>
            </a:extLst>
          </p:cNvPr>
          <p:cNvCxnSpPr>
            <a:cxnSpLocks/>
            <a:stCxn id="37" idx="7"/>
            <a:endCxn id="185" idx="1"/>
          </p:cNvCxnSpPr>
          <p:nvPr/>
        </p:nvCxnSpPr>
        <p:spPr>
          <a:xfrm flipV="1">
            <a:off x="2805602" y="5399315"/>
            <a:ext cx="2461967" cy="1014503"/>
          </a:xfrm>
          <a:prstGeom prst="straightConnector1">
            <a:avLst/>
          </a:prstGeom>
          <a:ln w="5588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C619CDC4-6CE2-45D6-831F-1100DCE2672A}"/>
              </a:ext>
            </a:extLst>
          </p:cNvPr>
          <p:cNvCxnSpPr>
            <a:cxnSpLocks/>
            <a:stCxn id="2" idx="5"/>
            <a:endCxn id="185" idx="1"/>
          </p:cNvCxnSpPr>
          <p:nvPr/>
        </p:nvCxnSpPr>
        <p:spPr>
          <a:xfrm>
            <a:off x="3027536" y="4173899"/>
            <a:ext cx="2240033" cy="1225416"/>
          </a:xfrm>
          <a:prstGeom prst="straightConnector1">
            <a:avLst/>
          </a:prstGeom>
          <a:ln w="7239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A2EF27AA-30D0-45D9-BDB0-44C242D9E720}"/>
              </a:ext>
            </a:extLst>
          </p:cNvPr>
          <p:cNvCxnSpPr>
            <a:cxnSpLocks/>
            <a:stCxn id="37" idx="4"/>
            <a:endCxn id="214" idx="0"/>
          </p:cNvCxnSpPr>
          <p:nvPr/>
        </p:nvCxnSpPr>
        <p:spPr>
          <a:xfrm flipH="1">
            <a:off x="1741486" y="7411228"/>
            <a:ext cx="1" cy="727755"/>
          </a:xfrm>
          <a:prstGeom prst="straightConnector1">
            <a:avLst/>
          </a:prstGeom>
          <a:ln w="6985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80C49C13-F9D5-4626-A353-7FCB12C4393F}"/>
              </a:ext>
            </a:extLst>
          </p:cNvPr>
          <p:cNvCxnSpPr>
            <a:cxnSpLocks/>
            <a:stCxn id="57" idx="4"/>
            <a:endCxn id="94" idx="3"/>
          </p:cNvCxnSpPr>
          <p:nvPr/>
        </p:nvCxnSpPr>
        <p:spPr>
          <a:xfrm flipH="1">
            <a:off x="7531917" y="4340903"/>
            <a:ext cx="3325612" cy="2486055"/>
          </a:xfrm>
          <a:prstGeom prst="straightConnector1">
            <a:avLst/>
          </a:prstGeom>
          <a:ln w="8255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Connector: Elbow 123">
            <a:extLst>
              <a:ext uri="{FF2B5EF4-FFF2-40B4-BE49-F238E27FC236}">
                <a16:creationId xmlns:a16="http://schemas.microsoft.com/office/drawing/2014/main" id="{C20CDA7B-D4A8-4B6C-88A7-A7AE495E5F7C}"/>
              </a:ext>
            </a:extLst>
          </p:cNvPr>
          <p:cNvCxnSpPr>
            <a:cxnSpLocks/>
            <a:stCxn id="149" idx="3"/>
            <a:endCxn id="2" idx="0"/>
          </p:cNvCxnSpPr>
          <p:nvPr/>
        </p:nvCxnSpPr>
        <p:spPr>
          <a:xfrm flipH="1" flipV="1">
            <a:off x="1741486" y="3166530"/>
            <a:ext cx="12124498" cy="2130711"/>
          </a:xfrm>
          <a:prstGeom prst="bentConnector4">
            <a:avLst>
              <a:gd name="adj1" fmla="val -1885"/>
              <a:gd name="adj2" fmla="val 206522"/>
            </a:avLst>
          </a:prstGeom>
          <a:ln w="254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D89D372-CB33-420B-9B6A-FB9ECAAC31B5}"/>
              </a:ext>
            </a:extLst>
          </p:cNvPr>
          <p:cNvCxnSpPr>
            <a:cxnSpLocks/>
            <a:stCxn id="47" idx="1"/>
            <a:endCxn id="185" idx="3"/>
          </p:cNvCxnSpPr>
          <p:nvPr/>
        </p:nvCxnSpPr>
        <p:spPr>
          <a:xfrm flipH="1" flipV="1">
            <a:off x="7531917" y="5399315"/>
            <a:ext cx="2039562" cy="1014503"/>
          </a:xfrm>
          <a:prstGeom prst="straightConnector1">
            <a:avLst/>
          </a:prstGeom>
          <a:ln w="8382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2E764B5-903E-49C3-B61C-8247DBCDBBF7}"/>
              </a:ext>
            </a:extLst>
          </p:cNvPr>
          <p:cNvCxnSpPr>
            <a:cxnSpLocks/>
            <a:stCxn id="10" idx="3"/>
            <a:endCxn id="57" idx="1"/>
          </p:cNvCxnSpPr>
          <p:nvPr/>
        </p:nvCxnSpPr>
        <p:spPr>
          <a:xfrm>
            <a:off x="7531917" y="1918247"/>
            <a:ext cx="2039562" cy="1425246"/>
          </a:xfrm>
          <a:prstGeom prst="straightConnector1">
            <a:avLst/>
          </a:prstGeom>
          <a:ln w="508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67D634E9-D3E5-46B1-A157-562B61129247}"/>
              </a:ext>
            </a:extLst>
          </p:cNvPr>
          <p:cNvSpPr/>
          <p:nvPr/>
        </p:nvSpPr>
        <p:spPr>
          <a:xfrm>
            <a:off x="5267569" y="8138983"/>
            <a:ext cx="2264348" cy="661316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chemeClr val="tx1"/>
                </a:solidFill>
              </a:rPr>
              <a:t>Glucose</a:t>
            </a:r>
            <a:endParaRPr lang="nl-BE" sz="2800" dirty="0">
              <a:solidFill>
                <a:schemeClr val="tx1"/>
              </a:solidFill>
            </a:endParaRPr>
          </a:p>
        </p:txBody>
      </p:sp>
      <p:cxnSp>
        <p:nvCxnSpPr>
          <p:cNvPr id="370" name="Connector: Elbow 369">
            <a:extLst>
              <a:ext uri="{FF2B5EF4-FFF2-40B4-BE49-F238E27FC236}">
                <a16:creationId xmlns:a16="http://schemas.microsoft.com/office/drawing/2014/main" id="{BCA3DF6E-7123-4D71-B3A9-FA4394D97697}"/>
              </a:ext>
            </a:extLst>
          </p:cNvPr>
          <p:cNvCxnSpPr>
            <a:cxnSpLocks/>
            <a:stCxn id="16" idx="3"/>
            <a:endCxn id="57" idx="6"/>
          </p:cNvCxnSpPr>
          <p:nvPr/>
        </p:nvCxnSpPr>
        <p:spPr>
          <a:xfrm flipV="1">
            <a:off x="7531917" y="3756634"/>
            <a:ext cx="5144361" cy="4713007"/>
          </a:xfrm>
          <a:prstGeom prst="bentConnector3">
            <a:avLst>
              <a:gd name="adj1" fmla="val 137137"/>
            </a:avLst>
          </a:prstGeom>
          <a:ln w="26543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632F189C-BE52-475C-8C9E-4D452CA08669}"/>
              </a:ext>
            </a:extLst>
          </p:cNvPr>
          <p:cNvCxnSpPr>
            <a:cxnSpLocks/>
            <a:stCxn id="2" idx="4"/>
            <a:endCxn id="94" idx="1"/>
          </p:cNvCxnSpPr>
          <p:nvPr/>
        </p:nvCxnSpPr>
        <p:spPr>
          <a:xfrm>
            <a:off x="1741486" y="4346736"/>
            <a:ext cx="3526083" cy="2480222"/>
          </a:xfrm>
          <a:prstGeom prst="straightConnector1">
            <a:avLst/>
          </a:prstGeom>
          <a:ln w="7239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522121B6-857E-4DD3-8AA0-FBC831236E41}"/>
              </a:ext>
            </a:extLst>
          </p:cNvPr>
          <p:cNvCxnSpPr>
            <a:cxnSpLocks/>
            <a:stCxn id="37" idx="6"/>
            <a:endCxn id="94" idx="1"/>
          </p:cNvCxnSpPr>
          <p:nvPr/>
        </p:nvCxnSpPr>
        <p:spPr>
          <a:xfrm flipV="1">
            <a:off x="3246373" y="6826958"/>
            <a:ext cx="2021196" cy="1"/>
          </a:xfrm>
          <a:prstGeom prst="straightConnector1">
            <a:avLst/>
          </a:prstGeom>
          <a:ln w="4953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E9FC8F02-3CF1-4FAD-A408-7A34D973DC5C}"/>
              </a:ext>
            </a:extLst>
          </p:cNvPr>
          <p:cNvCxnSpPr>
            <a:cxnSpLocks/>
            <a:stCxn id="57" idx="3"/>
            <a:endCxn id="185" idx="3"/>
          </p:cNvCxnSpPr>
          <p:nvPr/>
        </p:nvCxnSpPr>
        <p:spPr>
          <a:xfrm flipH="1">
            <a:off x="7531917" y="4169774"/>
            <a:ext cx="2039562" cy="1229541"/>
          </a:xfrm>
          <a:prstGeom prst="straightConnector1">
            <a:avLst/>
          </a:prstGeom>
          <a:ln w="154940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59DF67A7-8CFC-4A57-AE31-B0A0376B7A01}"/>
              </a:ext>
            </a:extLst>
          </p:cNvPr>
          <p:cNvCxnSpPr>
            <a:cxnSpLocks/>
            <a:stCxn id="165" idx="3"/>
            <a:endCxn id="57" idx="2"/>
          </p:cNvCxnSpPr>
          <p:nvPr/>
        </p:nvCxnSpPr>
        <p:spPr>
          <a:xfrm>
            <a:off x="7531917" y="3756633"/>
            <a:ext cx="1506863" cy="1"/>
          </a:xfrm>
          <a:prstGeom prst="straightConnector1">
            <a:avLst/>
          </a:prstGeom>
          <a:ln w="10922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321D283-EAE2-4AE3-90F8-2A3227624A74}"/>
              </a:ext>
            </a:extLst>
          </p:cNvPr>
          <p:cNvCxnSpPr>
            <a:cxnSpLocks/>
            <a:stCxn id="165" idx="3"/>
            <a:endCxn id="47" idx="0"/>
          </p:cNvCxnSpPr>
          <p:nvPr/>
        </p:nvCxnSpPr>
        <p:spPr>
          <a:xfrm>
            <a:off x="7531917" y="3756633"/>
            <a:ext cx="3325612" cy="2486056"/>
          </a:xfrm>
          <a:prstGeom prst="straightConnector1">
            <a:avLst/>
          </a:prstGeom>
          <a:ln w="6858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FD8E6273-3FDB-411A-ADEE-07E80164A364}"/>
              </a:ext>
            </a:extLst>
          </p:cNvPr>
          <p:cNvCxnSpPr>
            <a:cxnSpLocks/>
            <a:stCxn id="165" idx="1"/>
            <a:endCxn id="37" idx="0"/>
          </p:cNvCxnSpPr>
          <p:nvPr/>
        </p:nvCxnSpPr>
        <p:spPr>
          <a:xfrm flipH="1">
            <a:off x="1741487" y="3756633"/>
            <a:ext cx="3526082" cy="2486056"/>
          </a:xfrm>
          <a:prstGeom prst="straightConnector1">
            <a:avLst/>
          </a:prstGeom>
          <a:ln w="4826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115151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7D0A9C6-EE94-43FD-A151-E83FDCB6AC12}"/>
              </a:ext>
            </a:extLst>
          </p:cNvPr>
          <p:cNvGrpSpPr/>
          <p:nvPr/>
        </p:nvGrpSpPr>
        <p:grpSpPr>
          <a:xfrm>
            <a:off x="8422967" y="2980175"/>
            <a:ext cx="2594429" cy="2384993"/>
            <a:chOff x="10222738" y="2617318"/>
            <a:chExt cx="2594429" cy="2384993"/>
          </a:xfrm>
        </p:grpSpPr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71B4F8EA-848A-4EDB-9E0F-3E9DB7B76D4B}"/>
                </a:ext>
              </a:extLst>
            </p:cNvPr>
            <p:cNvSpPr/>
            <p:nvPr/>
          </p:nvSpPr>
          <p:spPr>
            <a:xfrm>
              <a:off x="10222738" y="2671094"/>
              <a:ext cx="203200" cy="203200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CBFF7F84-E715-4D5F-98F0-DE4A6D3C1241}"/>
                </a:ext>
              </a:extLst>
            </p:cNvPr>
            <p:cNvSpPr/>
            <p:nvPr/>
          </p:nvSpPr>
          <p:spPr>
            <a:xfrm>
              <a:off x="10222738" y="3681327"/>
              <a:ext cx="203200" cy="203200"/>
            </a:xfrm>
            <a:prstGeom prst="ellipse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EAFE2D6E-0D72-45B0-83FD-0A0CEA3E1B49}"/>
                </a:ext>
              </a:extLst>
            </p:cNvPr>
            <p:cNvSpPr/>
            <p:nvPr/>
          </p:nvSpPr>
          <p:spPr>
            <a:xfrm>
              <a:off x="10222738" y="3150066"/>
              <a:ext cx="203200" cy="203200"/>
            </a:xfrm>
            <a:prstGeom prst="ellipse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A5D04AA3-028F-439C-A89B-C9EBECD8F6DF}"/>
                </a:ext>
              </a:extLst>
            </p:cNvPr>
            <p:cNvSpPr/>
            <p:nvPr/>
          </p:nvSpPr>
          <p:spPr>
            <a:xfrm>
              <a:off x="10226366" y="4214076"/>
              <a:ext cx="203200" cy="203200"/>
            </a:xfrm>
            <a:prstGeom prst="ellipse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940F53CA-D553-477B-9A8C-E397E85ECA84}"/>
                </a:ext>
              </a:extLst>
            </p:cNvPr>
            <p:cNvSpPr/>
            <p:nvPr/>
          </p:nvSpPr>
          <p:spPr>
            <a:xfrm>
              <a:off x="10251766" y="4746823"/>
              <a:ext cx="203200" cy="203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BE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CF6D2AA-C2CA-471F-8C3F-9ED80032E0D7}"/>
                </a:ext>
              </a:extLst>
            </p:cNvPr>
            <p:cNvSpPr txBox="1"/>
            <p:nvPr/>
          </p:nvSpPr>
          <p:spPr>
            <a:xfrm>
              <a:off x="10425938" y="2617318"/>
              <a:ext cx="23658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 err="1"/>
                <a:t>Roseburia</a:t>
              </a:r>
              <a:r>
                <a:rPr lang="en-US" sz="1400" i="1" dirty="0"/>
                <a:t> intestinalis</a:t>
              </a:r>
              <a:endParaRPr lang="nl-BE" sz="1400" i="1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4CD666A-10DB-4EA3-A5E1-773743F7CC83}"/>
                </a:ext>
              </a:extLst>
            </p:cNvPr>
            <p:cNvSpPr txBox="1"/>
            <p:nvPr/>
          </p:nvSpPr>
          <p:spPr>
            <a:xfrm>
              <a:off x="10425938" y="3629038"/>
              <a:ext cx="23658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/>
                <a:t>Bacteroides </a:t>
              </a:r>
              <a:r>
                <a:rPr lang="en-US" sz="1400" i="1" dirty="0" err="1"/>
                <a:t>thetaiotaomicron</a:t>
              </a:r>
              <a:endParaRPr lang="nl-BE" sz="1400" i="1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5E4CB11-5E0D-4AA8-A842-D696669A9847}"/>
                </a:ext>
              </a:extLst>
            </p:cNvPr>
            <p:cNvSpPr txBox="1"/>
            <p:nvPr/>
          </p:nvSpPr>
          <p:spPr>
            <a:xfrm>
              <a:off x="10425938" y="3096290"/>
              <a:ext cx="23658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 err="1"/>
                <a:t>Blautia</a:t>
              </a:r>
              <a:r>
                <a:rPr lang="en-US" sz="1400" i="1" dirty="0"/>
                <a:t> </a:t>
              </a:r>
              <a:r>
                <a:rPr lang="en-US" sz="1400" i="1" dirty="0" err="1"/>
                <a:t>hydrogenotrophica</a:t>
              </a:r>
              <a:endParaRPr lang="nl-BE" sz="1400" i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0507F86-4FB0-411E-9EDD-185E7D024405}"/>
                </a:ext>
              </a:extLst>
            </p:cNvPr>
            <p:cNvSpPr txBox="1"/>
            <p:nvPr/>
          </p:nvSpPr>
          <p:spPr>
            <a:xfrm>
              <a:off x="10425938" y="4161786"/>
              <a:ext cx="23658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 err="1"/>
                <a:t>Collinsella</a:t>
              </a:r>
              <a:r>
                <a:rPr lang="en-US" sz="1400" i="1" dirty="0"/>
                <a:t> </a:t>
              </a:r>
              <a:r>
                <a:rPr lang="en-US" sz="1400" i="1" dirty="0" err="1"/>
                <a:t>aerofaciens</a:t>
              </a:r>
              <a:endParaRPr lang="nl-BE" sz="1400" i="1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3DD2B6B-01C7-4F43-B429-A58C04D7EB51}"/>
                </a:ext>
              </a:extLst>
            </p:cNvPr>
            <p:cNvSpPr txBox="1"/>
            <p:nvPr/>
          </p:nvSpPr>
          <p:spPr>
            <a:xfrm>
              <a:off x="10451338" y="4694534"/>
              <a:ext cx="23658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Blank</a:t>
              </a:r>
              <a:endParaRPr lang="nl-BE" sz="1400" dirty="0"/>
            </a:p>
          </p:txBody>
        </p:sp>
      </p:grpSp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BB755333-2279-4937-A256-A985BB19CA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9239883"/>
              </p:ext>
            </p:extLst>
          </p:nvPr>
        </p:nvGraphicFramePr>
        <p:xfrm>
          <a:off x="450535" y="910760"/>
          <a:ext cx="7588744" cy="6033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1852016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C7791CC-B8EA-4A2F-AD97-A9B4D7F1FF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0458" y="635721"/>
            <a:ext cx="7751736" cy="420297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5F95896-B1F8-4417-9190-C1F593B35D98}"/>
              </a:ext>
            </a:extLst>
          </p:cNvPr>
          <p:cNvSpPr txBox="1"/>
          <p:nvPr/>
        </p:nvSpPr>
        <p:spPr>
          <a:xfrm>
            <a:off x="2059137" y="635721"/>
            <a:ext cx="16867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A</a:t>
            </a:r>
            <a:endParaRPr lang="nl-BE" sz="26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BB65868-C3DE-452D-9512-FDF74E30A71D}"/>
              </a:ext>
            </a:extLst>
          </p:cNvPr>
          <p:cNvSpPr txBox="1"/>
          <p:nvPr/>
        </p:nvSpPr>
        <p:spPr>
          <a:xfrm>
            <a:off x="2147787" y="5270049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B</a:t>
            </a:r>
            <a:endParaRPr lang="nl-BE" sz="2600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43B7A51-BBDB-4D65-A940-39D2493237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02508" y="4953000"/>
            <a:ext cx="8727831" cy="49858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8584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DD4B423-60FB-42DA-83B5-B7F97D9D81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5"/>
          <a:stretch/>
        </p:blipFill>
        <p:spPr>
          <a:xfrm>
            <a:off x="6639162" y="473579"/>
            <a:ext cx="6568838" cy="475884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1EBFED-E8A2-4D1C-B6BD-3F3573DCC0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9686" y="5256974"/>
            <a:ext cx="6567677" cy="460640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EB4B4FC-9A59-42AD-BB06-CF6466E858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9687" y="403596"/>
            <a:ext cx="6499475" cy="4853377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63D778-F73F-4D9B-81FC-FE36C90BA3FC}"/>
              </a:ext>
            </a:extLst>
          </p:cNvPr>
          <p:cNvSpPr txBox="1"/>
          <p:nvPr/>
        </p:nvSpPr>
        <p:spPr>
          <a:xfrm>
            <a:off x="315733" y="42621"/>
            <a:ext cx="16867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A</a:t>
            </a:r>
            <a:endParaRPr lang="nl-BE" sz="26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98E3962-A397-4DEA-B344-8F7719090329}"/>
              </a:ext>
            </a:extLst>
          </p:cNvPr>
          <p:cNvSpPr txBox="1"/>
          <p:nvPr/>
        </p:nvSpPr>
        <p:spPr>
          <a:xfrm>
            <a:off x="7032708" y="42621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B</a:t>
            </a:r>
            <a:endParaRPr lang="nl-BE" sz="26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97DD27C-664F-473A-A764-AC8344EC3C15}"/>
              </a:ext>
            </a:extLst>
          </p:cNvPr>
          <p:cNvSpPr txBox="1"/>
          <p:nvPr/>
        </p:nvSpPr>
        <p:spPr>
          <a:xfrm>
            <a:off x="237913" y="5066205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C</a:t>
            </a:r>
            <a:endParaRPr lang="nl-BE" sz="26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F485B6E-F324-4040-B290-EC3BB8C29BF4}"/>
              </a:ext>
            </a:extLst>
          </p:cNvPr>
          <p:cNvSpPr txBox="1"/>
          <p:nvPr/>
        </p:nvSpPr>
        <p:spPr>
          <a:xfrm>
            <a:off x="6954888" y="5066205"/>
            <a:ext cx="10110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600" b="1" dirty="0"/>
              <a:t>D</a:t>
            </a:r>
            <a:endParaRPr lang="nl-BE" sz="2600" b="1" dirty="0"/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8FD6D62E-18CC-46D6-9ADC-428BAE1163D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0508" y="5215982"/>
            <a:ext cx="3894149" cy="46473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10623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775B1126-93DB-47EA-8D73-22EF2963A3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425" y="17860"/>
            <a:ext cx="13083150" cy="98702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7017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538387E414B0A4F8A1FD6F9560608E7" ma:contentTypeVersion="14" ma:contentTypeDescription="Create a new document." ma:contentTypeScope="" ma:versionID="6cb98ed3700da162af2d32c99dd63ebb">
  <xsd:schema xmlns:xsd="http://www.w3.org/2001/XMLSchema" xmlns:xs="http://www.w3.org/2001/XMLSchema" xmlns:p="http://schemas.microsoft.com/office/2006/metadata/properties" xmlns:ns3="685bc27c-546e-4923-864f-8fc5b1bbd8cd" xmlns:ns4="494f3c23-626e-476d-b988-f5835333453e" targetNamespace="http://schemas.microsoft.com/office/2006/metadata/properties" ma:root="true" ma:fieldsID="d32752101026e0f2cfb0e0d9e8658cb8" ns3:_="" ns4:_="">
    <xsd:import namespace="685bc27c-546e-4923-864f-8fc5b1bbd8cd"/>
    <xsd:import namespace="494f3c23-626e-476d-b988-f5835333453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LengthInSecond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85bc27c-546e-4923-864f-8fc5b1bbd8c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94f3c23-626e-476d-b988-f5835333453e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D4B5CB8-BC89-4FA1-8C91-8FCD4F7EF342}">
  <ds:schemaRefs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www.w3.org/XML/1998/namespace"/>
    <ds:schemaRef ds:uri="http://schemas.microsoft.com/office/2006/documentManagement/types"/>
    <ds:schemaRef ds:uri="494f3c23-626e-476d-b988-f5835333453e"/>
    <ds:schemaRef ds:uri="http://purl.org/dc/terms/"/>
    <ds:schemaRef ds:uri="685bc27c-546e-4923-864f-8fc5b1bbd8cd"/>
    <ds:schemaRef ds:uri="http://schemas.microsoft.com/office/2006/metadata/properties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2A01CA34-57D9-45E0-80E9-5703883C143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85bc27c-546e-4923-864f-8fc5b1bbd8cd"/>
    <ds:schemaRef ds:uri="494f3c23-626e-476d-b988-f5835333453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F8442BA-44B2-4D63-9A61-98E9184D1D9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102</TotalTime>
  <Words>284</Words>
  <Application>Microsoft Office PowerPoint</Application>
  <PresentationFormat>Custom</PresentationFormat>
  <Paragraphs>117</Paragraphs>
  <Slides>13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otte van de Velde</dc:creator>
  <cp:lastModifiedBy>Charlotte van de Velde</cp:lastModifiedBy>
  <cp:revision>190</cp:revision>
  <dcterms:created xsi:type="dcterms:W3CDTF">2021-12-15T09:53:49Z</dcterms:created>
  <dcterms:modified xsi:type="dcterms:W3CDTF">2022-10-27T08:37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538387E414B0A4F8A1FD6F9560608E7</vt:lpwstr>
  </property>
</Properties>
</file>